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385" r:id="rId2"/>
    <p:sldId id="449" r:id="rId3"/>
    <p:sldId id="460" r:id="rId4"/>
    <p:sldId id="452" r:id="rId5"/>
    <p:sldId id="438" r:id="rId6"/>
    <p:sldId id="461" r:id="rId7"/>
    <p:sldId id="455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5F02"/>
    <a:srgbClr val="A3E4FB"/>
    <a:srgbClr val="00642D"/>
    <a:srgbClr val="FFE48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906D11C-5CFC-4DE2-8E59-481AAD2DEBAB}" v="96" dt="2026-02-27T13:59:42.14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80" autoAdjust="0"/>
    <p:restoredTop sz="95033" autoAdjust="0"/>
  </p:normalViewPr>
  <p:slideViewPr>
    <p:cSldViewPr snapToGrid="0">
      <p:cViewPr>
        <p:scale>
          <a:sx n="100" d="100"/>
          <a:sy n="100" d="100"/>
        </p:scale>
        <p:origin x="3090" y="-13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5/10/relationships/revisionInfo" Target="revisionInfo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klau\OneDrive\Desktop\Work%20stuff\RNA%20Seq%20Data\R5020%20vs%20ETOH\Dotplot\541%20gene%20(Less%20than%2010%25)\Copy%20of%20Dots%20Plot_Plvx%20PRB%20FFF%20QQQ_RNA%20seq%20R5020%20vs%20Ctr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3!$B$3</c:f>
              <c:strCache>
                <c:ptCount val="1"/>
                <c:pt idx="0">
                  <c:v>PRB_padj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3!$A$4:$A$13</c:f>
              <c:strCache>
                <c:ptCount val="10"/>
                <c:pt idx="0">
                  <c:v>AHNAK</c:v>
                </c:pt>
                <c:pt idx="1">
                  <c:v>ACSS1</c:v>
                </c:pt>
                <c:pt idx="2">
                  <c:v>ST3GAL4</c:v>
                </c:pt>
                <c:pt idx="3">
                  <c:v>NEDD4L</c:v>
                </c:pt>
                <c:pt idx="4">
                  <c:v>GRHL2</c:v>
                </c:pt>
                <c:pt idx="5">
                  <c:v>DDIT4</c:v>
                </c:pt>
                <c:pt idx="6">
                  <c:v>ECE1</c:v>
                </c:pt>
                <c:pt idx="7">
                  <c:v>SLC5A6</c:v>
                </c:pt>
                <c:pt idx="8">
                  <c:v>WWC1</c:v>
                </c:pt>
                <c:pt idx="9">
                  <c:v>PLLP</c:v>
                </c:pt>
              </c:strCache>
            </c:strRef>
          </c:cat>
          <c:val>
            <c:numRef>
              <c:f>Sheet3!$B$4:$B$13</c:f>
            </c:numRef>
          </c:val>
          <c:extLst>
            <c:ext xmlns:c16="http://schemas.microsoft.com/office/drawing/2014/chart" uri="{C3380CC4-5D6E-409C-BE32-E72D297353CC}">
              <c16:uniqueId val="{00000000-8469-431A-8A9D-0C247D311848}"/>
            </c:ext>
          </c:extLst>
        </c:ser>
        <c:ser>
          <c:idx val="1"/>
          <c:order val="1"/>
          <c:tx>
            <c:strRef>
              <c:f>Sheet3!$C$3</c:f>
              <c:strCache>
                <c:ptCount val="1"/>
                <c:pt idx="0">
                  <c:v>PRB_Fold Change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3!$A$4:$A$13</c:f>
              <c:strCache>
                <c:ptCount val="10"/>
                <c:pt idx="0">
                  <c:v>AHNAK</c:v>
                </c:pt>
                <c:pt idx="1">
                  <c:v>ACSS1</c:v>
                </c:pt>
                <c:pt idx="2">
                  <c:v>ST3GAL4</c:v>
                </c:pt>
                <c:pt idx="3">
                  <c:v>NEDD4L</c:v>
                </c:pt>
                <c:pt idx="4">
                  <c:v>GRHL2</c:v>
                </c:pt>
                <c:pt idx="5">
                  <c:v>DDIT4</c:v>
                </c:pt>
                <c:pt idx="6">
                  <c:v>ECE1</c:v>
                </c:pt>
                <c:pt idx="7">
                  <c:v>SLC5A6</c:v>
                </c:pt>
                <c:pt idx="8">
                  <c:v>WWC1</c:v>
                </c:pt>
                <c:pt idx="9">
                  <c:v>PLLP</c:v>
                </c:pt>
              </c:strCache>
            </c:strRef>
          </c:cat>
          <c:val>
            <c:numRef>
              <c:f>Sheet3!$C$4:$C$13</c:f>
            </c:numRef>
          </c:val>
          <c:extLst>
            <c:ext xmlns:c16="http://schemas.microsoft.com/office/drawing/2014/chart" uri="{C3380CC4-5D6E-409C-BE32-E72D297353CC}">
              <c16:uniqueId val="{00000001-8469-431A-8A9D-0C247D311848}"/>
            </c:ext>
          </c:extLst>
        </c:ser>
        <c:ser>
          <c:idx val="2"/>
          <c:order val="2"/>
          <c:tx>
            <c:strRef>
              <c:f>Sheet3!$D$3</c:f>
              <c:strCache>
                <c:ptCount val="1"/>
                <c:pt idx="0">
                  <c:v>PRB_Log2 FC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3!$A$4:$A$13</c:f>
              <c:strCache>
                <c:ptCount val="10"/>
                <c:pt idx="0">
                  <c:v>AHNAK</c:v>
                </c:pt>
                <c:pt idx="1">
                  <c:v>ACSS1</c:v>
                </c:pt>
                <c:pt idx="2">
                  <c:v>ST3GAL4</c:v>
                </c:pt>
                <c:pt idx="3">
                  <c:v>NEDD4L</c:v>
                </c:pt>
                <c:pt idx="4">
                  <c:v>GRHL2</c:v>
                </c:pt>
                <c:pt idx="5">
                  <c:v>DDIT4</c:v>
                </c:pt>
                <c:pt idx="6">
                  <c:v>ECE1</c:v>
                </c:pt>
                <c:pt idx="7">
                  <c:v>SLC5A6</c:v>
                </c:pt>
                <c:pt idx="8">
                  <c:v>WWC1</c:v>
                </c:pt>
                <c:pt idx="9">
                  <c:v>PLLP</c:v>
                </c:pt>
              </c:strCache>
            </c:strRef>
          </c:cat>
          <c:val>
            <c:numRef>
              <c:f>Sheet3!$D$4:$D$13</c:f>
              <c:numCache>
                <c:formatCode>General</c:formatCode>
                <c:ptCount val="10"/>
                <c:pt idx="0">
                  <c:v>1.4707939755747097</c:v>
                </c:pt>
                <c:pt idx="1">
                  <c:v>1.8816412168343299</c:v>
                </c:pt>
                <c:pt idx="2">
                  <c:v>1.7130435992902002</c:v>
                </c:pt>
                <c:pt idx="3">
                  <c:v>1.5449505691508603</c:v>
                </c:pt>
                <c:pt idx="4">
                  <c:v>1.3055744148162001</c:v>
                </c:pt>
                <c:pt idx="5">
                  <c:v>1.68450938361284</c:v>
                </c:pt>
                <c:pt idx="6">
                  <c:v>1.32559486203447</c:v>
                </c:pt>
                <c:pt idx="7">
                  <c:v>1.1700293145904901</c:v>
                </c:pt>
                <c:pt idx="8">
                  <c:v>1.2506214202941699</c:v>
                </c:pt>
                <c:pt idx="9">
                  <c:v>2.0497248227087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69-431A-8A9D-0C247D311848}"/>
            </c:ext>
          </c:extLst>
        </c:ser>
        <c:ser>
          <c:idx val="3"/>
          <c:order val="3"/>
          <c:tx>
            <c:strRef>
              <c:f>Sheet3!$E$3</c:f>
              <c:strCache>
                <c:ptCount val="1"/>
                <c:pt idx="0">
                  <c:v>FFF_padj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3!$A$4:$A$13</c:f>
              <c:strCache>
                <c:ptCount val="10"/>
                <c:pt idx="0">
                  <c:v>AHNAK</c:v>
                </c:pt>
                <c:pt idx="1">
                  <c:v>ACSS1</c:v>
                </c:pt>
                <c:pt idx="2">
                  <c:v>ST3GAL4</c:v>
                </c:pt>
                <c:pt idx="3">
                  <c:v>NEDD4L</c:v>
                </c:pt>
                <c:pt idx="4">
                  <c:v>GRHL2</c:v>
                </c:pt>
                <c:pt idx="5">
                  <c:v>DDIT4</c:v>
                </c:pt>
                <c:pt idx="6">
                  <c:v>ECE1</c:v>
                </c:pt>
                <c:pt idx="7">
                  <c:v>SLC5A6</c:v>
                </c:pt>
                <c:pt idx="8">
                  <c:v>WWC1</c:v>
                </c:pt>
                <c:pt idx="9">
                  <c:v>PLLP</c:v>
                </c:pt>
              </c:strCache>
            </c:strRef>
          </c:cat>
          <c:val>
            <c:numRef>
              <c:f>Sheet3!$E$4:$E$13</c:f>
            </c:numRef>
          </c:val>
          <c:extLst>
            <c:ext xmlns:c16="http://schemas.microsoft.com/office/drawing/2014/chart" uri="{C3380CC4-5D6E-409C-BE32-E72D297353CC}">
              <c16:uniqueId val="{00000003-8469-431A-8A9D-0C247D311848}"/>
            </c:ext>
          </c:extLst>
        </c:ser>
        <c:ser>
          <c:idx val="4"/>
          <c:order val="4"/>
          <c:tx>
            <c:strRef>
              <c:f>Sheet3!$F$3</c:f>
              <c:strCache>
                <c:ptCount val="1"/>
                <c:pt idx="0">
                  <c:v>FFF_Fold Chang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3!$A$4:$A$13</c:f>
              <c:strCache>
                <c:ptCount val="10"/>
                <c:pt idx="0">
                  <c:v>AHNAK</c:v>
                </c:pt>
                <c:pt idx="1">
                  <c:v>ACSS1</c:v>
                </c:pt>
                <c:pt idx="2">
                  <c:v>ST3GAL4</c:v>
                </c:pt>
                <c:pt idx="3">
                  <c:v>NEDD4L</c:v>
                </c:pt>
                <c:pt idx="4">
                  <c:v>GRHL2</c:v>
                </c:pt>
                <c:pt idx="5">
                  <c:v>DDIT4</c:v>
                </c:pt>
                <c:pt idx="6">
                  <c:v>ECE1</c:v>
                </c:pt>
                <c:pt idx="7">
                  <c:v>SLC5A6</c:v>
                </c:pt>
                <c:pt idx="8">
                  <c:v>WWC1</c:v>
                </c:pt>
                <c:pt idx="9">
                  <c:v>PLLP</c:v>
                </c:pt>
              </c:strCache>
            </c:strRef>
          </c:cat>
          <c:val>
            <c:numRef>
              <c:f>Sheet3!$F$4:$F$13</c:f>
            </c:numRef>
          </c:val>
          <c:extLst>
            <c:ext xmlns:c16="http://schemas.microsoft.com/office/drawing/2014/chart" uri="{C3380CC4-5D6E-409C-BE32-E72D297353CC}">
              <c16:uniqueId val="{00000004-8469-431A-8A9D-0C247D311848}"/>
            </c:ext>
          </c:extLst>
        </c:ser>
        <c:ser>
          <c:idx val="5"/>
          <c:order val="5"/>
          <c:tx>
            <c:strRef>
              <c:f>Sheet3!$G$3</c:f>
              <c:strCache>
                <c:ptCount val="1"/>
                <c:pt idx="0">
                  <c:v>FFF Log2 FC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3!$A$4:$A$13</c:f>
              <c:strCache>
                <c:ptCount val="10"/>
                <c:pt idx="0">
                  <c:v>AHNAK</c:v>
                </c:pt>
                <c:pt idx="1">
                  <c:v>ACSS1</c:v>
                </c:pt>
                <c:pt idx="2">
                  <c:v>ST3GAL4</c:v>
                </c:pt>
                <c:pt idx="3">
                  <c:v>NEDD4L</c:v>
                </c:pt>
                <c:pt idx="4">
                  <c:v>GRHL2</c:v>
                </c:pt>
                <c:pt idx="5">
                  <c:v>DDIT4</c:v>
                </c:pt>
                <c:pt idx="6">
                  <c:v>ECE1</c:v>
                </c:pt>
                <c:pt idx="7">
                  <c:v>SLC5A6</c:v>
                </c:pt>
                <c:pt idx="8">
                  <c:v>WWC1</c:v>
                </c:pt>
                <c:pt idx="9">
                  <c:v>PLLP</c:v>
                </c:pt>
              </c:strCache>
            </c:strRef>
          </c:cat>
          <c:val>
            <c:numRef>
              <c:f>Sheet3!$G$4:$G$13</c:f>
              <c:numCache>
                <c:formatCode>General</c:formatCode>
                <c:ptCount val="10"/>
                <c:pt idx="0">
                  <c:v>1.3232100079653299</c:v>
                </c:pt>
                <c:pt idx="1">
                  <c:v>1.7994954549709001</c:v>
                </c:pt>
                <c:pt idx="2">
                  <c:v>1.6596395200766301</c:v>
                </c:pt>
                <c:pt idx="3">
                  <c:v>1.4333487392530397</c:v>
                </c:pt>
                <c:pt idx="4">
                  <c:v>1.2382040922372901</c:v>
                </c:pt>
                <c:pt idx="5">
                  <c:v>1.63911566679221</c:v>
                </c:pt>
                <c:pt idx="6">
                  <c:v>1.2569546113808101</c:v>
                </c:pt>
                <c:pt idx="7">
                  <c:v>1.0778967922282403</c:v>
                </c:pt>
                <c:pt idx="8">
                  <c:v>1.1249765242838998</c:v>
                </c:pt>
                <c:pt idx="9">
                  <c:v>1.9129592313841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469-431A-8A9D-0C247D311848}"/>
            </c:ext>
          </c:extLst>
        </c:ser>
        <c:ser>
          <c:idx val="6"/>
          <c:order val="6"/>
          <c:tx>
            <c:strRef>
              <c:f>Sheet3!$H$3</c:f>
              <c:strCache>
                <c:ptCount val="1"/>
                <c:pt idx="0">
                  <c:v>FC/FC_0.9/1.1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A$4:$A$13</c:f>
              <c:strCache>
                <c:ptCount val="10"/>
                <c:pt idx="0">
                  <c:v>AHNAK</c:v>
                </c:pt>
                <c:pt idx="1">
                  <c:v>ACSS1</c:v>
                </c:pt>
                <c:pt idx="2">
                  <c:v>ST3GAL4</c:v>
                </c:pt>
                <c:pt idx="3">
                  <c:v>NEDD4L</c:v>
                </c:pt>
                <c:pt idx="4">
                  <c:v>GRHL2</c:v>
                </c:pt>
                <c:pt idx="5">
                  <c:v>DDIT4</c:v>
                </c:pt>
                <c:pt idx="6">
                  <c:v>ECE1</c:v>
                </c:pt>
                <c:pt idx="7">
                  <c:v>SLC5A6</c:v>
                </c:pt>
                <c:pt idx="8">
                  <c:v>WWC1</c:v>
                </c:pt>
                <c:pt idx="9">
                  <c:v>PLLP</c:v>
                </c:pt>
              </c:strCache>
            </c:strRef>
          </c:cat>
          <c:val>
            <c:numRef>
              <c:f>Sheet3!$H$4:$H$13</c:f>
            </c:numRef>
          </c:val>
          <c:extLst>
            <c:ext xmlns:c16="http://schemas.microsoft.com/office/drawing/2014/chart" uri="{C3380CC4-5D6E-409C-BE32-E72D297353CC}">
              <c16:uniqueId val="{00000006-8469-431A-8A9D-0C247D311848}"/>
            </c:ext>
          </c:extLst>
        </c:ser>
        <c:ser>
          <c:idx val="7"/>
          <c:order val="7"/>
          <c:tx>
            <c:strRef>
              <c:f>Sheet3!$I$3</c:f>
              <c:strCache>
                <c:ptCount val="1"/>
                <c:pt idx="0">
                  <c:v>FC/FC_0.8/1.2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A$4:$A$13</c:f>
              <c:strCache>
                <c:ptCount val="10"/>
                <c:pt idx="0">
                  <c:v>AHNAK</c:v>
                </c:pt>
                <c:pt idx="1">
                  <c:v>ACSS1</c:v>
                </c:pt>
                <c:pt idx="2">
                  <c:v>ST3GAL4</c:v>
                </c:pt>
                <c:pt idx="3">
                  <c:v>NEDD4L</c:v>
                </c:pt>
                <c:pt idx="4">
                  <c:v>GRHL2</c:v>
                </c:pt>
                <c:pt idx="5">
                  <c:v>DDIT4</c:v>
                </c:pt>
                <c:pt idx="6">
                  <c:v>ECE1</c:v>
                </c:pt>
                <c:pt idx="7">
                  <c:v>SLC5A6</c:v>
                </c:pt>
                <c:pt idx="8">
                  <c:v>WWC1</c:v>
                </c:pt>
                <c:pt idx="9">
                  <c:v>PLLP</c:v>
                </c:pt>
              </c:strCache>
            </c:strRef>
          </c:cat>
          <c:val>
            <c:numRef>
              <c:f>Sheet3!$I$4:$I$13</c:f>
            </c:numRef>
          </c:val>
          <c:extLst>
            <c:ext xmlns:c16="http://schemas.microsoft.com/office/drawing/2014/chart" uri="{C3380CC4-5D6E-409C-BE32-E72D297353CC}">
              <c16:uniqueId val="{00000007-8469-431A-8A9D-0C247D3118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30754448"/>
        <c:axId val="2030755408"/>
      </c:barChart>
      <c:catAx>
        <c:axId val="2030754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30755408"/>
        <c:crosses val="autoZero"/>
        <c:auto val="1"/>
        <c:lblAlgn val="ctr"/>
        <c:lblOffset val="100"/>
        <c:noMultiLvlLbl val="0"/>
      </c:catAx>
      <c:valAx>
        <c:axId val="203075540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30754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MY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664EC1-300F-4603-B026-AA8F961DF4CC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MY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39DC55-A725-45C3-B126-F776C71A64A6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3049481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r>
              <a:rPr lang="en-US" sz="1800" b="0" i="0" u="none" strike="noStrike" baseline="0" dirty="0">
                <a:latin typeface="Arial-BoldMT"/>
              </a:rPr>
              <a:t>Supplementary Fig. 1 </a:t>
            </a:r>
            <a:r>
              <a:rPr lang="en-SG" sz="1800" b="1" dirty="0">
                <a:latin typeface="Arial" panose="020B0604020202020204" pitchFamily="34" charset="0"/>
                <a:cs typeface="Arial" panose="020B0604020202020204" pitchFamily="34" charset="0"/>
              </a:rPr>
              <a:t>PR AF1 mutants exhibits normal nuclear localization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US" sz="1800" b="0" i="0" u="none" strike="noStrike" baseline="0" dirty="0">
                <a:latin typeface="Arial-BoldMT"/>
              </a:rPr>
              <a:t>Verification of PR overexpression in transduced MCF-7 stable cell line. </a:t>
            </a:r>
            <a:r>
              <a:rPr lang="en-US" sz="1800" b="0" i="0" u="none" strike="noStrike" baseline="0" dirty="0">
                <a:latin typeface="ArialMT"/>
              </a:rPr>
              <a:t>Immunofluorescent histology of overexpressed PR cells lines. DAPI (blue), PR (green) </a:t>
            </a:r>
            <a:r>
              <a:rPr lang="en-MY" sz="1800" b="0" i="0" u="none" strike="noStrike" baseline="0" dirty="0">
                <a:latin typeface="ArialMT"/>
              </a:rPr>
              <a:t>and DAPI+PR combined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DE7E68-C9EC-44C3-A8EF-8559508137C3}" type="slidenum">
              <a:rPr lang="en-SG" smtClean="0"/>
              <a:t>1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8646263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639FF0-4403-D24E-85BE-5D63E3A4667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B95756F-C42B-CDAC-52D7-708EB3945F2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90819B33-AA29-413C-26EE-3F7BB8ED5B6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MY" dirty="0"/>
              <a:t>Supplementary Fig. 3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US" dirty="0"/>
              <a:t>GSEA of EV and </a:t>
            </a:r>
            <a:r>
              <a:rPr lang="en-US" dirty="0" err="1"/>
              <a:t>Wt</a:t>
            </a:r>
            <a:r>
              <a:rPr lang="en-US" dirty="0"/>
              <a:t>-PRB when is E2 treated (FDR&gt;0.25). More enriched hallmark in </a:t>
            </a:r>
            <a:r>
              <a:rPr lang="en-US" dirty="0" err="1"/>
              <a:t>Wt</a:t>
            </a:r>
            <a:r>
              <a:rPr lang="en-US" dirty="0"/>
              <a:t>-PRB though less genes regulated compared to EV when is E2 treated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MY" dirty="0"/>
              <a:t>E2 regulated gene in </a:t>
            </a:r>
            <a:r>
              <a:rPr lang="en-MY" dirty="0" err="1"/>
              <a:t>Wt</a:t>
            </a:r>
            <a:r>
              <a:rPr lang="en-MY" dirty="0"/>
              <a:t>-PRB compared to PRB-FFF (</a:t>
            </a:r>
            <a:r>
              <a:rPr lang="en-MY" dirty="0" err="1"/>
              <a:t>i</a:t>
            </a:r>
            <a:r>
              <a:rPr lang="en-MY" dirty="0"/>
              <a:t>) and PRB-QQQ (ii). Only marginal difference were observed were only 12% of genes having more than 20% difference in PRB-FFF and PRB-QQQ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US" dirty="0"/>
              <a:t>Venn diagram indicating the number of genes significantly regulated by E2, R5020 and combination treatment E2+R5020 in </a:t>
            </a:r>
            <a:r>
              <a:rPr lang="en-US" dirty="0" err="1"/>
              <a:t>Wt</a:t>
            </a:r>
            <a:r>
              <a:rPr lang="en-US" dirty="0"/>
              <a:t>-PRB (</a:t>
            </a:r>
            <a:r>
              <a:rPr lang="en-US" dirty="0" err="1"/>
              <a:t>padj</a:t>
            </a:r>
            <a:r>
              <a:rPr lang="en-US" dirty="0"/>
              <a:t> &lt; 0.05)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US" dirty="0"/>
              <a:t>41% genes in </a:t>
            </a:r>
            <a:r>
              <a:rPr lang="en-US" dirty="0" err="1"/>
              <a:t>Wt</a:t>
            </a:r>
            <a:r>
              <a:rPr lang="en-US" dirty="0"/>
              <a:t>-PRB have more than 20% difference dysregulation when is E2R treated compared to E2 treated.</a:t>
            </a:r>
          </a:p>
          <a:p>
            <a:endParaRPr lang="en-MY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EDAB7DF-6DC3-7DD2-6DFA-39107D44ED1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39DC55-A725-45C3-B126-F776C71A64A6}" type="slidenum">
              <a:rPr lang="en-MY" smtClean="0"/>
              <a:t>2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5499367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67D88E4-68F8-8A59-E335-5FABF660420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EAFEDA6E-6B62-0F64-95AD-C9B547C3594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B1805453-B51E-525B-5285-295028C23EEE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MY" dirty="0"/>
              <a:t>Supplementary Fig. 3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US" dirty="0"/>
              <a:t>GSEA of EV and </a:t>
            </a:r>
            <a:r>
              <a:rPr lang="en-US" dirty="0" err="1"/>
              <a:t>Wt</a:t>
            </a:r>
            <a:r>
              <a:rPr lang="en-US" dirty="0"/>
              <a:t>-PRB when is E2 treated (FDR&gt;0.25). More enriched hallmark in </a:t>
            </a:r>
            <a:r>
              <a:rPr lang="en-US" dirty="0" err="1"/>
              <a:t>Wt</a:t>
            </a:r>
            <a:r>
              <a:rPr lang="en-US" dirty="0"/>
              <a:t>-PRB though less genes regulated compared to EV when is E2 treated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MY" dirty="0"/>
              <a:t>E2 regulated gene in </a:t>
            </a:r>
            <a:r>
              <a:rPr lang="en-MY" dirty="0" err="1"/>
              <a:t>Wt</a:t>
            </a:r>
            <a:r>
              <a:rPr lang="en-MY" dirty="0"/>
              <a:t>-PRB compared to PRB-FFF (</a:t>
            </a:r>
            <a:r>
              <a:rPr lang="en-MY" dirty="0" err="1"/>
              <a:t>i</a:t>
            </a:r>
            <a:r>
              <a:rPr lang="en-MY" dirty="0"/>
              <a:t>) and PRB-QQQ (ii). Only marginal difference were observed were only 12% of genes having more than 20% difference in PRB-FFF and PRB-QQQ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US" dirty="0"/>
              <a:t>Venn diagram indicating the number of genes significantly regulated by E2, R5020 and combination treatment E2+R5020 in </a:t>
            </a:r>
            <a:r>
              <a:rPr lang="en-US" dirty="0" err="1"/>
              <a:t>Wt</a:t>
            </a:r>
            <a:r>
              <a:rPr lang="en-US" dirty="0"/>
              <a:t>-PRB (</a:t>
            </a:r>
            <a:r>
              <a:rPr lang="en-US" dirty="0" err="1"/>
              <a:t>padj</a:t>
            </a:r>
            <a:r>
              <a:rPr lang="en-US" dirty="0"/>
              <a:t> &lt; 0.05).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US" dirty="0"/>
              <a:t>41% genes in </a:t>
            </a:r>
            <a:r>
              <a:rPr lang="en-US" dirty="0" err="1"/>
              <a:t>Wt</a:t>
            </a:r>
            <a:r>
              <a:rPr lang="en-US" dirty="0"/>
              <a:t>-PRB have more than 20% difference dysregulation when is E2R treated compared to E2 treated.</a:t>
            </a:r>
          </a:p>
          <a:p>
            <a:endParaRPr lang="en-MY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F5C00F-C307-904C-2ACE-F2C674B61A8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39DC55-A725-45C3-B126-F776C71A64A6}" type="slidenum">
              <a:rPr lang="en-MY" smtClean="0"/>
              <a:t>4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6161345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5BB8307-BFDB-E545-DFEF-35BF2DDF75C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14FAA53E-112A-AEF7-3065-0D5D68F076E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504CBC1-FCDD-D11B-49AD-C6401F69FB6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Supplementary Fig. 2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US" dirty="0"/>
              <a:t>Circle plot displaying PRB peak density for all chromosomes. FFF has enriched binding in all chromosomes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UcParenBoth"/>
              <a:tabLst/>
              <a:defRPr/>
            </a:pPr>
            <a:r>
              <a:rPr lang="en-US" dirty="0"/>
              <a:t>Global distribution of PR peaks called in PRB, PRB-FFF and PRB-QQQ. The enriched binding in FFF is not limited to promoter regions only but across the regions</a:t>
            </a:r>
            <a:endParaRPr lang="en-MY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pPr marL="0" indent="0">
              <a:buNone/>
            </a:pPr>
            <a:endParaRPr lang="en-MY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5B5815-4D64-9EF9-A2DF-0B422A8EF42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1DE7E68-C9EC-44C3-A8EF-8559508137C3}" type="slidenum">
              <a:rPr lang="en-SG" smtClean="0"/>
              <a:t>5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9820863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081910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491046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713062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32426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036427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3058713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9021549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559654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37001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848072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728990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6F0F85-9ACE-4EAF-BF0F-154341519AAF}" type="datetimeFigureOut">
              <a:rPr lang="en-MY" smtClean="0"/>
              <a:t>23/3/2026</a:t>
            </a:fld>
            <a:endParaRPr lang="en-M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M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E9EADDC-5585-42DA-85A8-98758A270D9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684793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sv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png"/><Relationship Id="rId18" Type="http://schemas.microsoft.com/office/2007/relationships/hdphoto" Target="../media/hdphoto8.wdp"/><Relationship Id="rId3" Type="http://schemas.openxmlformats.org/officeDocument/2006/relationships/image" Target="../media/image3.png"/><Relationship Id="rId7" Type="http://schemas.openxmlformats.org/officeDocument/2006/relationships/image" Target="../media/image5.png"/><Relationship Id="rId12" Type="http://schemas.microsoft.com/office/2007/relationships/hdphoto" Target="../media/hdphoto5.wdp"/><Relationship Id="rId1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6" Type="http://schemas.microsoft.com/office/2007/relationships/hdphoto" Target="../media/hdphoto7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7.png"/><Relationship Id="rId5" Type="http://schemas.openxmlformats.org/officeDocument/2006/relationships/image" Target="../media/image4.png"/><Relationship Id="rId15" Type="http://schemas.openxmlformats.org/officeDocument/2006/relationships/image" Target="../media/image9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microsoft.com/office/2007/relationships/hdphoto" Target="../media/hdphoto6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18" Type="http://schemas.openxmlformats.org/officeDocument/2006/relationships/image" Target="../media/image3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17" Type="http://schemas.openxmlformats.org/officeDocument/2006/relationships/image" Target="../media/image34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5" Type="http://schemas.openxmlformats.org/officeDocument/2006/relationships/image" Target="../media/image32.jp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Relationship Id="rId14" Type="http://schemas.openxmlformats.org/officeDocument/2006/relationships/image" Target="../media/image31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3" Type="http://schemas.openxmlformats.org/officeDocument/2006/relationships/image" Target="../media/image37.png"/><Relationship Id="rId7" Type="http://schemas.openxmlformats.org/officeDocument/2006/relationships/image" Target="../media/image41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10" Type="http://schemas.openxmlformats.org/officeDocument/2006/relationships/image" Target="../media/image44.png"/><Relationship Id="rId4" Type="http://schemas.openxmlformats.org/officeDocument/2006/relationships/image" Target="../media/image38.png"/><Relationship Id="rId9" Type="http://schemas.openxmlformats.org/officeDocument/2006/relationships/image" Target="../media/image4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7D7A5262-B365-5550-7193-FA54ADA58E86}"/>
              </a:ext>
            </a:extLst>
          </p:cNvPr>
          <p:cNvGrpSpPr/>
          <p:nvPr/>
        </p:nvGrpSpPr>
        <p:grpSpPr>
          <a:xfrm>
            <a:off x="765510" y="946320"/>
            <a:ext cx="4962043" cy="2903414"/>
            <a:chOff x="685332" y="1425298"/>
            <a:chExt cx="4962043" cy="2903414"/>
          </a:xfrm>
        </p:grpSpPr>
        <p:pic>
          <p:nvPicPr>
            <p:cNvPr id="37" name="Graphic 36">
              <a:extLst>
                <a:ext uri="{FF2B5EF4-FFF2-40B4-BE49-F238E27FC236}">
                  <a16:creationId xmlns:a16="http://schemas.microsoft.com/office/drawing/2014/main" id="{942880D3-B954-EE75-C52F-35A7370FB7F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rcRect l="8932" t="5634"/>
            <a:stretch/>
          </p:blipFill>
          <p:spPr>
            <a:xfrm>
              <a:off x="1327375" y="1619273"/>
              <a:ext cx="4320000" cy="2709439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C7A5079-1259-BAF8-7A43-0E8DEAC3A2F1}"/>
                </a:ext>
              </a:extLst>
            </p:cNvPr>
            <p:cNvSpPr txBox="1"/>
            <p:nvPr/>
          </p:nvSpPr>
          <p:spPr>
            <a:xfrm>
              <a:off x="1653617" y="1425298"/>
              <a:ext cx="3602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3D6465D-FEEC-2DD6-93BC-A9B74538B91E}"/>
                </a:ext>
              </a:extLst>
            </p:cNvPr>
            <p:cNvSpPr txBox="1"/>
            <p:nvPr/>
          </p:nvSpPr>
          <p:spPr>
            <a:xfrm>
              <a:off x="2675990" y="1425298"/>
              <a:ext cx="621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PRB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907FB0F-443F-1B68-435B-8A7C99F6A8F0}"/>
                </a:ext>
              </a:extLst>
            </p:cNvPr>
            <p:cNvSpPr txBox="1"/>
            <p:nvPr/>
          </p:nvSpPr>
          <p:spPr>
            <a:xfrm>
              <a:off x="3640253" y="1425298"/>
              <a:ext cx="7028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PRB−FFF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AF945A5-2D28-2B3E-79BC-9B528B88ACC6}"/>
                </a:ext>
              </a:extLst>
            </p:cNvPr>
            <p:cNvSpPr txBox="1"/>
            <p:nvPr/>
          </p:nvSpPr>
          <p:spPr>
            <a:xfrm>
              <a:off x="4717646" y="1425298"/>
              <a:ext cx="70280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PRB−QQQ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2992F42-F7DC-70A2-D06F-8828DBAA3B99}"/>
                </a:ext>
              </a:extLst>
            </p:cNvPr>
            <p:cNvSpPr txBox="1"/>
            <p:nvPr/>
          </p:nvSpPr>
          <p:spPr>
            <a:xfrm>
              <a:off x="947347" y="2002971"/>
              <a:ext cx="463718" cy="214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022EB2F-FCD3-E94C-D25A-9A1860478A72}"/>
                </a:ext>
              </a:extLst>
            </p:cNvPr>
            <p:cNvSpPr txBox="1"/>
            <p:nvPr/>
          </p:nvSpPr>
          <p:spPr>
            <a:xfrm>
              <a:off x="945093" y="2866635"/>
              <a:ext cx="463718" cy="2147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PR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1FAEDD4-0142-0B42-43E7-1D196C71DA02}"/>
                </a:ext>
              </a:extLst>
            </p:cNvPr>
            <p:cNvSpPr txBox="1"/>
            <p:nvPr/>
          </p:nvSpPr>
          <p:spPr>
            <a:xfrm>
              <a:off x="685332" y="3730299"/>
              <a:ext cx="720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DAPI+PR</a:t>
              </a:r>
            </a:p>
          </p:txBody>
        </p: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812AFA1F-FB6F-5A21-95B0-7194B9ECFD92}"/>
              </a:ext>
            </a:extLst>
          </p:cNvPr>
          <p:cNvSpPr txBox="1"/>
          <p:nvPr/>
        </p:nvSpPr>
        <p:spPr>
          <a:xfrm>
            <a:off x="829638" y="581689"/>
            <a:ext cx="2054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S1</a:t>
            </a:r>
            <a:endParaRPr lang="en-MY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5C82B4A-0258-5B4C-CAF7-0892392F2CA1}"/>
              </a:ext>
            </a:extLst>
          </p:cNvPr>
          <p:cNvSpPr txBox="1"/>
          <p:nvPr/>
        </p:nvSpPr>
        <p:spPr>
          <a:xfrm>
            <a:off x="829638" y="4114985"/>
            <a:ext cx="4891565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SG" sz="1000" b="1" dirty="0">
                <a:latin typeface="Arial" panose="020B0604020202020204" pitchFamily="34" charset="0"/>
                <a:cs typeface="Arial" panose="020B0604020202020204" pitchFamily="34" charset="0"/>
              </a:rPr>
              <a:t>PR AF1 mutants exhibit normal nuclear localization. </a:t>
            </a:r>
            <a:r>
              <a:rPr lang="en-US" sz="10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Immunofluorescence analysis verifying PR overexpression in transduced MCF-7 stable cell line. PR (green) shows nuclear localization. Nuclei are counterstained with DAPI (blue); merged images show DAPI+PR.</a:t>
            </a:r>
            <a:endParaRPr lang="en-MY" sz="1000" b="0" i="0" u="none" strike="noStrike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93063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1067BA1-E8ED-1C99-74CC-35CAC573495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TextBox 178">
            <a:extLst>
              <a:ext uri="{FF2B5EF4-FFF2-40B4-BE49-F238E27FC236}">
                <a16:creationId xmlns:a16="http://schemas.microsoft.com/office/drawing/2014/main" id="{4B4CC220-5A42-2ACB-AD06-4336729C0D14}"/>
              </a:ext>
            </a:extLst>
          </p:cNvPr>
          <p:cNvSpPr txBox="1"/>
          <p:nvPr/>
        </p:nvSpPr>
        <p:spPr>
          <a:xfrm>
            <a:off x="769761" y="506982"/>
            <a:ext cx="2061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70ECDC4B-DD4D-E56B-D067-B6DF2802B0DD}"/>
              </a:ext>
            </a:extLst>
          </p:cNvPr>
          <p:cNvSpPr txBox="1"/>
          <p:nvPr/>
        </p:nvSpPr>
        <p:spPr>
          <a:xfrm>
            <a:off x="867018" y="3796116"/>
            <a:ext cx="5039312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MY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  <a:r>
              <a:rPr lang="en-MY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5020 induced less cell spreading in PRB-FFF cells compared to in PRB and PRB-QQQ cells after 96h treatment. EV cells as control showed no response to R5020 treatment.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376B0343-4258-6209-DDDE-039C4A2D9B2B}"/>
              </a:ext>
            </a:extLst>
          </p:cNvPr>
          <p:cNvGrpSpPr/>
          <p:nvPr/>
        </p:nvGrpSpPr>
        <p:grpSpPr>
          <a:xfrm>
            <a:off x="898105" y="1201225"/>
            <a:ext cx="4977696" cy="2353366"/>
            <a:chOff x="1004553" y="3987101"/>
            <a:chExt cx="4977696" cy="2353366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21FA2A1-2E29-0B5E-62C5-273A2A4CAF30}"/>
                </a:ext>
              </a:extLst>
            </p:cNvPr>
            <p:cNvSpPr txBox="1"/>
            <p:nvPr/>
          </p:nvSpPr>
          <p:spPr>
            <a:xfrm>
              <a:off x="1664467" y="3993940"/>
              <a:ext cx="4709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2F82D14-D5DF-1506-3257-CA7451920D17}"/>
                </a:ext>
              </a:extLst>
            </p:cNvPr>
            <p:cNvSpPr txBox="1"/>
            <p:nvPr/>
          </p:nvSpPr>
          <p:spPr>
            <a:xfrm>
              <a:off x="2671859" y="4004060"/>
              <a:ext cx="621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PRB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6F77E75-65B4-679C-E383-6D1133F0A256}"/>
                </a:ext>
              </a:extLst>
            </p:cNvPr>
            <p:cNvSpPr txBox="1"/>
            <p:nvPr/>
          </p:nvSpPr>
          <p:spPr>
            <a:xfrm>
              <a:off x="3921389" y="4004905"/>
              <a:ext cx="6984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PRB−FFF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841AC95-7435-C1C7-A922-7F301DA29003}"/>
                </a:ext>
              </a:extLst>
            </p:cNvPr>
            <p:cNvSpPr txBox="1"/>
            <p:nvPr/>
          </p:nvSpPr>
          <p:spPr>
            <a:xfrm>
              <a:off x="5077741" y="3987101"/>
              <a:ext cx="761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PRB−QQQ</a:t>
              </a:r>
            </a:p>
          </p:txBody>
        </p:sp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5332A7D1-FDDB-5CEA-49C9-47C199BA50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6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202" t="11726"/>
            <a:stretch/>
          </p:blipFill>
          <p:spPr>
            <a:xfrm>
              <a:off x="1232075" y="4207333"/>
              <a:ext cx="1140038" cy="1032225"/>
            </a:xfrm>
            <a:prstGeom prst="rect">
              <a:avLst/>
            </a:prstGeom>
          </p:spPr>
        </p:pic>
        <p:pic>
          <p:nvPicPr>
            <p:cNvPr id="87" name="Picture 86">
              <a:extLst>
                <a:ext uri="{FF2B5EF4-FFF2-40B4-BE49-F238E27FC236}">
                  <a16:creationId xmlns:a16="http://schemas.microsoft.com/office/drawing/2014/main" id="{4DF34ACB-736A-7BF8-4099-D121FB7652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6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55" t="11807"/>
            <a:stretch/>
          </p:blipFill>
          <p:spPr>
            <a:xfrm>
              <a:off x="2451474" y="4207333"/>
              <a:ext cx="1136943" cy="1032225"/>
            </a:xfrm>
            <a:prstGeom prst="rect">
              <a:avLst/>
            </a:prstGeom>
          </p:spPr>
        </p:pic>
        <p:pic>
          <p:nvPicPr>
            <p:cNvPr id="88" name="Picture 87">
              <a:extLst>
                <a:ext uri="{FF2B5EF4-FFF2-40B4-BE49-F238E27FC236}">
                  <a16:creationId xmlns:a16="http://schemas.microsoft.com/office/drawing/2014/main" id="{EC1EED60-000D-EA32-2FEB-8FB790C92F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6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38" t="10322"/>
            <a:stretch/>
          </p:blipFill>
          <p:spPr>
            <a:xfrm>
              <a:off x="1232075" y="5308242"/>
              <a:ext cx="1140036" cy="1032225"/>
            </a:xfrm>
            <a:prstGeom prst="rect">
              <a:avLst/>
            </a:prstGeom>
          </p:spPr>
        </p:pic>
        <p:pic>
          <p:nvPicPr>
            <p:cNvPr id="89" name="Picture 88">
              <a:extLst>
                <a:ext uri="{FF2B5EF4-FFF2-40B4-BE49-F238E27FC236}">
                  <a16:creationId xmlns:a16="http://schemas.microsoft.com/office/drawing/2014/main" id="{770D34B9-D4DB-11F7-3B19-988E5A462D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6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31" t="11834"/>
            <a:stretch/>
          </p:blipFill>
          <p:spPr>
            <a:xfrm>
              <a:off x="3652494" y="4194637"/>
              <a:ext cx="1136943" cy="1032225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399FEDF4-F37E-26C0-C251-9E25AEB0A7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6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806" t="11807"/>
            <a:stretch/>
          </p:blipFill>
          <p:spPr>
            <a:xfrm>
              <a:off x="4845306" y="4197401"/>
              <a:ext cx="1136943" cy="1032225"/>
            </a:xfrm>
            <a:prstGeom prst="rect">
              <a:avLst/>
            </a:prstGeom>
          </p:spPr>
        </p:pic>
        <p:pic>
          <p:nvPicPr>
            <p:cNvPr id="91" name="Picture 90">
              <a:extLst>
                <a:ext uri="{FF2B5EF4-FFF2-40B4-BE49-F238E27FC236}">
                  <a16:creationId xmlns:a16="http://schemas.microsoft.com/office/drawing/2014/main" id="{01BBC4BE-6479-14BC-87F0-ED3E3B93E8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6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21" t="10317"/>
            <a:stretch/>
          </p:blipFill>
          <p:spPr>
            <a:xfrm>
              <a:off x="2448880" y="5299497"/>
              <a:ext cx="1144831" cy="1032225"/>
            </a:xfrm>
            <a:prstGeom prst="rect">
              <a:avLst/>
            </a:prstGeom>
          </p:spPr>
        </p:pic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81464BC3-3EBC-DF6E-12E6-C93BC332D3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6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21" t="11487"/>
            <a:stretch/>
          </p:blipFill>
          <p:spPr>
            <a:xfrm>
              <a:off x="3652494" y="5288549"/>
              <a:ext cx="1136943" cy="1032225"/>
            </a:xfrm>
            <a:prstGeom prst="rect">
              <a:avLst/>
            </a:prstGeom>
          </p:spPr>
        </p:pic>
        <p:pic>
          <p:nvPicPr>
            <p:cNvPr id="93" name="Picture 92">
              <a:extLst>
                <a:ext uri="{FF2B5EF4-FFF2-40B4-BE49-F238E27FC236}">
                  <a16:creationId xmlns:a16="http://schemas.microsoft.com/office/drawing/2014/main" id="{03FFDD43-BB47-883E-6055-8AE3B1AA8E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6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669" t="11487"/>
            <a:stretch/>
          </p:blipFill>
          <p:spPr>
            <a:xfrm>
              <a:off x="4847922" y="5288380"/>
              <a:ext cx="1134327" cy="1032225"/>
            </a:xfrm>
            <a:prstGeom prst="rect">
              <a:avLst/>
            </a:prstGeom>
          </p:spPr>
        </p:pic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1588B2E7-7C11-28E0-C6A9-C0143A672055}"/>
                </a:ext>
              </a:extLst>
            </p:cNvPr>
            <p:cNvSpPr txBox="1"/>
            <p:nvPr/>
          </p:nvSpPr>
          <p:spPr>
            <a:xfrm rot="16200000">
              <a:off x="825359" y="4658212"/>
              <a:ext cx="5892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EAB5D9D-1261-EC8C-2FD7-930B24E40889}"/>
                </a:ext>
              </a:extLst>
            </p:cNvPr>
            <p:cNvSpPr txBox="1"/>
            <p:nvPr/>
          </p:nvSpPr>
          <p:spPr>
            <a:xfrm rot="16200000">
              <a:off x="877470" y="5599853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R5020</a:t>
              </a:r>
              <a:endParaRPr lang="en-SG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164131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0B04AAC-B485-BA22-DA48-0483D207B526}"/>
              </a:ext>
            </a:extLst>
          </p:cNvPr>
          <p:cNvSpPr txBox="1"/>
          <p:nvPr/>
        </p:nvSpPr>
        <p:spPr>
          <a:xfrm>
            <a:off x="769761" y="506982"/>
            <a:ext cx="2042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26E724C-E9F4-B494-70B6-2DB5F6FCC375}"/>
              </a:ext>
            </a:extLst>
          </p:cNvPr>
          <p:cNvGrpSpPr/>
          <p:nvPr/>
        </p:nvGrpSpPr>
        <p:grpSpPr>
          <a:xfrm>
            <a:off x="388783" y="1100976"/>
            <a:ext cx="6108913" cy="2272629"/>
            <a:chOff x="388783" y="929520"/>
            <a:chExt cx="6108913" cy="2272629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DA12AB0F-8F9D-6E89-DE1B-2FE8FBE2E63D}"/>
                </a:ext>
              </a:extLst>
            </p:cNvPr>
            <p:cNvGrpSpPr/>
            <p:nvPr/>
          </p:nvGrpSpPr>
          <p:grpSpPr>
            <a:xfrm>
              <a:off x="388783" y="1277021"/>
              <a:ext cx="1543977" cy="1918942"/>
              <a:chOff x="431180" y="1041455"/>
              <a:chExt cx="1543977" cy="1918942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AC922CE9-89F9-2FF0-C70A-76FCE08D53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436" t="5513" r="20256" b="7309"/>
              <a:stretch>
                <a:fillRect/>
              </a:stretch>
            </p:blipFill>
            <p:spPr>
              <a:xfrm>
                <a:off x="769761" y="1277816"/>
                <a:ext cx="1080000" cy="1302127"/>
              </a:xfrm>
              <a:prstGeom prst="rect">
                <a:avLst/>
              </a:prstGeom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5227039-A2FF-743B-F997-C76EE318E68F}"/>
                  </a:ext>
                </a:extLst>
              </p:cNvPr>
              <p:cNvSpPr txBox="1"/>
              <p:nvPr/>
            </p:nvSpPr>
            <p:spPr>
              <a:xfrm>
                <a:off x="595785" y="2549238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0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9ABDF0B-1ED4-6B20-501B-A57B286A2A5E}"/>
                  </a:ext>
                </a:extLst>
              </p:cNvPr>
              <p:cNvSpPr txBox="1"/>
              <p:nvPr/>
            </p:nvSpPr>
            <p:spPr>
              <a:xfrm>
                <a:off x="849031" y="2547657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EE2F668D-3005-4425-3D15-3D6171EC1851}"/>
                  </a:ext>
                </a:extLst>
              </p:cNvPr>
              <p:cNvSpPr txBox="1"/>
              <p:nvPr/>
            </p:nvSpPr>
            <p:spPr>
              <a:xfrm>
                <a:off x="1140680" y="2552447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5D4F156C-2DC0-7A5C-D4C5-B16C2AEE1A7F}"/>
                  </a:ext>
                </a:extLst>
              </p:cNvPr>
              <p:cNvSpPr txBox="1"/>
              <p:nvPr/>
            </p:nvSpPr>
            <p:spPr>
              <a:xfrm>
                <a:off x="1401898" y="2546918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5E065E1-01B6-8D06-E97C-4764E17AADC6}"/>
                  </a:ext>
                </a:extLst>
              </p:cNvPr>
              <p:cNvSpPr txBox="1"/>
              <p:nvPr/>
            </p:nvSpPr>
            <p:spPr>
              <a:xfrm>
                <a:off x="459102" y="2335666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4C7FF36C-1F20-3884-DC89-24BA64D96812}"/>
                  </a:ext>
                </a:extLst>
              </p:cNvPr>
              <p:cNvSpPr txBox="1"/>
              <p:nvPr/>
            </p:nvSpPr>
            <p:spPr>
              <a:xfrm>
                <a:off x="452542" y="2091390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5BAA5B8A-E9F3-DA56-827B-354992461186}"/>
                  </a:ext>
                </a:extLst>
              </p:cNvPr>
              <p:cNvSpPr txBox="1"/>
              <p:nvPr/>
            </p:nvSpPr>
            <p:spPr>
              <a:xfrm>
                <a:off x="459239" y="1843753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18F84CF1-BB32-F5DF-460E-722248FB3A8D}"/>
                  </a:ext>
                </a:extLst>
              </p:cNvPr>
              <p:cNvSpPr txBox="1"/>
              <p:nvPr/>
            </p:nvSpPr>
            <p:spPr>
              <a:xfrm>
                <a:off x="459239" y="1595956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3F03181-B05A-993D-A9D1-6F7B4706CA73}"/>
                  </a:ext>
                </a:extLst>
              </p:cNvPr>
              <p:cNvSpPr txBox="1"/>
              <p:nvPr/>
            </p:nvSpPr>
            <p:spPr>
              <a:xfrm>
                <a:off x="458404" y="1343621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20118010-1F94-F95D-B6FE-25CC57C1ED0C}"/>
                  </a:ext>
                </a:extLst>
              </p:cNvPr>
              <p:cNvSpPr txBox="1"/>
              <p:nvPr/>
            </p:nvSpPr>
            <p:spPr>
              <a:xfrm>
                <a:off x="556576" y="2729565"/>
                <a:ext cx="141858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C1: 94% variance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41D78C1B-1130-91BD-C397-9EEA75E8D710}"/>
                  </a:ext>
                </a:extLst>
              </p:cNvPr>
              <p:cNvSpPr txBox="1"/>
              <p:nvPr/>
            </p:nvSpPr>
            <p:spPr>
              <a:xfrm rot="16200000">
                <a:off x="-162988" y="1788865"/>
                <a:ext cx="141916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C2: 3% variance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8031E75-E8CC-D2ED-F67C-0FF2D97D48CD}"/>
                  </a:ext>
                </a:extLst>
              </p:cNvPr>
              <p:cNvSpPr txBox="1"/>
              <p:nvPr/>
            </p:nvSpPr>
            <p:spPr>
              <a:xfrm>
                <a:off x="1028197" y="1041455"/>
                <a:ext cx="40366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</a:p>
            </p:txBody>
          </p:sp>
        </p:grp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452E7FAA-CB38-5B02-CCB3-ECF766CD3B27}"/>
                </a:ext>
              </a:extLst>
            </p:cNvPr>
            <p:cNvGrpSpPr/>
            <p:nvPr/>
          </p:nvGrpSpPr>
          <p:grpSpPr>
            <a:xfrm>
              <a:off x="1913610" y="1277021"/>
              <a:ext cx="1519130" cy="1925128"/>
              <a:chOff x="2293877" y="1064901"/>
              <a:chExt cx="1519130" cy="1925128"/>
            </a:xfrm>
          </p:grpSpPr>
          <p:pic>
            <p:nvPicPr>
              <p:cNvPr id="53" name="Picture 52">
                <a:extLst>
                  <a:ext uri="{FF2B5EF4-FFF2-40B4-BE49-F238E27FC236}">
                    <a16:creationId xmlns:a16="http://schemas.microsoft.com/office/drawing/2014/main" id="{471E413A-46C5-92F4-CF88-4990A4F4CE5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60" t="5629" r="20513" b="7174"/>
              <a:stretch>
                <a:fillRect/>
              </a:stretch>
            </p:blipFill>
            <p:spPr>
              <a:xfrm>
                <a:off x="2612744" y="1328010"/>
                <a:ext cx="1080000" cy="1309301"/>
              </a:xfrm>
              <a:prstGeom prst="rect">
                <a:avLst/>
              </a:prstGeom>
            </p:spPr>
          </p:pic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8A9B0412-4AD6-4A28-C597-272AFBC4D715}"/>
                  </a:ext>
                </a:extLst>
              </p:cNvPr>
              <p:cNvSpPr txBox="1"/>
              <p:nvPr/>
            </p:nvSpPr>
            <p:spPr>
              <a:xfrm>
                <a:off x="2500045" y="2579113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0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0E5EC8D7-7175-3EC9-E68F-72ABC2647EF5}"/>
                  </a:ext>
                </a:extLst>
              </p:cNvPr>
              <p:cNvSpPr txBox="1"/>
              <p:nvPr/>
            </p:nvSpPr>
            <p:spPr>
              <a:xfrm>
                <a:off x="2706631" y="2579113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5A3B66FF-943A-F23B-C156-628571471F74}"/>
                  </a:ext>
                </a:extLst>
              </p:cNvPr>
              <p:cNvSpPr txBox="1"/>
              <p:nvPr/>
            </p:nvSpPr>
            <p:spPr>
              <a:xfrm>
                <a:off x="2913217" y="2579113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7A7DC4D9-0F69-CB4C-5D27-6DD5C83BFFF7}"/>
                  </a:ext>
                </a:extLst>
              </p:cNvPr>
              <p:cNvSpPr txBox="1"/>
              <p:nvPr/>
            </p:nvSpPr>
            <p:spPr>
              <a:xfrm>
                <a:off x="3108118" y="2579113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B5E03283-F2F7-BDE7-912D-E9EFD011E539}"/>
                  </a:ext>
                </a:extLst>
              </p:cNvPr>
              <p:cNvSpPr txBox="1"/>
              <p:nvPr/>
            </p:nvSpPr>
            <p:spPr>
              <a:xfrm>
                <a:off x="3294217" y="2579113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346CECB8-7B1B-9938-B4C6-5E0E9F6031F2}"/>
                  </a:ext>
                </a:extLst>
              </p:cNvPr>
              <p:cNvSpPr txBox="1"/>
              <p:nvPr/>
            </p:nvSpPr>
            <p:spPr>
              <a:xfrm>
                <a:off x="2300330" y="2183049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A68FA4A2-5CB1-31F1-742B-B3FAA7426FE6}"/>
                  </a:ext>
                </a:extLst>
              </p:cNvPr>
              <p:cNvSpPr txBox="1"/>
              <p:nvPr/>
            </p:nvSpPr>
            <p:spPr>
              <a:xfrm>
                <a:off x="2293877" y="1800988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1FD0D2C7-8210-E92E-E298-A74018BE1C21}"/>
                  </a:ext>
                </a:extLst>
              </p:cNvPr>
              <p:cNvSpPr txBox="1"/>
              <p:nvPr/>
            </p:nvSpPr>
            <p:spPr>
              <a:xfrm>
                <a:off x="2301564" y="1425072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70F8C39B-5677-652F-651C-9526EB745245}"/>
                  </a:ext>
                </a:extLst>
              </p:cNvPr>
              <p:cNvSpPr txBox="1"/>
              <p:nvPr/>
            </p:nvSpPr>
            <p:spPr>
              <a:xfrm rot="16200000">
                <a:off x="1711482" y="1801394"/>
                <a:ext cx="141916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C2: 27% variance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AED49B5D-14D2-D2EA-E685-44299D1A84E0}"/>
                  </a:ext>
                </a:extLst>
              </p:cNvPr>
              <p:cNvSpPr txBox="1"/>
              <p:nvPr/>
            </p:nvSpPr>
            <p:spPr>
              <a:xfrm>
                <a:off x="2394426" y="2759197"/>
                <a:ext cx="141858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C1: 69% variance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6EC71262-0391-6771-F499-6FC434C0F39E}"/>
                  </a:ext>
                </a:extLst>
              </p:cNvPr>
              <p:cNvSpPr txBox="1"/>
              <p:nvPr/>
            </p:nvSpPr>
            <p:spPr>
              <a:xfrm>
                <a:off x="2950910" y="1064901"/>
                <a:ext cx="47809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B</a:t>
                </a:r>
              </a:p>
            </p:txBody>
          </p:sp>
        </p:grp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0BBF87BF-4BE7-963B-8B49-B38222990BF1}"/>
                </a:ext>
              </a:extLst>
            </p:cNvPr>
            <p:cNvGrpSpPr/>
            <p:nvPr/>
          </p:nvGrpSpPr>
          <p:grpSpPr>
            <a:xfrm>
              <a:off x="3413038" y="1277021"/>
              <a:ext cx="1540554" cy="1913770"/>
              <a:chOff x="3793305" y="1064901"/>
              <a:chExt cx="1540554" cy="1913770"/>
            </a:xfrm>
          </p:grpSpPr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638985D2-3D1D-B7E2-8E34-01C1FA5187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60" t="5872" r="20384" b="7436"/>
              <a:stretch>
                <a:fillRect/>
              </a:stretch>
            </p:blipFill>
            <p:spPr>
              <a:xfrm>
                <a:off x="4097483" y="1355561"/>
                <a:ext cx="1080000" cy="1299362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D0980774-8AD6-6CBD-7C13-53F48D43AC34}"/>
                  </a:ext>
                </a:extLst>
              </p:cNvPr>
              <p:cNvSpPr txBox="1"/>
              <p:nvPr/>
            </p:nvSpPr>
            <p:spPr>
              <a:xfrm>
                <a:off x="4303439" y="1064901"/>
                <a:ext cx="7549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B−FFF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24926189-E0DA-7184-C43E-E7EBA46A092F}"/>
                  </a:ext>
                </a:extLst>
              </p:cNvPr>
              <p:cNvSpPr txBox="1"/>
              <p:nvPr/>
            </p:nvSpPr>
            <p:spPr>
              <a:xfrm>
                <a:off x="4007402" y="2607029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0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74E512E8-D467-5137-0465-7298CA27FAC0}"/>
                  </a:ext>
                </a:extLst>
              </p:cNvPr>
              <p:cNvSpPr txBox="1"/>
              <p:nvPr/>
            </p:nvSpPr>
            <p:spPr>
              <a:xfrm>
                <a:off x="4235332" y="2607029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F464217F-A12E-B9DB-92A0-EF75EEB43777}"/>
                  </a:ext>
                </a:extLst>
              </p:cNvPr>
              <p:cNvSpPr txBox="1"/>
              <p:nvPr/>
            </p:nvSpPr>
            <p:spPr>
              <a:xfrm>
                <a:off x="4473563" y="2603389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9A8B2B6D-07E6-CD3E-E0A1-FD0612650F98}"/>
                  </a:ext>
                </a:extLst>
              </p:cNvPr>
              <p:cNvSpPr txBox="1"/>
              <p:nvPr/>
            </p:nvSpPr>
            <p:spPr>
              <a:xfrm>
                <a:off x="4701493" y="2611473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4E28DC26-E185-23E3-4EDA-49B672DAD409}"/>
                  </a:ext>
                </a:extLst>
              </p:cNvPr>
              <p:cNvSpPr txBox="1"/>
              <p:nvPr/>
            </p:nvSpPr>
            <p:spPr>
              <a:xfrm>
                <a:off x="3793305" y="2280250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6FDD883C-DE59-CC0C-6279-8A30D0DA5E76}"/>
                  </a:ext>
                </a:extLst>
              </p:cNvPr>
              <p:cNvSpPr txBox="1"/>
              <p:nvPr/>
            </p:nvSpPr>
            <p:spPr>
              <a:xfrm>
                <a:off x="3798003" y="1974921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146CC9C1-A9A7-2DFE-685E-A306E19D44FE}"/>
                  </a:ext>
                </a:extLst>
              </p:cNvPr>
              <p:cNvSpPr txBox="1"/>
              <p:nvPr/>
            </p:nvSpPr>
            <p:spPr>
              <a:xfrm>
                <a:off x="3793573" y="1669213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E7D14DE5-57FC-3DC6-1684-E55969029339}"/>
                  </a:ext>
                </a:extLst>
              </p:cNvPr>
              <p:cNvSpPr txBox="1"/>
              <p:nvPr/>
            </p:nvSpPr>
            <p:spPr>
              <a:xfrm rot="16200000">
                <a:off x="3199203" y="1818802"/>
                <a:ext cx="143215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C2: 43% variance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EC1C2CA3-EDE5-707F-E24E-9A0E9F33E372}"/>
                  </a:ext>
                </a:extLst>
              </p:cNvPr>
              <p:cNvSpPr txBox="1"/>
              <p:nvPr/>
            </p:nvSpPr>
            <p:spPr>
              <a:xfrm>
                <a:off x="3793305" y="1355561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CFC8F040-8370-A3D1-55CC-39C69CC1AFF8}"/>
                  </a:ext>
                </a:extLst>
              </p:cNvPr>
              <p:cNvSpPr txBox="1"/>
              <p:nvPr/>
            </p:nvSpPr>
            <p:spPr>
              <a:xfrm>
                <a:off x="3915278" y="2747839"/>
                <a:ext cx="141858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C1: 52% variance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E969C00D-B228-239D-5196-89D70C535994}"/>
                  </a:ext>
                </a:extLst>
              </p:cNvPr>
              <p:cNvSpPr txBox="1"/>
              <p:nvPr/>
            </p:nvSpPr>
            <p:spPr>
              <a:xfrm>
                <a:off x="4916310" y="2606510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</p:grp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E48C628D-70CF-EDEA-45FB-AAE5A2902894}"/>
                </a:ext>
              </a:extLst>
            </p:cNvPr>
            <p:cNvGrpSpPr/>
            <p:nvPr/>
          </p:nvGrpSpPr>
          <p:grpSpPr>
            <a:xfrm>
              <a:off x="4919670" y="1277021"/>
              <a:ext cx="1578026" cy="1913770"/>
              <a:chOff x="5231131" y="1064901"/>
              <a:chExt cx="1578026" cy="1913770"/>
            </a:xfrm>
          </p:grpSpPr>
          <p:pic>
            <p:nvPicPr>
              <p:cNvPr id="74" name="Picture 73">
                <a:extLst>
                  <a:ext uri="{FF2B5EF4-FFF2-40B4-BE49-F238E27FC236}">
                    <a16:creationId xmlns:a16="http://schemas.microsoft.com/office/drawing/2014/main" id="{4CD2F9F2-AE97-4676-BF89-BB1F70018F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39" t="5783" r="20641" b="8076"/>
              <a:stretch>
                <a:fillRect/>
              </a:stretch>
            </p:blipFill>
            <p:spPr>
              <a:xfrm>
                <a:off x="5539280" y="1359364"/>
                <a:ext cx="1080000" cy="1291755"/>
              </a:xfrm>
              <a:prstGeom prst="rect">
                <a:avLst/>
              </a:prstGeom>
            </p:spPr>
          </p:pic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656894E2-9F2F-7A47-0917-DBA2B3879ADB}"/>
                  </a:ext>
                </a:extLst>
              </p:cNvPr>
              <p:cNvSpPr txBox="1"/>
              <p:nvPr/>
            </p:nvSpPr>
            <p:spPr>
              <a:xfrm>
                <a:off x="5521913" y="2603814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10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CE2CD494-0EC8-723B-7A94-6DB002F35E8E}"/>
                  </a:ext>
                </a:extLst>
              </p:cNvPr>
              <p:cNvSpPr txBox="1"/>
              <p:nvPr/>
            </p:nvSpPr>
            <p:spPr>
              <a:xfrm>
                <a:off x="5868708" y="2611473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81FDD9BE-E98A-2EF4-6A1F-D8F349C77D03}"/>
                  </a:ext>
                </a:extLst>
              </p:cNvPr>
              <p:cNvSpPr txBox="1"/>
              <p:nvPr/>
            </p:nvSpPr>
            <p:spPr>
              <a:xfrm>
                <a:off x="5390576" y="2747839"/>
                <a:ext cx="141858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C1: 77% variance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8E0BB4EA-1D74-4B16-1A3B-69EFB4848BD6}"/>
                  </a:ext>
                </a:extLst>
              </p:cNvPr>
              <p:cNvSpPr txBox="1"/>
              <p:nvPr/>
            </p:nvSpPr>
            <p:spPr>
              <a:xfrm>
                <a:off x="6186134" y="2611473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A403FD1A-931F-ACD9-C8B2-540BD6E2CD70}"/>
                  </a:ext>
                </a:extLst>
              </p:cNvPr>
              <p:cNvSpPr txBox="1"/>
              <p:nvPr/>
            </p:nvSpPr>
            <p:spPr>
              <a:xfrm>
                <a:off x="5237584" y="2212811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A47CA956-64C2-88F5-58AB-EECE32BD6D86}"/>
                  </a:ext>
                </a:extLst>
              </p:cNvPr>
              <p:cNvSpPr txBox="1"/>
              <p:nvPr/>
            </p:nvSpPr>
            <p:spPr>
              <a:xfrm>
                <a:off x="5231131" y="1860060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6E998702-AA7C-6640-3B17-8D0CFB257CF6}"/>
                  </a:ext>
                </a:extLst>
              </p:cNvPr>
              <p:cNvSpPr txBox="1"/>
              <p:nvPr/>
            </p:nvSpPr>
            <p:spPr>
              <a:xfrm>
                <a:off x="5238818" y="1501730"/>
                <a:ext cx="381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B3E5AA83-ACC3-B6B1-B433-3B8BD4B66C38}"/>
                  </a:ext>
                </a:extLst>
              </p:cNvPr>
              <p:cNvSpPr txBox="1"/>
              <p:nvPr/>
            </p:nvSpPr>
            <p:spPr>
              <a:xfrm rot="16200000">
                <a:off x="4642874" y="1831156"/>
                <a:ext cx="141916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C2: 20% variance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16232BA2-22E5-B979-E282-87A9CADABCFD}"/>
                  </a:ext>
                </a:extLst>
              </p:cNvPr>
              <p:cNvSpPr txBox="1"/>
              <p:nvPr/>
            </p:nvSpPr>
            <p:spPr>
              <a:xfrm>
                <a:off x="5701800" y="1064901"/>
                <a:ext cx="79358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B−QQQ</a:t>
                </a:r>
              </a:p>
            </p:txBody>
          </p:sp>
        </p:grp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71E65379-B576-2C39-3454-4AC640D1C914}"/>
                </a:ext>
              </a:extLst>
            </p:cNvPr>
            <p:cNvGrpSpPr/>
            <p:nvPr/>
          </p:nvGrpSpPr>
          <p:grpSpPr>
            <a:xfrm>
              <a:off x="1647904" y="929520"/>
              <a:ext cx="944960" cy="282601"/>
              <a:chOff x="704304" y="3404307"/>
              <a:chExt cx="944960" cy="282601"/>
            </a:xfrm>
          </p:grpSpPr>
          <p:pic>
            <p:nvPicPr>
              <p:cNvPr id="87" name="Picture 86">
                <a:extLst>
                  <a:ext uri="{FF2B5EF4-FFF2-40B4-BE49-F238E27FC236}">
                    <a16:creationId xmlns:a16="http://schemas.microsoft.com/office/drawing/2014/main" id="{18958347-0CD5-0577-C274-25575C6DE3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173" t="40513" r="11795" b="53306"/>
              <a:stretch>
                <a:fillRect/>
              </a:stretch>
            </p:blipFill>
            <p:spPr>
              <a:xfrm>
                <a:off x="704304" y="3404307"/>
                <a:ext cx="230092" cy="282601"/>
              </a:xfrm>
              <a:prstGeom prst="rect">
                <a:avLst/>
              </a:prstGeom>
            </p:spPr>
          </p:pic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B9D462D9-F32A-D5CC-8969-1C1A1DFAAF01}"/>
                  </a:ext>
                </a:extLst>
              </p:cNvPr>
              <p:cNvSpPr txBox="1"/>
              <p:nvPr/>
            </p:nvSpPr>
            <p:spPr>
              <a:xfrm>
                <a:off x="902805" y="3447841"/>
                <a:ext cx="74645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</p:grp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CCEE06EB-9BFB-845F-A2D3-C23D29B1863C}"/>
                </a:ext>
              </a:extLst>
            </p:cNvPr>
            <p:cNvGrpSpPr/>
            <p:nvPr/>
          </p:nvGrpSpPr>
          <p:grpSpPr>
            <a:xfrm>
              <a:off x="2582533" y="952363"/>
              <a:ext cx="944960" cy="239077"/>
              <a:chOff x="704304" y="3730442"/>
              <a:chExt cx="944960" cy="239077"/>
            </a:xfrm>
          </p:grpSpPr>
          <p:pic>
            <p:nvPicPr>
              <p:cNvPr id="88" name="Picture 87">
                <a:extLst>
                  <a:ext uri="{FF2B5EF4-FFF2-40B4-BE49-F238E27FC236}">
                    <a16:creationId xmlns:a16="http://schemas.microsoft.com/office/drawing/2014/main" id="{194F2C76-A9C5-C2BB-FA79-38B25D2DB1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128" t="45813" r="11841" b="48958"/>
              <a:stretch>
                <a:fillRect/>
              </a:stretch>
            </p:blipFill>
            <p:spPr>
              <a:xfrm>
                <a:off x="704304" y="3730442"/>
                <a:ext cx="230092" cy="239077"/>
              </a:xfrm>
              <a:prstGeom prst="rect">
                <a:avLst/>
              </a:prstGeom>
            </p:spPr>
          </p:pic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0A4AEDCE-3D1B-5449-09C0-3BAA1ACE142D}"/>
                  </a:ext>
                </a:extLst>
              </p:cNvPr>
              <p:cNvSpPr txBox="1"/>
              <p:nvPr/>
            </p:nvSpPr>
            <p:spPr>
              <a:xfrm>
                <a:off x="902805" y="3754075"/>
                <a:ext cx="74645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2</a:t>
                </a:r>
              </a:p>
            </p:txBody>
          </p:sp>
        </p:grp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4C1CC19B-C4A4-D6F2-CBF2-289D0FC23BDC}"/>
                </a:ext>
              </a:extLst>
            </p:cNvPr>
            <p:cNvGrpSpPr/>
            <p:nvPr/>
          </p:nvGrpSpPr>
          <p:grpSpPr>
            <a:xfrm>
              <a:off x="3254842" y="969687"/>
              <a:ext cx="714869" cy="239077"/>
              <a:chOff x="704304" y="4060309"/>
              <a:chExt cx="714869" cy="239077"/>
            </a:xfrm>
          </p:grpSpPr>
          <p:pic>
            <p:nvPicPr>
              <p:cNvPr id="89" name="Picture 88">
                <a:extLst>
                  <a:ext uri="{FF2B5EF4-FFF2-40B4-BE49-F238E27FC236}">
                    <a16:creationId xmlns:a16="http://schemas.microsoft.com/office/drawing/2014/main" id="{D13B65CD-9D8E-7928-EEDC-42D08EA01E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067" t="51026" r="11901" b="43745"/>
              <a:stretch>
                <a:fillRect/>
              </a:stretch>
            </p:blipFill>
            <p:spPr>
              <a:xfrm>
                <a:off x="704304" y="4060309"/>
                <a:ext cx="230092" cy="239077"/>
              </a:xfrm>
              <a:prstGeom prst="rect">
                <a:avLst/>
              </a:prstGeom>
            </p:spPr>
          </p:pic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7F88F4F3-78D2-02BE-5217-629BA6AC1CB9}"/>
                  </a:ext>
                </a:extLst>
              </p:cNvPr>
              <p:cNvSpPr txBox="1"/>
              <p:nvPr/>
            </p:nvSpPr>
            <p:spPr>
              <a:xfrm>
                <a:off x="897185" y="4060309"/>
                <a:ext cx="52198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5020</a:t>
                </a:r>
              </a:p>
            </p:txBody>
          </p:sp>
        </p:grp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0514EAEB-E563-0241-B920-93D1005BD732}"/>
                </a:ext>
              </a:extLst>
            </p:cNvPr>
            <p:cNvGrpSpPr/>
            <p:nvPr/>
          </p:nvGrpSpPr>
          <p:grpSpPr>
            <a:xfrm>
              <a:off x="4152042" y="969687"/>
              <a:ext cx="963355" cy="251324"/>
              <a:chOff x="711443" y="4380421"/>
              <a:chExt cx="963355" cy="251324"/>
            </a:xfrm>
          </p:grpSpPr>
          <p:pic>
            <p:nvPicPr>
              <p:cNvPr id="90" name="Picture 89">
                <a:extLst>
                  <a:ext uri="{FF2B5EF4-FFF2-40B4-BE49-F238E27FC236}">
                    <a16:creationId xmlns:a16="http://schemas.microsoft.com/office/drawing/2014/main" id="{DE4EDEAF-3669-04D1-74BE-CA52E4DD00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173" t="56255" r="12292" b="38461"/>
              <a:stretch>
                <a:fillRect/>
              </a:stretch>
            </p:blipFill>
            <p:spPr>
              <a:xfrm>
                <a:off x="711443" y="4390176"/>
                <a:ext cx="207365" cy="241569"/>
              </a:xfrm>
              <a:prstGeom prst="rect">
                <a:avLst/>
              </a:prstGeom>
            </p:spPr>
          </p:pic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ADDBE7FB-977D-CD5C-3E33-F1FB619CBA70}"/>
                  </a:ext>
                </a:extLst>
              </p:cNvPr>
              <p:cNvSpPr txBox="1"/>
              <p:nvPr/>
            </p:nvSpPr>
            <p:spPr>
              <a:xfrm>
                <a:off x="928339" y="4380421"/>
                <a:ext cx="74645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2+R5020</a:t>
                </a:r>
              </a:p>
            </p:txBody>
          </p:sp>
        </p:grp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55C21886-A34D-35B6-BF33-C8F678691220}"/>
              </a:ext>
            </a:extLst>
          </p:cNvPr>
          <p:cNvSpPr txBox="1"/>
          <p:nvPr/>
        </p:nvSpPr>
        <p:spPr>
          <a:xfrm>
            <a:off x="410145" y="109622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SG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D2BED1C-8F6A-1859-7F2D-81A5F1E87058}"/>
              </a:ext>
            </a:extLst>
          </p:cNvPr>
          <p:cNvSpPr txBox="1"/>
          <p:nvPr/>
        </p:nvSpPr>
        <p:spPr>
          <a:xfrm>
            <a:off x="696229" y="6857003"/>
            <a:ext cx="5039312" cy="16312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MY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incipal Component Analysis (PCA) of RNA-seq profiles for EV, PRB, PRB-FFF, and PRB-QQQ cell lines reveals tight clustering of biological replicates (n=2) within each treatment group. This high proximity between replicates, contrasted by the clear spatial separation between different hormonal treatments, demonstrates a high signal-to-noise ratio that validates the robustness of the dataset for downstream analysi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MY" sz="1000" dirty="0">
                <a:latin typeface="Arial" panose="020B0604020202020204" pitchFamily="34" charset="0"/>
                <a:cs typeface="Arial" panose="020B0604020202020204" pitchFamily="34" charset="0"/>
              </a:rPr>
              <a:t>Top 10 genes unaffected by AF1-FFF mutation in response to R5020 (based on </a:t>
            </a:r>
            <a:r>
              <a:rPr lang="en-MY" sz="1000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MY" sz="1000" dirty="0">
                <a:latin typeface="Arial" panose="020B0604020202020204" pitchFamily="34" charset="0"/>
                <a:cs typeface="Arial" panose="020B0604020202020204" pitchFamily="34" charset="0"/>
              </a:rPr>
              <a:t>) are listed. The genes are involved in diverse molecular functions, indicating the effect of FFF mutation is gene specific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fold change values represent the ratio of R5020-treated to Vehicle-control (EtOH) within each respective cell line.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510EB381-380E-FEEC-6C83-6E58FA4784FB}"/>
              </a:ext>
            </a:extLst>
          </p:cNvPr>
          <p:cNvGrpSpPr/>
          <p:nvPr/>
        </p:nvGrpSpPr>
        <p:grpSpPr>
          <a:xfrm>
            <a:off x="1967399" y="3876367"/>
            <a:ext cx="3147998" cy="2611511"/>
            <a:chOff x="1982524" y="6430120"/>
            <a:chExt cx="3147998" cy="2611511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25BB86D-394D-7AFB-761E-42C1696FC2B0}"/>
                </a:ext>
              </a:extLst>
            </p:cNvPr>
            <p:cNvSpPr txBox="1"/>
            <p:nvPr/>
          </p:nvSpPr>
          <p:spPr>
            <a:xfrm>
              <a:off x="1982524" y="6430120"/>
              <a:ext cx="31479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OP 10 genes not affected by AF1-FFF mutation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2903473-33A7-F861-7BE8-2D0B46930F79}"/>
                </a:ext>
              </a:extLst>
            </p:cNvPr>
            <p:cNvSpPr txBox="1"/>
            <p:nvPr/>
          </p:nvSpPr>
          <p:spPr>
            <a:xfrm rot="16200000">
              <a:off x="1596157" y="7465502"/>
              <a:ext cx="11336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Log2 Fold Change</a:t>
              </a:r>
              <a:endParaRPr lang="en-SG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15D5E435-A98D-FC89-6162-776CCD095AD7}"/>
                </a:ext>
              </a:extLst>
            </p:cNvPr>
            <p:cNvGrpSpPr/>
            <p:nvPr/>
          </p:nvGrpSpPr>
          <p:grpSpPr>
            <a:xfrm>
              <a:off x="2773575" y="8824939"/>
              <a:ext cx="1334846" cy="216692"/>
              <a:chOff x="4124030" y="6382887"/>
              <a:chExt cx="1334846" cy="216692"/>
            </a:xfrm>
          </p:grpSpPr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09920168-78D1-A1CE-B493-604468612257}"/>
                  </a:ext>
                </a:extLst>
              </p:cNvPr>
              <p:cNvSpPr/>
              <p:nvPr/>
            </p:nvSpPr>
            <p:spPr>
              <a:xfrm>
                <a:off x="4730342" y="6440350"/>
                <a:ext cx="99692" cy="9969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MY" sz="1662"/>
              </a:p>
            </p:txBody>
          </p:sp>
          <p:sp>
            <p:nvSpPr>
              <p:cNvPr id="26" name="TextBox 41">
                <a:extLst>
                  <a:ext uri="{FF2B5EF4-FFF2-40B4-BE49-F238E27FC236}">
                    <a16:creationId xmlns:a16="http://schemas.microsoft.com/office/drawing/2014/main" id="{A02FC8D3-ADE8-DD8D-D214-5195A7EEBB9F}"/>
                  </a:ext>
                </a:extLst>
              </p:cNvPr>
              <p:cNvSpPr txBox="1"/>
              <p:nvPr/>
            </p:nvSpPr>
            <p:spPr>
              <a:xfrm>
                <a:off x="4786718" y="6384135"/>
                <a:ext cx="6721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−FFF</a:t>
                </a:r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68DFA238-FD03-F122-D2E0-C2CCEA3F9E93}"/>
                  </a:ext>
                </a:extLst>
              </p:cNvPr>
              <p:cNvSpPr/>
              <p:nvPr/>
            </p:nvSpPr>
            <p:spPr>
              <a:xfrm>
                <a:off x="4124030" y="6439102"/>
                <a:ext cx="99692" cy="99692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MY" sz="1662"/>
              </a:p>
            </p:txBody>
          </p:sp>
          <p:sp>
            <p:nvSpPr>
              <p:cNvPr id="28" name="TextBox 41">
                <a:extLst>
                  <a:ext uri="{FF2B5EF4-FFF2-40B4-BE49-F238E27FC236}">
                    <a16:creationId xmlns:a16="http://schemas.microsoft.com/office/drawing/2014/main" id="{8B94FB07-218F-EDF1-5E77-1FB114197114}"/>
                  </a:ext>
                </a:extLst>
              </p:cNvPr>
              <p:cNvSpPr txBox="1"/>
              <p:nvPr/>
            </p:nvSpPr>
            <p:spPr>
              <a:xfrm>
                <a:off x="4180403" y="6382887"/>
                <a:ext cx="43272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</a:t>
                </a:r>
              </a:p>
            </p:txBody>
          </p:sp>
        </p:grpSp>
        <p:graphicFrame>
          <p:nvGraphicFramePr>
            <p:cNvPr id="11" name="Chart 10">
              <a:extLst>
                <a:ext uri="{FF2B5EF4-FFF2-40B4-BE49-F238E27FC236}">
                  <a16:creationId xmlns:a16="http://schemas.microsoft.com/office/drawing/2014/main" id="{52937474-4B4F-96B2-CEA2-A11D2AAE97D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96903917"/>
                </p:ext>
              </p:extLst>
            </p:nvPr>
          </p:nvGraphicFramePr>
          <p:xfrm>
            <a:off x="2202308" y="6788926"/>
            <a:ext cx="2160000" cy="20258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0A22D4EB-F0E5-4CB7-E52E-0EC22DEA355D}"/>
              </a:ext>
            </a:extLst>
          </p:cNvPr>
          <p:cNvSpPr txBox="1"/>
          <p:nvPr/>
        </p:nvSpPr>
        <p:spPr>
          <a:xfrm>
            <a:off x="418589" y="3719097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SG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61641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C437CC-8CC6-69F8-B3BE-2E8861E6F26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TextBox 178">
            <a:extLst>
              <a:ext uri="{FF2B5EF4-FFF2-40B4-BE49-F238E27FC236}">
                <a16:creationId xmlns:a16="http://schemas.microsoft.com/office/drawing/2014/main" id="{BF940B54-544B-8857-5C28-4C7ABAFDA96A}"/>
              </a:ext>
            </a:extLst>
          </p:cNvPr>
          <p:cNvSpPr txBox="1"/>
          <p:nvPr/>
        </p:nvSpPr>
        <p:spPr>
          <a:xfrm>
            <a:off x="769760" y="506982"/>
            <a:ext cx="20555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B67A14F-47E6-976B-36EF-FBBA8948C962}"/>
              </a:ext>
            </a:extLst>
          </p:cNvPr>
          <p:cNvSpPr txBox="1"/>
          <p:nvPr/>
        </p:nvSpPr>
        <p:spPr>
          <a:xfrm>
            <a:off x="867018" y="5922236"/>
            <a:ext cx="5039312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MY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mparison of unique E2 regulated gene in PRB-FFF cells (A) and in PRB-QQQ cells (B) with that in PRB cells shows that the basal levels of expression of these genes differ between AF1 mutants and PRB cells. C: Control; E2: Estradiol. The fold-change values represent the ratio of E2-treated to Vehicle-control (EtOH) within each respective cell line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CEF3F9C-7CF9-DFF4-29CD-D8DFB5562B4A}"/>
              </a:ext>
            </a:extLst>
          </p:cNvPr>
          <p:cNvSpPr txBox="1"/>
          <p:nvPr/>
        </p:nvSpPr>
        <p:spPr>
          <a:xfrm>
            <a:off x="867018" y="1062427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SG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7DE86C9-56AD-D680-2359-54EEB29ABCC6}"/>
              </a:ext>
            </a:extLst>
          </p:cNvPr>
          <p:cNvSpPr txBox="1"/>
          <p:nvPr/>
        </p:nvSpPr>
        <p:spPr>
          <a:xfrm>
            <a:off x="867018" y="351295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SG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50351185-8A7E-5CB1-DAC2-DED51AAA0305}"/>
              </a:ext>
            </a:extLst>
          </p:cNvPr>
          <p:cNvGrpSpPr/>
          <p:nvPr/>
        </p:nvGrpSpPr>
        <p:grpSpPr>
          <a:xfrm>
            <a:off x="1695361" y="934285"/>
            <a:ext cx="3047925" cy="2289363"/>
            <a:chOff x="1267189" y="906330"/>
            <a:chExt cx="3047925" cy="2289363"/>
          </a:xfrm>
        </p:grpSpPr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43B44571-ED91-493F-1912-99006C89A81D}"/>
                </a:ext>
              </a:extLst>
            </p:cNvPr>
            <p:cNvGrpSpPr/>
            <p:nvPr/>
          </p:nvGrpSpPr>
          <p:grpSpPr>
            <a:xfrm>
              <a:off x="1267189" y="1220740"/>
              <a:ext cx="1628564" cy="1966174"/>
              <a:chOff x="1267189" y="1220740"/>
              <a:chExt cx="1628564" cy="1966174"/>
            </a:xfrm>
          </p:grpSpPr>
          <p:pic>
            <p:nvPicPr>
              <p:cNvPr id="6" name="Picture 5" descr="A screenshot of a graph&#10;&#10;AI-generated content may be incorrect.">
                <a:extLst>
                  <a:ext uri="{FF2B5EF4-FFF2-40B4-BE49-F238E27FC236}">
                    <a16:creationId xmlns:a16="http://schemas.microsoft.com/office/drawing/2014/main" id="{5E8429CD-082F-B041-5C82-F34E9E3DBA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583" t="4570" r="19685" b="10119"/>
              <a:stretch>
                <a:fillRect/>
              </a:stretch>
            </p:blipFill>
            <p:spPr>
              <a:xfrm>
                <a:off x="1267189" y="1220740"/>
                <a:ext cx="1620000" cy="1469994"/>
              </a:xfrm>
              <a:prstGeom prst="rect">
                <a:avLst/>
              </a:prstGeom>
            </p:spPr>
          </p:pic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E791A152-2CB6-3434-6F32-4AEBD277EB2D}"/>
                  </a:ext>
                </a:extLst>
              </p:cNvPr>
              <p:cNvGrpSpPr/>
              <p:nvPr/>
            </p:nvGrpSpPr>
            <p:grpSpPr>
              <a:xfrm>
                <a:off x="1339682" y="2661380"/>
                <a:ext cx="741851" cy="343393"/>
                <a:chOff x="1444260" y="4846248"/>
                <a:chExt cx="741851" cy="343393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2DD42FA5-186F-CFA0-EA9C-B2ABFFEC4866}"/>
                    </a:ext>
                  </a:extLst>
                </p:cNvPr>
                <p:cNvSpPr txBox="1"/>
                <p:nvPr/>
              </p:nvSpPr>
              <p:spPr>
                <a:xfrm>
                  <a:off x="1444260" y="4846248"/>
                  <a:ext cx="7258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MY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           E2</a:t>
                  </a:r>
                </a:p>
              </p:txBody>
            </p:sp>
            <p:cxnSp>
              <p:nvCxnSpPr>
                <p:cNvPr id="12" name="Straight Connector 11">
                  <a:extLst>
                    <a:ext uri="{FF2B5EF4-FFF2-40B4-BE49-F238E27FC236}">
                      <a16:creationId xmlns:a16="http://schemas.microsoft.com/office/drawing/2014/main" id="{5EF904F0-7E94-1C0A-0C61-F12E6E345E30}"/>
                    </a:ext>
                  </a:extLst>
                </p:cNvPr>
                <p:cNvCxnSpPr/>
                <p:nvPr/>
              </p:nvCxnSpPr>
              <p:spPr>
                <a:xfrm flipH="1">
                  <a:off x="1517291" y="5009281"/>
                  <a:ext cx="504000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E8910804-5982-D54E-E391-F413C9B644A5}"/>
                    </a:ext>
                  </a:extLst>
                </p:cNvPr>
                <p:cNvSpPr txBox="1"/>
                <p:nvPr/>
              </p:nvSpPr>
              <p:spPr>
                <a:xfrm>
                  <a:off x="1596763" y="4974197"/>
                  <a:ext cx="58934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MY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B</a:t>
                  </a:r>
                </a:p>
              </p:txBody>
            </p:sp>
          </p:grp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C267731C-EC7B-239A-7B1D-D57A259BFA5B}"/>
                  </a:ext>
                </a:extLst>
              </p:cNvPr>
              <p:cNvGrpSpPr/>
              <p:nvPr/>
            </p:nvGrpSpPr>
            <p:grpSpPr>
              <a:xfrm>
                <a:off x="2140651" y="2661755"/>
                <a:ext cx="755102" cy="339503"/>
                <a:chOff x="1705056" y="6480501"/>
                <a:chExt cx="755102" cy="339503"/>
              </a:xfrm>
            </p:grpSpPr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30C6FDFF-DDF5-A472-0F56-FAB831F23FAE}"/>
                    </a:ext>
                  </a:extLst>
                </p:cNvPr>
                <p:cNvSpPr txBox="1"/>
                <p:nvPr/>
              </p:nvSpPr>
              <p:spPr>
                <a:xfrm>
                  <a:off x="1705056" y="6480501"/>
                  <a:ext cx="75510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MY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           E2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64E6C140-8D5E-7AEE-5F5B-A53FF45902DF}"/>
                    </a:ext>
                  </a:extLst>
                </p:cNvPr>
                <p:cNvSpPr txBox="1"/>
                <p:nvPr/>
              </p:nvSpPr>
              <p:spPr>
                <a:xfrm>
                  <a:off x="1716782" y="6604560"/>
                  <a:ext cx="6880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MY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B−FFF</a:t>
                  </a:r>
                </a:p>
              </p:txBody>
            </p:sp>
            <p:cxnSp>
              <p:nvCxnSpPr>
                <p:cNvPr id="17" name="Straight Connector 16">
                  <a:extLst>
                    <a:ext uri="{FF2B5EF4-FFF2-40B4-BE49-F238E27FC236}">
                      <a16:creationId xmlns:a16="http://schemas.microsoft.com/office/drawing/2014/main" id="{F3A603E2-0492-B65F-B3A0-4295F2552F11}"/>
                    </a:ext>
                  </a:extLst>
                </p:cNvPr>
                <p:cNvCxnSpPr/>
                <p:nvPr/>
              </p:nvCxnSpPr>
              <p:spPr>
                <a:xfrm flipH="1">
                  <a:off x="1771822" y="6639259"/>
                  <a:ext cx="504000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A7682267-3379-BAA1-F60B-0AAB868097FE}"/>
                  </a:ext>
                </a:extLst>
              </p:cNvPr>
              <p:cNvGrpSpPr/>
              <p:nvPr/>
            </p:nvGrpSpPr>
            <p:grpSpPr>
              <a:xfrm>
                <a:off x="1422473" y="2947982"/>
                <a:ext cx="1262499" cy="238932"/>
                <a:chOff x="1800391" y="7725168"/>
                <a:chExt cx="1262499" cy="238932"/>
              </a:xfrm>
            </p:grpSpPr>
            <p:pic>
              <p:nvPicPr>
                <p:cNvPr id="31" name="Picture 30" descr="A group of colored squares&#10;&#10;AI-generated content may be incorrect.">
                  <a:extLst>
                    <a:ext uri="{FF2B5EF4-FFF2-40B4-BE49-F238E27FC236}">
                      <a16:creationId xmlns:a16="http://schemas.microsoft.com/office/drawing/2014/main" id="{48FFD83B-F963-931A-1454-7C451B310B4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4830" r="23122" b="50437"/>
                <a:stretch>
                  <a:fillRect/>
                </a:stretch>
              </p:blipFill>
              <p:spPr>
                <a:xfrm rot="5400000">
                  <a:off x="2293637" y="7413346"/>
                  <a:ext cx="57508" cy="1044000"/>
                </a:xfrm>
                <a:prstGeom prst="rect">
                  <a:avLst/>
                </a:prstGeom>
              </p:spPr>
            </p:pic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49FC735D-A984-23EF-9291-866F6E3E0F48}"/>
                    </a:ext>
                  </a:extLst>
                </p:cNvPr>
                <p:cNvSpPr txBox="1"/>
                <p:nvPr/>
              </p:nvSpPr>
              <p:spPr>
                <a:xfrm>
                  <a:off x="1976544" y="7725168"/>
                  <a:ext cx="10863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MY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  -1    0    1    2</a:t>
                  </a:r>
                </a:p>
              </p:txBody>
            </p:sp>
          </p:grp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AE01652E-55E3-55DD-8DDF-F75C2632DF95}"/>
                </a:ext>
              </a:extLst>
            </p:cNvPr>
            <p:cNvGrpSpPr/>
            <p:nvPr/>
          </p:nvGrpSpPr>
          <p:grpSpPr>
            <a:xfrm>
              <a:off x="3144998" y="906330"/>
              <a:ext cx="1170116" cy="2289363"/>
              <a:chOff x="3144998" y="906330"/>
              <a:chExt cx="1170116" cy="2289363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ED98BB1A-182E-690C-1020-3FA657EDB7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507" r="10753" b="5301"/>
              <a:stretch>
                <a:fillRect/>
              </a:stretch>
            </p:blipFill>
            <p:spPr>
              <a:xfrm>
                <a:off x="3335108" y="1220740"/>
                <a:ext cx="707357" cy="1469994"/>
              </a:xfrm>
              <a:prstGeom prst="rect">
                <a:avLst/>
              </a:prstGeom>
              <a:ln w="3175">
                <a:noFill/>
              </a:ln>
            </p:spPr>
          </p:pic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BF4F8D79-0BBF-11F8-3DBC-2BFC40D3DCD5}"/>
                  </a:ext>
                </a:extLst>
              </p:cNvPr>
              <p:cNvGrpSpPr/>
              <p:nvPr/>
            </p:nvGrpSpPr>
            <p:grpSpPr>
              <a:xfrm>
                <a:off x="3228768" y="2977559"/>
                <a:ext cx="1086346" cy="218134"/>
                <a:chOff x="3829269" y="2919419"/>
                <a:chExt cx="1086346" cy="218134"/>
              </a:xfrm>
            </p:grpSpPr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16C2A11C-4E57-7CED-E7A3-064EAD5F543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4777" r="3953" b="77437"/>
                <a:stretch>
                  <a:fillRect/>
                </a:stretch>
              </p:blipFill>
              <p:spPr>
                <a:xfrm rot="5400000" flipH="1">
                  <a:off x="4271417" y="2712095"/>
                  <a:ext cx="45719" cy="805197"/>
                </a:xfrm>
                <a:prstGeom prst="rect">
                  <a:avLst/>
                </a:prstGeom>
              </p:spPr>
            </p:pic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78C9B0CA-1945-FC75-6922-E5124DF3AC6B}"/>
                    </a:ext>
                  </a:extLst>
                </p:cNvPr>
                <p:cNvSpPr txBox="1"/>
                <p:nvPr/>
              </p:nvSpPr>
              <p:spPr>
                <a:xfrm>
                  <a:off x="3829269" y="2919419"/>
                  <a:ext cx="10863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MY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6 -4 -2 0  2  4  6</a:t>
                  </a:r>
                </a:p>
              </p:txBody>
            </p:sp>
          </p:grp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8B313FFF-B8F3-9863-94FF-B24D69EE0433}"/>
                  </a:ext>
                </a:extLst>
              </p:cNvPr>
              <p:cNvSpPr txBox="1"/>
              <p:nvPr/>
            </p:nvSpPr>
            <p:spPr>
              <a:xfrm>
                <a:off x="3144998" y="906330"/>
                <a:ext cx="113449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og2 Fold Change</a:t>
                </a:r>
              </a:p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2 vs ETOH</a:t>
                </a:r>
                <a:endParaRPr lang="en-SG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A8CA0A5-9075-F0FB-9F30-DC70F532FA89}"/>
                  </a:ext>
                </a:extLst>
              </p:cNvPr>
              <p:cNvSpPr txBox="1"/>
              <p:nvPr/>
            </p:nvSpPr>
            <p:spPr>
              <a:xfrm>
                <a:off x="3206828" y="2664511"/>
                <a:ext cx="5893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7D9E932E-470E-2C62-0943-3D9AD0769F79}"/>
                  </a:ext>
                </a:extLst>
              </p:cNvPr>
              <p:cNvSpPr txBox="1"/>
              <p:nvPr/>
            </p:nvSpPr>
            <p:spPr>
              <a:xfrm>
                <a:off x="3555414" y="2667940"/>
                <a:ext cx="6880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−FFF</a:t>
                </a:r>
              </a:p>
            </p:txBody>
          </p:sp>
        </p:grp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B36E07BF-259D-F15C-64B2-130303EF7EFD}"/>
              </a:ext>
            </a:extLst>
          </p:cNvPr>
          <p:cNvGrpSpPr/>
          <p:nvPr/>
        </p:nvGrpSpPr>
        <p:grpSpPr>
          <a:xfrm>
            <a:off x="1695361" y="3426373"/>
            <a:ext cx="3048142" cy="2270891"/>
            <a:chOff x="1265049" y="3259742"/>
            <a:chExt cx="3048142" cy="2270891"/>
          </a:xfrm>
        </p:grpSpPr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3666C1E8-FCDC-34DB-136C-5C53344CEBC1}"/>
                </a:ext>
              </a:extLst>
            </p:cNvPr>
            <p:cNvGrpSpPr/>
            <p:nvPr/>
          </p:nvGrpSpPr>
          <p:grpSpPr>
            <a:xfrm>
              <a:off x="1265049" y="3550008"/>
              <a:ext cx="1720482" cy="1963619"/>
              <a:chOff x="1265049" y="3550008"/>
              <a:chExt cx="1720482" cy="1963619"/>
            </a:xfrm>
          </p:grpSpPr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936E61D4-52C4-CE1B-478E-E3683327B932}"/>
                  </a:ext>
                </a:extLst>
              </p:cNvPr>
              <p:cNvGrpSpPr/>
              <p:nvPr/>
            </p:nvGrpSpPr>
            <p:grpSpPr>
              <a:xfrm>
                <a:off x="1265049" y="3550008"/>
                <a:ext cx="1720482" cy="1780641"/>
                <a:chOff x="1161771" y="3515371"/>
                <a:chExt cx="1720482" cy="1780641"/>
              </a:xfrm>
            </p:grpSpPr>
            <p:pic>
              <p:nvPicPr>
                <p:cNvPr id="4" name="Picture 3" descr="A screenshot of a graph&#10;&#10;AI-generated content may be incorrect.">
                  <a:extLst>
                    <a:ext uri="{FF2B5EF4-FFF2-40B4-BE49-F238E27FC236}">
                      <a16:creationId xmlns:a16="http://schemas.microsoft.com/office/drawing/2014/main" id="{EA9CC3D3-B5E2-532E-BE32-82A44E177C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845" t="4307" r="19423" b="11026"/>
                <a:stretch>
                  <a:fillRect/>
                </a:stretch>
              </p:blipFill>
              <p:spPr>
                <a:xfrm>
                  <a:off x="1161771" y="3515371"/>
                  <a:ext cx="1620000" cy="1474565"/>
                </a:xfrm>
                <a:prstGeom prst="rect">
                  <a:avLst/>
                </a:prstGeom>
              </p:spPr>
            </p:pic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0D85D116-5A1D-D36B-9693-A1E929913841}"/>
                    </a:ext>
                  </a:extLst>
                </p:cNvPr>
                <p:cNvGrpSpPr/>
                <p:nvPr/>
              </p:nvGrpSpPr>
              <p:grpSpPr>
                <a:xfrm>
                  <a:off x="1236080" y="4952619"/>
                  <a:ext cx="779951" cy="343393"/>
                  <a:chOff x="1406160" y="4846248"/>
                  <a:chExt cx="779951" cy="343393"/>
                </a:xfrm>
              </p:grpSpPr>
              <p:sp>
                <p:nvSpPr>
                  <p:cNvPr id="23" name="TextBox 22">
                    <a:extLst>
                      <a:ext uri="{FF2B5EF4-FFF2-40B4-BE49-F238E27FC236}">
                        <a16:creationId xmlns:a16="http://schemas.microsoft.com/office/drawing/2014/main" id="{7779ADAC-2343-6B15-00CE-AFB74340D7DC}"/>
                      </a:ext>
                    </a:extLst>
                  </p:cNvPr>
                  <p:cNvSpPr txBox="1"/>
                  <p:nvPr/>
                </p:nvSpPr>
                <p:spPr>
                  <a:xfrm>
                    <a:off x="1406160" y="4846248"/>
                    <a:ext cx="72584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MY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           E2</a:t>
                    </a:r>
                  </a:p>
                </p:txBody>
              </p:sp>
              <p:cxnSp>
                <p:nvCxnSpPr>
                  <p:cNvPr id="24" name="Straight Connector 23">
                    <a:extLst>
                      <a:ext uri="{FF2B5EF4-FFF2-40B4-BE49-F238E27FC236}">
                        <a16:creationId xmlns:a16="http://schemas.microsoft.com/office/drawing/2014/main" id="{8F3E29BC-247F-E992-7D64-640F96F06DB4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1517291" y="5009281"/>
                    <a:ext cx="5040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5" name="TextBox 24">
                    <a:extLst>
                      <a:ext uri="{FF2B5EF4-FFF2-40B4-BE49-F238E27FC236}">
                        <a16:creationId xmlns:a16="http://schemas.microsoft.com/office/drawing/2014/main" id="{96BF3E93-CCA7-FC2D-5975-B9A5587557E0}"/>
                      </a:ext>
                    </a:extLst>
                  </p:cNvPr>
                  <p:cNvSpPr txBox="1"/>
                  <p:nvPr/>
                </p:nvSpPr>
                <p:spPr>
                  <a:xfrm>
                    <a:off x="1596763" y="4974197"/>
                    <a:ext cx="58934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MY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B</a:t>
                    </a:r>
                  </a:p>
                </p:txBody>
              </p:sp>
            </p:grpSp>
            <p:grpSp>
              <p:nvGrpSpPr>
                <p:cNvPr id="26" name="Group 25">
                  <a:extLst>
                    <a:ext uri="{FF2B5EF4-FFF2-40B4-BE49-F238E27FC236}">
                      <a16:creationId xmlns:a16="http://schemas.microsoft.com/office/drawing/2014/main" id="{612B852B-B6EE-31CA-DED3-6CEB4A89EE6D}"/>
                    </a:ext>
                  </a:extLst>
                </p:cNvPr>
                <p:cNvGrpSpPr/>
                <p:nvPr/>
              </p:nvGrpSpPr>
              <p:grpSpPr>
                <a:xfrm>
                  <a:off x="2037049" y="4952994"/>
                  <a:ext cx="845204" cy="339503"/>
                  <a:chOff x="1666956" y="6480501"/>
                  <a:chExt cx="845204" cy="339503"/>
                </a:xfrm>
              </p:grpSpPr>
              <p:sp>
                <p:nvSpPr>
                  <p:cNvPr id="27" name="TextBox 26">
                    <a:extLst>
                      <a:ext uri="{FF2B5EF4-FFF2-40B4-BE49-F238E27FC236}">
                        <a16:creationId xmlns:a16="http://schemas.microsoft.com/office/drawing/2014/main" id="{AC76926C-D01E-08C0-25D9-D25C2EAD5A22}"/>
                      </a:ext>
                    </a:extLst>
                  </p:cNvPr>
                  <p:cNvSpPr txBox="1"/>
                  <p:nvPr/>
                </p:nvSpPr>
                <p:spPr>
                  <a:xfrm>
                    <a:off x="1666956" y="6480501"/>
                    <a:ext cx="75510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MY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           E2</a:t>
                    </a:r>
                  </a:p>
                </p:txBody>
              </p:sp>
              <p:sp>
                <p:nvSpPr>
                  <p:cNvPr id="28" name="TextBox 27">
                    <a:extLst>
                      <a:ext uri="{FF2B5EF4-FFF2-40B4-BE49-F238E27FC236}">
                        <a16:creationId xmlns:a16="http://schemas.microsoft.com/office/drawing/2014/main" id="{15095BDB-4E97-CF6A-FE3F-2A0AC9F01A42}"/>
                      </a:ext>
                    </a:extLst>
                  </p:cNvPr>
                  <p:cNvSpPr txBox="1"/>
                  <p:nvPr/>
                </p:nvSpPr>
                <p:spPr>
                  <a:xfrm>
                    <a:off x="1716782" y="6604560"/>
                    <a:ext cx="79537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MY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B−QQQ</a:t>
                    </a:r>
                  </a:p>
                </p:txBody>
              </p:sp>
              <p:cxnSp>
                <p:nvCxnSpPr>
                  <p:cNvPr id="29" name="Straight Connector 28">
                    <a:extLst>
                      <a:ext uri="{FF2B5EF4-FFF2-40B4-BE49-F238E27FC236}">
                        <a16:creationId xmlns:a16="http://schemas.microsoft.com/office/drawing/2014/main" id="{EF296CEC-45AD-53EB-0632-4C64AC602DD9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1771822" y="6639259"/>
                    <a:ext cx="504000" cy="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AF39F18E-19DB-24A9-3068-0E42BE89CD68}"/>
                  </a:ext>
                </a:extLst>
              </p:cNvPr>
              <p:cNvGrpSpPr/>
              <p:nvPr/>
            </p:nvGrpSpPr>
            <p:grpSpPr>
              <a:xfrm>
                <a:off x="1422590" y="5274695"/>
                <a:ext cx="1262499" cy="238932"/>
                <a:chOff x="1800391" y="7725168"/>
                <a:chExt cx="1262499" cy="238932"/>
              </a:xfrm>
            </p:grpSpPr>
            <p:pic>
              <p:nvPicPr>
                <p:cNvPr id="42" name="Picture 41" descr="A group of colored squares&#10;&#10;AI-generated content may be incorrect.">
                  <a:extLst>
                    <a:ext uri="{FF2B5EF4-FFF2-40B4-BE49-F238E27FC236}">
                      <a16:creationId xmlns:a16="http://schemas.microsoft.com/office/drawing/2014/main" id="{897D6979-A1AA-F8D0-F175-845C12ED85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4830" r="23122" b="50437"/>
                <a:stretch>
                  <a:fillRect/>
                </a:stretch>
              </p:blipFill>
              <p:spPr>
                <a:xfrm rot="5400000">
                  <a:off x="2293637" y="7413346"/>
                  <a:ext cx="57508" cy="1044000"/>
                </a:xfrm>
                <a:prstGeom prst="rect">
                  <a:avLst/>
                </a:prstGeom>
              </p:spPr>
            </p:pic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0CC5BD1B-30D5-CDE7-F787-7B0817D9BB5D}"/>
                    </a:ext>
                  </a:extLst>
                </p:cNvPr>
                <p:cNvSpPr txBox="1"/>
                <p:nvPr/>
              </p:nvSpPr>
              <p:spPr>
                <a:xfrm>
                  <a:off x="1976544" y="7725168"/>
                  <a:ext cx="10863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MY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2  -1    0    1    2</a:t>
                  </a:r>
                </a:p>
              </p:txBody>
            </p:sp>
          </p:grpSp>
        </p:grp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76428CE6-D585-DF0C-88C2-510FFAE050C7}"/>
                </a:ext>
              </a:extLst>
            </p:cNvPr>
            <p:cNvGrpSpPr/>
            <p:nvPr/>
          </p:nvGrpSpPr>
          <p:grpSpPr>
            <a:xfrm>
              <a:off x="3184012" y="3259742"/>
              <a:ext cx="1129179" cy="2270891"/>
              <a:chOff x="3184012" y="3259742"/>
              <a:chExt cx="1129179" cy="2270891"/>
            </a:xfrm>
          </p:grpSpPr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26A49649-98CD-A511-F21E-1DBD0FFE583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733" t="-587" r="10441" b="10181"/>
              <a:stretch>
                <a:fillRect/>
              </a:stretch>
            </p:blipFill>
            <p:spPr>
              <a:xfrm>
                <a:off x="3333265" y="3550008"/>
                <a:ext cx="709200" cy="1474565"/>
              </a:xfrm>
              <a:prstGeom prst="rect">
                <a:avLst/>
              </a:prstGeom>
            </p:spPr>
          </p:pic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D22EEA11-3ADA-6213-1C76-5D701B74C161}"/>
                  </a:ext>
                </a:extLst>
              </p:cNvPr>
              <p:cNvSpPr txBox="1"/>
              <p:nvPr/>
            </p:nvSpPr>
            <p:spPr>
              <a:xfrm>
                <a:off x="3184012" y="3259742"/>
                <a:ext cx="108612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og2 Fold Change</a:t>
                </a:r>
              </a:p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2 vs ETOH</a:t>
                </a:r>
                <a:endParaRPr lang="en-SG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6" name="Group 45">
                <a:extLst>
                  <a:ext uri="{FF2B5EF4-FFF2-40B4-BE49-F238E27FC236}">
                    <a16:creationId xmlns:a16="http://schemas.microsoft.com/office/drawing/2014/main" id="{EB3E84F5-50E1-ADBC-ABF6-899001FCA004}"/>
                  </a:ext>
                </a:extLst>
              </p:cNvPr>
              <p:cNvGrpSpPr/>
              <p:nvPr/>
            </p:nvGrpSpPr>
            <p:grpSpPr>
              <a:xfrm>
                <a:off x="3226845" y="5312499"/>
                <a:ext cx="1086346" cy="218134"/>
                <a:chOff x="3829269" y="2919419"/>
                <a:chExt cx="1086346" cy="218134"/>
              </a:xfrm>
            </p:grpSpPr>
            <p:pic>
              <p:nvPicPr>
                <p:cNvPr id="47" name="Picture 46">
                  <a:extLst>
                    <a:ext uri="{FF2B5EF4-FFF2-40B4-BE49-F238E27FC236}">
                      <a16:creationId xmlns:a16="http://schemas.microsoft.com/office/drawing/2014/main" id="{35E39503-E7E2-2B71-646C-5E7A354AB4F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4777" r="3953" b="77437"/>
                <a:stretch>
                  <a:fillRect/>
                </a:stretch>
              </p:blipFill>
              <p:spPr>
                <a:xfrm rot="5400000" flipH="1">
                  <a:off x="4271417" y="2712095"/>
                  <a:ext cx="45719" cy="805197"/>
                </a:xfrm>
                <a:prstGeom prst="rect">
                  <a:avLst/>
                </a:prstGeom>
              </p:spPr>
            </p:pic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C12D652A-FD04-C6BF-3A26-66903A516160}"/>
                    </a:ext>
                  </a:extLst>
                </p:cNvPr>
                <p:cNvSpPr txBox="1"/>
                <p:nvPr/>
              </p:nvSpPr>
              <p:spPr>
                <a:xfrm>
                  <a:off x="3829269" y="2919419"/>
                  <a:ext cx="10863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MY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6 -4 -2 0  2  4  6</a:t>
                  </a:r>
                </a:p>
              </p:txBody>
            </p:sp>
          </p:grp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EF83A35A-B932-21FC-FD7B-FD37B681E265}"/>
                  </a:ext>
                </a:extLst>
              </p:cNvPr>
              <p:cNvSpPr txBox="1"/>
              <p:nvPr/>
            </p:nvSpPr>
            <p:spPr>
              <a:xfrm>
                <a:off x="3219324" y="5014107"/>
                <a:ext cx="5893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B65EE796-76ED-B5D0-EC1E-B466504080E8}"/>
                  </a:ext>
                </a:extLst>
              </p:cNvPr>
              <p:cNvSpPr txBox="1"/>
              <p:nvPr/>
            </p:nvSpPr>
            <p:spPr>
              <a:xfrm>
                <a:off x="3560940" y="5014584"/>
                <a:ext cx="7092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−QQQ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451611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A59FE60-009E-245E-07AA-9A72EAD7D2E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extBox 116">
            <a:extLst>
              <a:ext uri="{FF2B5EF4-FFF2-40B4-BE49-F238E27FC236}">
                <a16:creationId xmlns:a16="http://schemas.microsoft.com/office/drawing/2014/main" id="{750F051B-BB24-EC06-7AC4-FE0BB848FDE1}"/>
              </a:ext>
            </a:extLst>
          </p:cNvPr>
          <p:cNvSpPr txBox="1"/>
          <p:nvPr/>
        </p:nvSpPr>
        <p:spPr>
          <a:xfrm>
            <a:off x="823242" y="584488"/>
            <a:ext cx="2094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3422910-9E5D-C42E-CB31-A74AF68A02CA}"/>
              </a:ext>
            </a:extLst>
          </p:cNvPr>
          <p:cNvSpPr txBox="1"/>
          <p:nvPr/>
        </p:nvSpPr>
        <p:spPr>
          <a:xfrm>
            <a:off x="733256" y="260369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SG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7E2374AD-FEA9-80E5-C54E-B46FCB43A827}"/>
              </a:ext>
            </a:extLst>
          </p:cNvPr>
          <p:cNvGrpSpPr/>
          <p:nvPr/>
        </p:nvGrpSpPr>
        <p:grpSpPr>
          <a:xfrm>
            <a:off x="869736" y="2828198"/>
            <a:ext cx="1310117" cy="1132030"/>
            <a:chOff x="3508857" y="1956939"/>
            <a:chExt cx="1310117" cy="1132030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42ED882-4F56-90A7-8122-C5CC8FFF4500}"/>
                </a:ext>
              </a:extLst>
            </p:cNvPr>
            <p:cNvSpPr txBox="1"/>
            <p:nvPr/>
          </p:nvSpPr>
          <p:spPr>
            <a:xfrm>
              <a:off x="3593008" y="2396009"/>
              <a:ext cx="5232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600" dirty="0">
                  <a:latin typeface="Arial" panose="020B0604020202020204" pitchFamily="34" charset="0"/>
                  <a:cs typeface="Arial" panose="020B0604020202020204" pitchFamily="34" charset="0"/>
                </a:rPr>
                <a:t>67,420 kb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5055C52-F4ED-5C31-4BD0-93E7ED10B5B3}"/>
                </a:ext>
              </a:extLst>
            </p:cNvPr>
            <p:cNvSpPr txBox="1"/>
            <p:nvPr/>
          </p:nvSpPr>
          <p:spPr>
            <a:xfrm>
              <a:off x="4295734" y="2396009"/>
              <a:ext cx="5232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600" dirty="0">
                  <a:latin typeface="Arial" panose="020B0604020202020204" pitchFamily="34" charset="0"/>
                  <a:cs typeface="Arial" panose="020B0604020202020204" pitchFamily="34" charset="0"/>
                </a:rPr>
                <a:t>67,430 kb</a:t>
              </a:r>
            </a:p>
          </p:txBody>
        </p:sp>
        <p:pic>
          <p:nvPicPr>
            <p:cNvPr id="19" name="Picture 18" descr="A screenshot of a computer&#10;&#10;AI-generated content may be incorrect.">
              <a:extLst>
                <a:ext uri="{FF2B5EF4-FFF2-40B4-BE49-F238E27FC236}">
                  <a16:creationId xmlns:a16="http://schemas.microsoft.com/office/drawing/2014/main" id="{0362E0E0-3410-76E1-5302-D6056073C1E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455" t="14799" r="16222" b="62457"/>
            <a:stretch>
              <a:fillRect/>
            </a:stretch>
          </p:blipFill>
          <p:spPr>
            <a:xfrm>
              <a:off x="3593008" y="2528886"/>
              <a:ext cx="1188000" cy="560083"/>
            </a:xfrm>
            <a:prstGeom prst="rect">
              <a:avLst/>
            </a:prstGeom>
          </p:spPr>
        </p:pic>
        <p:pic>
          <p:nvPicPr>
            <p:cNvPr id="20" name="Picture 19" descr="A screenshot of a computer&#10;&#10;AI-generated content may be incorrect.">
              <a:extLst>
                <a:ext uri="{FF2B5EF4-FFF2-40B4-BE49-F238E27FC236}">
                  <a16:creationId xmlns:a16="http://schemas.microsoft.com/office/drawing/2014/main" id="{5EAA35DD-7D19-BEFA-95CD-5DA97A38D94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455" t="834" r="16222" b="96242"/>
            <a:stretch>
              <a:fillRect/>
            </a:stretch>
          </p:blipFill>
          <p:spPr>
            <a:xfrm>
              <a:off x="3593008" y="2192230"/>
              <a:ext cx="1188000" cy="72001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32EC18D9-4D3B-B35B-B913-A186B5BEFBF0}"/>
                </a:ext>
              </a:extLst>
            </p:cNvPr>
            <p:cNvSpPr txBox="1"/>
            <p:nvPr/>
          </p:nvSpPr>
          <p:spPr>
            <a:xfrm>
              <a:off x="3784104" y="2215165"/>
              <a:ext cx="29441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500" dirty="0">
                  <a:latin typeface="Arial" panose="020B0604020202020204" pitchFamily="34" charset="0"/>
                  <a:cs typeface="Arial" panose="020B0604020202020204" pitchFamily="34" charset="0"/>
                </a:rPr>
                <a:t>q21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D5F69ED7-81AC-C813-8EAC-1133E0BDE075}"/>
                </a:ext>
              </a:extLst>
            </p:cNvPr>
            <p:cNvSpPr/>
            <p:nvPr/>
          </p:nvSpPr>
          <p:spPr>
            <a:xfrm>
              <a:off x="4285092" y="2230535"/>
              <a:ext cx="10800" cy="2880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MY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EDF2CC0-752B-CD7B-8CB3-BFF194C3B6A4}"/>
                </a:ext>
              </a:extLst>
            </p:cNvPr>
            <p:cNvSpPr txBox="1"/>
            <p:nvPr/>
          </p:nvSpPr>
          <p:spPr>
            <a:xfrm>
              <a:off x="4212850" y="2215165"/>
              <a:ext cx="3708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500" dirty="0">
                  <a:latin typeface="Arial" panose="020B0604020202020204" pitchFamily="34" charset="0"/>
                  <a:cs typeface="Arial" panose="020B0604020202020204" pitchFamily="34" charset="0"/>
                </a:rPr>
                <a:t>q22.1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3484DD5A-E4A1-A8B5-FA60-5D961E27EACF}"/>
                </a:ext>
              </a:extLst>
            </p:cNvPr>
            <p:cNvSpPr txBox="1"/>
            <p:nvPr/>
          </p:nvSpPr>
          <p:spPr>
            <a:xfrm>
              <a:off x="4419546" y="2217035"/>
              <a:ext cx="3708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500" dirty="0">
                  <a:latin typeface="Arial" panose="020B0604020202020204" pitchFamily="34" charset="0"/>
                  <a:cs typeface="Arial" panose="020B0604020202020204" pitchFamily="34" charset="0"/>
                </a:rPr>
                <a:t>q22.2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2549D28-4D0D-BD8F-F9AA-0BB24CCD8D03}"/>
                </a:ext>
              </a:extLst>
            </p:cNvPr>
            <p:cNvSpPr txBox="1"/>
            <p:nvPr/>
          </p:nvSpPr>
          <p:spPr>
            <a:xfrm>
              <a:off x="3508857" y="1956939"/>
              <a:ext cx="98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SD11B2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A36A0913-075A-6E4C-D32C-190400126DD6}"/>
              </a:ext>
            </a:extLst>
          </p:cNvPr>
          <p:cNvGrpSpPr/>
          <p:nvPr/>
        </p:nvGrpSpPr>
        <p:grpSpPr>
          <a:xfrm>
            <a:off x="2170911" y="2828970"/>
            <a:ext cx="1385227" cy="1145004"/>
            <a:chOff x="4235093" y="1832658"/>
            <a:chExt cx="1385227" cy="1145004"/>
          </a:xfrm>
        </p:grpSpPr>
        <p:pic>
          <p:nvPicPr>
            <p:cNvPr id="55" name="Picture 54" descr="A screenshot of a computer&#10;&#10;AI-generated content may be incorrect.">
              <a:extLst>
                <a:ext uri="{FF2B5EF4-FFF2-40B4-BE49-F238E27FC236}">
                  <a16:creationId xmlns:a16="http://schemas.microsoft.com/office/drawing/2014/main" id="{E7A597FD-B8A8-A373-C7B4-3E07AF0F7EE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18" t="14844" r="68760" b="61978"/>
            <a:stretch>
              <a:fillRect/>
            </a:stretch>
          </p:blipFill>
          <p:spPr>
            <a:xfrm>
              <a:off x="4323909" y="2401940"/>
              <a:ext cx="1188000" cy="575722"/>
            </a:xfrm>
            <a:prstGeom prst="rect">
              <a:avLst/>
            </a:prstGeom>
          </p:spPr>
        </p:pic>
        <p:pic>
          <p:nvPicPr>
            <p:cNvPr id="56" name="Picture 55" descr="A screenshot of a computer&#10;&#10;AI-generated content may be incorrect.">
              <a:extLst>
                <a:ext uri="{FF2B5EF4-FFF2-40B4-BE49-F238E27FC236}">
                  <a16:creationId xmlns:a16="http://schemas.microsoft.com/office/drawing/2014/main" id="{A3173650-F5C7-579E-B8A9-0B1CBC56F79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18" t="2109" r="68760" b="96050"/>
            <a:stretch>
              <a:fillRect/>
            </a:stretch>
          </p:blipFill>
          <p:spPr>
            <a:xfrm>
              <a:off x="4323909" y="2097302"/>
              <a:ext cx="1188000" cy="45719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76C341B8-3F8C-94E4-62F7-A0F9628BBE51}"/>
                </a:ext>
              </a:extLst>
            </p:cNvPr>
            <p:cNvSpPr txBox="1"/>
            <p:nvPr/>
          </p:nvSpPr>
          <p:spPr>
            <a:xfrm>
              <a:off x="4451217" y="2091482"/>
              <a:ext cx="29441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500" dirty="0">
                  <a:latin typeface="Arial" panose="020B0604020202020204" pitchFamily="34" charset="0"/>
                  <a:cs typeface="Arial" panose="020B0604020202020204" pitchFamily="34" charset="0"/>
                </a:rPr>
                <a:t>p14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0729DC7-EF15-148C-2B1A-7129C65AEA4F}"/>
                </a:ext>
              </a:extLst>
            </p:cNvPr>
            <p:cNvSpPr txBox="1"/>
            <p:nvPr/>
          </p:nvSpPr>
          <p:spPr>
            <a:xfrm>
              <a:off x="4687147" y="2088219"/>
              <a:ext cx="29441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500" dirty="0">
                  <a:latin typeface="Arial" panose="020B0604020202020204" pitchFamily="34" charset="0"/>
                  <a:cs typeface="Arial" panose="020B0604020202020204" pitchFamily="34" charset="0"/>
                </a:rPr>
                <a:t>p13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66A751E-7E36-AF95-8711-568CF80F94B8}"/>
                </a:ext>
              </a:extLst>
            </p:cNvPr>
            <p:cNvSpPr txBox="1"/>
            <p:nvPr/>
          </p:nvSpPr>
          <p:spPr>
            <a:xfrm>
              <a:off x="4834355" y="2091482"/>
              <a:ext cx="38555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500" dirty="0">
                  <a:latin typeface="Arial" panose="020B0604020202020204" pitchFamily="34" charset="0"/>
                  <a:cs typeface="Arial" panose="020B0604020202020204" pitchFamily="34" charset="0"/>
                </a:rPr>
                <a:t>p12.32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DB493D30-11BD-2D9E-C1D1-565E58C62A4F}"/>
                </a:ext>
              </a:extLst>
            </p:cNvPr>
            <p:cNvSpPr txBox="1"/>
            <p:nvPr/>
          </p:nvSpPr>
          <p:spPr>
            <a:xfrm>
              <a:off x="5045609" y="2089138"/>
              <a:ext cx="34376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500" dirty="0">
                  <a:latin typeface="Arial" panose="020B0604020202020204" pitchFamily="34" charset="0"/>
                  <a:cs typeface="Arial" panose="020B0604020202020204" pitchFamily="34" charset="0"/>
                </a:rPr>
                <a:t>p12.2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4B6D9EC-973B-5C80-1034-136C8974FF7E}"/>
                </a:ext>
              </a:extLst>
            </p:cNvPr>
            <p:cNvSpPr txBox="1"/>
            <p:nvPr/>
          </p:nvSpPr>
          <p:spPr>
            <a:xfrm>
              <a:off x="5139139" y="2255240"/>
              <a:ext cx="48118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600" dirty="0">
                  <a:latin typeface="Arial" panose="020B0604020202020204" pitchFamily="34" charset="0"/>
                  <a:cs typeface="Arial" panose="020B0604020202020204" pitchFamily="34" charset="0"/>
                </a:rPr>
                <a:t>5,450 kb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652CE6A-0684-5464-E793-5B083BBBFD4B}"/>
                </a:ext>
              </a:extLst>
            </p:cNvPr>
            <p:cNvSpPr txBox="1"/>
            <p:nvPr/>
          </p:nvSpPr>
          <p:spPr>
            <a:xfrm>
              <a:off x="4285962" y="2269063"/>
              <a:ext cx="48118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600" dirty="0">
                  <a:latin typeface="Arial" panose="020B0604020202020204" pitchFamily="34" charset="0"/>
                  <a:cs typeface="Arial" panose="020B0604020202020204" pitchFamily="34" charset="0"/>
                </a:rPr>
                <a:t>5,440 kb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0E77455-0C33-CB32-0F6A-423BA1FE6DEE}"/>
                </a:ext>
              </a:extLst>
            </p:cNvPr>
            <p:cNvSpPr txBox="1"/>
            <p:nvPr/>
          </p:nvSpPr>
          <p:spPr>
            <a:xfrm>
              <a:off x="4235093" y="1832658"/>
              <a:ext cx="98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ET1</a:t>
              </a:r>
            </a:p>
          </p:txBody>
        </p: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4D683B2F-E49D-6B1D-6A71-D5D8B054EC39}"/>
              </a:ext>
            </a:extLst>
          </p:cNvPr>
          <p:cNvGrpSpPr/>
          <p:nvPr/>
        </p:nvGrpSpPr>
        <p:grpSpPr>
          <a:xfrm>
            <a:off x="3470878" y="2831938"/>
            <a:ext cx="1388262" cy="1151738"/>
            <a:chOff x="2830081" y="2863663"/>
            <a:chExt cx="1388262" cy="1151738"/>
          </a:xfrm>
        </p:grpSpPr>
        <p:pic>
          <p:nvPicPr>
            <p:cNvPr id="65" name="Picture 64" descr="A screenshot of a computer&#10;&#10;AI-generated content may be incorrect.">
              <a:extLst>
                <a:ext uri="{FF2B5EF4-FFF2-40B4-BE49-F238E27FC236}">
                  <a16:creationId xmlns:a16="http://schemas.microsoft.com/office/drawing/2014/main" id="{1B8D7344-4453-7C95-4902-6A3E7DD3748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583" t="15017" r="35094" b="61834"/>
            <a:stretch>
              <a:fillRect/>
            </a:stretch>
          </p:blipFill>
          <p:spPr>
            <a:xfrm>
              <a:off x="2919387" y="3435610"/>
              <a:ext cx="1188000" cy="579791"/>
            </a:xfrm>
            <a:prstGeom prst="rect">
              <a:avLst/>
            </a:prstGeom>
          </p:spPr>
        </p:pic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678350CC-1769-6DDA-C7E2-7FDA6F492B8B}"/>
                </a:ext>
              </a:extLst>
            </p:cNvPr>
            <p:cNvSpPr txBox="1"/>
            <p:nvPr/>
          </p:nvSpPr>
          <p:spPr>
            <a:xfrm>
              <a:off x="2935554" y="3306344"/>
              <a:ext cx="5232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600" dirty="0">
                  <a:latin typeface="Arial" panose="020B0604020202020204" pitchFamily="34" charset="0"/>
                  <a:cs typeface="Arial" panose="020B0604020202020204" pitchFamily="34" charset="0"/>
                </a:rPr>
                <a:t>42,290 kb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9EF4B4A-5303-9DCE-EF07-635FCFF692E2}"/>
                </a:ext>
              </a:extLst>
            </p:cNvPr>
            <p:cNvSpPr txBox="1"/>
            <p:nvPr/>
          </p:nvSpPr>
          <p:spPr>
            <a:xfrm>
              <a:off x="3695103" y="3306344"/>
              <a:ext cx="5232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600" dirty="0">
                  <a:latin typeface="Arial" panose="020B0604020202020204" pitchFamily="34" charset="0"/>
                  <a:cs typeface="Arial" panose="020B0604020202020204" pitchFamily="34" charset="0"/>
                </a:rPr>
                <a:t>42,300 kb</a:t>
              </a:r>
            </a:p>
          </p:txBody>
        </p:sp>
        <p:pic>
          <p:nvPicPr>
            <p:cNvPr id="68" name="Picture 67" descr="A screenshot of a computer&#10;&#10;AI-generated content may be incorrect.">
              <a:extLst>
                <a:ext uri="{FF2B5EF4-FFF2-40B4-BE49-F238E27FC236}">
                  <a16:creationId xmlns:a16="http://schemas.microsoft.com/office/drawing/2014/main" id="{671F3A71-0BD5-1E88-7E92-0C0878D7C13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583" t="1601" r="35094" b="96261"/>
            <a:stretch>
              <a:fillRect/>
            </a:stretch>
          </p:blipFill>
          <p:spPr>
            <a:xfrm>
              <a:off x="2915567" y="3114548"/>
              <a:ext cx="1188000" cy="58470"/>
            </a:xfrm>
            <a:prstGeom prst="rect">
              <a:avLst/>
            </a:prstGeom>
          </p:spPr>
        </p:pic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F310D02E-4F47-68ED-21E0-6AD9AA362253}"/>
                </a:ext>
              </a:extLst>
            </p:cNvPr>
            <p:cNvSpPr txBox="1"/>
            <p:nvPr/>
          </p:nvSpPr>
          <p:spPr>
            <a:xfrm>
              <a:off x="2959621" y="3121889"/>
              <a:ext cx="2950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500" dirty="0">
                  <a:latin typeface="Arial" panose="020B0604020202020204" pitchFamily="34" charset="0"/>
                  <a:cs typeface="Arial" panose="020B0604020202020204" pitchFamily="34" charset="0"/>
                </a:rPr>
                <a:t>q12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9EF29F52-31B2-D790-1B21-A513CF0309E5}"/>
                </a:ext>
              </a:extLst>
            </p:cNvPr>
            <p:cNvSpPr txBox="1"/>
            <p:nvPr/>
          </p:nvSpPr>
          <p:spPr>
            <a:xfrm>
              <a:off x="3155297" y="3121889"/>
              <a:ext cx="36590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500" dirty="0">
                  <a:latin typeface="Arial" panose="020B0604020202020204" pitchFamily="34" charset="0"/>
                  <a:cs typeface="Arial" panose="020B0604020202020204" pitchFamily="34" charset="0"/>
                </a:rPr>
                <a:t>q21.1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2E46CED7-BF18-4A55-4BFE-DF4FB2E2759B}"/>
                </a:ext>
              </a:extLst>
            </p:cNvPr>
            <p:cNvSpPr txBox="1"/>
            <p:nvPr/>
          </p:nvSpPr>
          <p:spPr>
            <a:xfrm>
              <a:off x="3485813" y="3121888"/>
              <a:ext cx="41857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500" dirty="0">
                  <a:latin typeface="Arial" panose="020B0604020202020204" pitchFamily="34" charset="0"/>
                  <a:cs typeface="Arial" panose="020B0604020202020204" pitchFamily="34" charset="0"/>
                </a:rPr>
                <a:t>q21.31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696E9AC4-E4FF-F9B4-FDDA-4D624C9000D9}"/>
                </a:ext>
              </a:extLst>
            </p:cNvPr>
            <p:cNvSpPr txBox="1"/>
            <p:nvPr/>
          </p:nvSpPr>
          <p:spPr>
            <a:xfrm>
              <a:off x="3717414" y="3121887"/>
              <a:ext cx="39469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500" dirty="0">
                  <a:latin typeface="Arial" panose="020B0604020202020204" pitchFamily="34" charset="0"/>
                  <a:cs typeface="Arial" panose="020B0604020202020204" pitchFamily="34" charset="0"/>
                </a:rPr>
                <a:t>q21.32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60B9E1A-12ED-122E-0C91-E9222513BB4E}"/>
                </a:ext>
              </a:extLst>
            </p:cNvPr>
            <p:cNvSpPr txBox="1"/>
            <p:nvPr/>
          </p:nvSpPr>
          <p:spPr>
            <a:xfrm>
              <a:off x="2830081" y="2863663"/>
              <a:ext cx="98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TAT5A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6C83205D-10C7-D07E-73E7-05E328B76548}"/>
              </a:ext>
            </a:extLst>
          </p:cNvPr>
          <p:cNvGrpSpPr/>
          <p:nvPr/>
        </p:nvGrpSpPr>
        <p:grpSpPr>
          <a:xfrm>
            <a:off x="4952065" y="2976809"/>
            <a:ext cx="861379" cy="634373"/>
            <a:chOff x="4952065" y="1295569"/>
            <a:chExt cx="861379" cy="634373"/>
          </a:xfrm>
        </p:grpSpPr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337839CE-983D-DA7A-247B-EE8D5C023DB5}"/>
                </a:ext>
              </a:extLst>
            </p:cNvPr>
            <p:cNvGrpSpPr/>
            <p:nvPr/>
          </p:nvGrpSpPr>
          <p:grpSpPr>
            <a:xfrm>
              <a:off x="4952065" y="1295569"/>
              <a:ext cx="709100" cy="215444"/>
              <a:chOff x="1710702" y="2348137"/>
              <a:chExt cx="709100" cy="215444"/>
            </a:xfrm>
          </p:grpSpPr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id="{EB230EE0-D8BB-6B6E-09C5-7C7C47395410}"/>
                  </a:ext>
                </a:extLst>
              </p:cNvPr>
              <p:cNvSpPr/>
              <p:nvPr/>
            </p:nvSpPr>
            <p:spPr>
              <a:xfrm>
                <a:off x="1710702" y="2426670"/>
                <a:ext cx="72000" cy="72000"/>
              </a:xfrm>
              <a:prstGeom prst="rect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MY" sz="70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7D1D443C-8861-EDE5-7539-CDAF3448E1F8}"/>
                  </a:ext>
                </a:extLst>
              </p:cNvPr>
              <p:cNvSpPr txBox="1"/>
              <p:nvPr/>
            </p:nvSpPr>
            <p:spPr>
              <a:xfrm>
                <a:off x="1741647" y="2348137"/>
                <a:ext cx="6781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                            </a:t>
                </a:r>
              </a:p>
            </p:txBody>
          </p:sp>
        </p:grp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0FCD3AF0-4DF9-F998-03D5-333730C0B020}"/>
                </a:ext>
              </a:extLst>
            </p:cNvPr>
            <p:cNvGrpSpPr/>
            <p:nvPr/>
          </p:nvGrpSpPr>
          <p:grpSpPr>
            <a:xfrm>
              <a:off x="4955034" y="1512744"/>
              <a:ext cx="790072" cy="215444"/>
              <a:chOff x="5181692" y="2269006"/>
              <a:chExt cx="790072" cy="215444"/>
            </a:xfrm>
          </p:grpSpPr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9C20BACB-18FB-6460-B183-70A6AC7AD68C}"/>
                  </a:ext>
                </a:extLst>
              </p:cNvPr>
              <p:cNvSpPr txBox="1"/>
              <p:nvPr/>
            </p:nvSpPr>
            <p:spPr>
              <a:xfrm>
                <a:off x="5207407" y="2269006"/>
                <a:ext cx="76435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−FFF</a:t>
                </a:r>
              </a:p>
            </p:txBody>
          </p:sp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id="{359D1573-7FA6-FAE8-B5EB-4F9FCCA4C182}"/>
                  </a:ext>
                </a:extLst>
              </p:cNvPr>
              <p:cNvSpPr/>
              <p:nvPr/>
            </p:nvSpPr>
            <p:spPr>
              <a:xfrm>
                <a:off x="5181692" y="2339277"/>
                <a:ext cx="72000" cy="720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MY" sz="7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id="{1BF4B93C-926A-6D5E-DADE-BEE75144875F}"/>
                </a:ext>
              </a:extLst>
            </p:cNvPr>
            <p:cNvGrpSpPr/>
            <p:nvPr/>
          </p:nvGrpSpPr>
          <p:grpSpPr>
            <a:xfrm>
              <a:off x="4954956" y="1714498"/>
              <a:ext cx="858488" cy="215444"/>
              <a:chOff x="5203363" y="2469783"/>
              <a:chExt cx="858488" cy="215444"/>
            </a:xfrm>
          </p:grpSpPr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F124F0BE-EB61-215E-2EC6-E82F97C6325D}"/>
                  </a:ext>
                </a:extLst>
              </p:cNvPr>
              <p:cNvSpPr txBox="1"/>
              <p:nvPr/>
            </p:nvSpPr>
            <p:spPr>
              <a:xfrm>
                <a:off x="5233919" y="2469783"/>
                <a:ext cx="82793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−QQQ</a:t>
                </a:r>
              </a:p>
            </p:txBody>
          </p:sp>
          <p:sp>
            <p:nvSpPr>
              <p:cNvPr id="79" name="Rectangle 78">
                <a:extLst>
                  <a:ext uri="{FF2B5EF4-FFF2-40B4-BE49-F238E27FC236}">
                    <a16:creationId xmlns:a16="http://schemas.microsoft.com/office/drawing/2014/main" id="{C768C6A2-56A5-4199-5F5F-C44241706A33}"/>
                  </a:ext>
                </a:extLst>
              </p:cNvPr>
              <p:cNvSpPr/>
              <p:nvPr/>
            </p:nvSpPr>
            <p:spPr>
              <a:xfrm>
                <a:off x="5203363" y="2539329"/>
                <a:ext cx="72000" cy="72000"/>
              </a:xfrm>
              <a:prstGeom prst="rect">
                <a:avLst/>
              </a:prstGeom>
              <a:solidFill>
                <a:srgbClr val="92D050"/>
              </a:solidFill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MY" sz="7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6079F91F-FF70-E64D-4FA4-4A7B0B99C4A1}"/>
              </a:ext>
            </a:extLst>
          </p:cNvPr>
          <p:cNvSpPr txBox="1"/>
          <p:nvPr/>
        </p:nvSpPr>
        <p:spPr>
          <a:xfrm>
            <a:off x="733256" y="7187673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SG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8" name="Group 157">
            <a:extLst>
              <a:ext uri="{FF2B5EF4-FFF2-40B4-BE49-F238E27FC236}">
                <a16:creationId xmlns:a16="http://schemas.microsoft.com/office/drawing/2014/main" id="{35A8A391-C307-C4DF-116F-4B24D97447ED}"/>
              </a:ext>
            </a:extLst>
          </p:cNvPr>
          <p:cNvGrpSpPr/>
          <p:nvPr/>
        </p:nvGrpSpPr>
        <p:grpSpPr>
          <a:xfrm>
            <a:off x="973471" y="7297329"/>
            <a:ext cx="4410469" cy="1866792"/>
            <a:chOff x="1655836" y="2064642"/>
            <a:chExt cx="4586898" cy="2022359"/>
          </a:xfrm>
        </p:grpSpPr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9F5DF523-A017-9CF6-3239-86BAA41FFF10}"/>
                </a:ext>
              </a:extLst>
            </p:cNvPr>
            <p:cNvSpPr txBox="1"/>
            <p:nvPr/>
          </p:nvSpPr>
          <p:spPr>
            <a:xfrm>
              <a:off x="2404592" y="2074088"/>
              <a:ext cx="1021698" cy="233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PRGR 1.1e-716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C6E1C8E7-7562-84A5-AE99-822DEC4B5968}"/>
                </a:ext>
              </a:extLst>
            </p:cNvPr>
            <p:cNvSpPr txBox="1"/>
            <p:nvPr/>
          </p:nvSpPr>
          <p:spPr>
            <a:xfrm>
              <a:off x="1684168" y="2433165"/>
              <a:ext cx="556817" cy="233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RB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69A3A77E-EE04-600A-5643-4C61A304E519}"/>
                </a:ext>
              </a:extLst>
            </p:cNvPr>
            <p:cNvSpPr txBox="1"/>
            <p:nvPr/>
          </p:nvSpPr>
          <p:spPr>
            <a:xfrm>
              <a:off x="3817696" y="2064642"/>
              <a:ext cx="1021697" cy="233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No motif 1.4e-20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B6C30930-7ECB-563C-0B4B-7EBFEB109032}"/>
                </a:ext>
              </a:extLst>
            </p:cNvPr>
            <p:cNvSpPr txBox="1"/>
            <p:nvPr/>
          </p:nvSpPr>
          <p:spPr>
            <a:xfrm>
              <a:off x="1666497" y="3053739"/>
              <a:ext cx="499997" cy="366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RB−FFF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C4143237-2F28-AEFC-8418-D4C15A002722}"/>
                </a:ext>
              </a:extLst>
            </p:cNvPr>
            <p:cNvSpPr txBox="1"/>
            <p:nvPr/>
          </p:nvSpPr>
          <p:spPr>
            <a:xfrm>
              <a:off x="2404592" y="2871954"/>
              <a:ext cx="966722" cy="233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PRGR 3.6e-495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525BB18B-502C-2E5C-8E97-A589D3390D94}"/>
                </a:ext>
              </a:extLst>
            </p:cNvPr>
            <p:cNvSpPr txBox="1"/>
            <p:nvPr/>
          </p:nvSpPr>
          <p:spPr>
            <a:xfrm>
              <a:off x="3825333" y="2861546"/>
              <a:ext cx="966721" cy="233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ZN362 7.4e-15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9CE10E2C-181C-B1A8-2CA4-EC77E042F550}"/>
                </a:ext>
              </a:extLst>
            </p:cNvPr>
            <p:cNvSpPr txBox="1"/>
            <p:nvPr/>
          </p:nvSpPr>
          <p:spPr>
            <a:xfrm>
              <a:off x="1655836" y="3720234"/>
              <a:ext cx="539972" cy="3667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RB−QQQ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62A67408-AEFC-804D-CB7C-2524856DD6B4}"/>
                </a:ext>
              </a:extLst>
            </p:cNvPr>
            <p:cNvSpPr txBox="1"/>
            <p:nvPr/>
          </p:nvSpPr>
          <p:spPr>
            <a:xfrm>
              <a:off x="2404590" y="3545690"/>
              <a:ext cx="1021699" cy="233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PRGR 5.7e-837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A270DF7F-4C7E-8555-2054-8A0DB0AA2CDF}"/>
                </a:ext>
              </a:extLst>
            </p:cNvPr>
            <p:cNvSpPr txBox="1"/>
            <p:nvPr/>
          </p:nvSpPr>
          <p:spPr>
            <a:xfrm>
              <a:off x="3905111" y="3536245"/>
              <a:ext cx="934411" cy="233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ZN317 5.5e-54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E23709C0-F1E0-1CCC-8DA1-188095C62CAC}"/>
                </a:ext>
              </a:extLst>
            </p:cNvPr>
            <p:cNvSpPr txBox="1"/>
            <p:nvPr/>
          </p:nvSpPr>
          <p:spPr>
            <a:xfrm>
              <a:off x="5308325" y="3545690"/>
              <a:ext cx="934409" cy="233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ZN766 9.5e-41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F14A5F08-35A0-A871-1C11-22EC1EE7BD88}"/>
                </a:ext>
              </a:extLst>
            </p:cNvPr>
            <p:cNvSpPr txBox="1"/>
            <p:nvPr/>
          </p:nvSpPr>
          <p:spPr>
            <a:xfrm>
              <a:off x="5251650" y="2870991"/>
              <a:ext cx="934409" cy="233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 GLI4 2.0e-8</a:t>
              </a:r>
            </a:p>
          </p:txBody>
        </p:sp>
      </p:grpSp>
      <p:pic>
        <p:nvPicPr>
          <p:cNvPr id="170" name="Picture 169" descr="A colorful text on a black background&#10;&#10;AI-generated content may be incorrect.">
            <a:extLst>
              <a:ext uri="{FF2B5EF4-FFF2-40B4-BE49-F238E27FC236}">
                <a16:creationId xmlns:a16="http://schemas.microsoft.com/office/drawing/2014/main" id="{1732C003-20C8-31A9-FD98-F06A4A0B3A3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932"/>
          <a:stretch>
            <a:fillRect/>
          </a:stretch>
        </p:blipFill>
        <p:spPr>
          <a:xfrm>
            <a:off x="2917689" y="7478971"/>
            <a:ext cx="1213200" cy="507618"/>
          </a:xfrm>
          <a:prstGeom prst="rect">
            <a:avLst/>
          </a:prstGeom>
        </p:spPr>
      </p:pic>
      <p:pic>
        <p:nvPicPr>
          <p:cNvPr id="171" name="Picture 170" descr="A colorful letters on a black background&#10;&#10;AI-generated content may be incorrect.">
            <a:extLst>
              <a:ext uri="{FF2B5EF4-FFF2-40B4-BE49-F238E27FC236}">
                <a16:creationId xmlns:a16="http://schemas.microsoft.com/office/drawing/2014/main" id="{6825DEA1-E7A2-0FB3-2D67-96DC9E2A166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323"/>
          <a:stretch>
            <a:fillRect/>
          </a:stretch>
        </p:blipFill>
        <p:spPr>
          <a:xfrm>
            <a:off x="1544665" y="7508587"/>
            <a:ext cx="1213200" cy="473191"/>
          </a:xfrm>
          <a:prstGeom prst="rect">
            <a:avLst/>
          </a:prstGeom>
        </p:spPr>
      </p:pic>
      <p:pic>
        <p:nvPicPr>
          <p:cNvPr id="172" name="Picture 171" descr="A colorful text on a black background&#10;&#10;AI-generated content may be incorrect.">
            <a:extLst>
              <a:ext uri="{FF2B5EF4-FFF2-40B4-BE49-F238E27FC236}">
                <a16:creationId xmlns:a16="http://schemas.microsoft.com/office/drawing/2014/main" id="{B6AD6650-2256-B2F2-BB23-54F0BE7C178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01"/>
          <a:stretch>
            <a:fillRect/>
          </a:stretch>
        </p:blipFill>
        <p:spPr>
          <a:xfrm>
            <a:off x="4272376" y="7508586"/>
            <a:ext cx="1213200" cy="473191"/>
          </a:xfrm>
          <a:prstGeom prst="rect">
            <a:avLst/>
          </a:prstGeom>
        </p:spPr>
      </p:pic>
      <p:pic>
        <p:nvPicPr>
          <p:cNvPr id="173" name="Picture 172" descr="A colorful text on a black background&#10;&#10;AI-generated content may be incorrect.">
            <a:extLst>
              <a:ext uri="{FF2B5EF4-FFF2-40B4-BE49-F238E27FC236}">
                <a16:creationId xmlns:a16="http://schemas.microsoft.com/office/drawing/2014/main" id="{B2C2B3D3-FABC-D97F-EB29-3F0CDD721F6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568"/>
          <a:stretch>
            <a:fillRect/>
          </a:stretch>
        </p:blipFill>
        <p:spPr>
          <a:xfrm>
            <a:off x="1535231" y="8149002"/>
            <a:ext cx="1213200" cy="473189"/>
          </a:xfrm>
          <a:prstGeom prst="rect">
            <a:avLst/>
          </a:prstGeom>
        </p:spPr>
      </p:pic>
      <p:pic>
        <p:nvPicPr>
          <p:cNvPr id="174" name="Picture 173" descr="A red and blue letters on a black background&#10;&#10;AI-generated content may be incorrect.">
            <a:extLst>
              <a:ext uri="{FF2B5EF4-FFF2-40B4-BE49-F238E27FC236}">
                <a16:creationId xmlns:a16="http://schemas.microsoft.com/office/drawing/2014/main" id="{FD44D4B6-E2F6-E04F-9CA4-02BD3BB5D91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236"/>
          <a:stretch>
            <a:fillRect/>
          </a:stretch>
        </p:blipFill>
        <p:spPr>
          <a:xfrm>
            <a:off x="2917689" y="8149002"/>
            <a:ext cx="1213200" cy="471288"/>
          </a:xfrm>
          <a:prstGeom prst="rect">
            <a:avLst/>
          </a:prstGeom>
        </p:spPr>
      </p:pic>
      <p:pic>
        <p:nvPicPr>
          <p:cNvPr id="175" name="Picture 174" descr="A colorful letters on a black background&#10;&#10;AI-generated content may be incorrect.">
            <a:extLst>
              <a:ext uri="{FF2B5EF4-FFF2-40B4-BE49-F238E27FC236}">
                <a16:creationId xmlns:a16="http://schemas.microsoft.com/office/drawing/2014/main" id="{D823BA52-1D90-4C0A-44B0-FF6CCEA240B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236"/>
          <a:stretch>
            <a:fillRect/>
          </a:stretch>
        </p:blipFill>
        <p:spPr>
          <a:xfrm>
            <a:off x="4272376" y="8139518"/>
            <a:ext cx="1213200" cy="480200"/>
          </a:xfrm>
          <a:prstGeom prst="rect">
            <a:avLst/>
          </a:prstGeom>
        </p:spPr>
      </p:pic>
      <p:pic>
        <p:nvPicPr>
          <p:cNvPr id="176" name="Picture 175" descr="A colorful text on a black background&#10;&#10;AI-generated content may be incorrect.">
            <a:extLst>
              <a:ext uri="{FF2B5EF4-FFF2-40B4-BE49-F238E27FC236}">
                <a16:creationId xmlns:a16="http://schemas.microsoft.com/office/drawing/2014/main" id="{18F17D0D-CF5C-D61B-8738-5F46CCB1345D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236"/>
          <a:stretch>
            <a:fillRect/>
          </a:stretch>
        </p:blipFill>
        <p:spPr>
          <a:xfrm>
            <a:off x="1544665" y="8784083"/>
            <a:ext cx="1213200" cy="473189"/>
          </a:xfrm>
          <a:prstGeom prst="rect">
            <a:avLst/>
          </a:prstGeom>
        </p:spPr>
      </p:pic>
      <p:pic>
        <p:nvPicPr>
          <p:cNvPr id="177" name="Picture 176" descr="A colorful text on a black background&#10;&#10;AI-generated content may be incorrect.">
            <a:extLst>
              <a:ext uri="{FF2B5EF4-FFF2-40B4-BE49-F238E27FC236}">
                <a16:creationId xmlns:a16="http://schemas.microsoft.com/office/drawing/2014/main" id="{08FC35EB-D1FA-F4AB-F9DE-5D1A258442C2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236"/>
          <a:stretch>
            <a:fillRect/>
          </a:stretch>
        </p:blipFill>
        <p:spPr>
          <a:xfrm>
            <a:off x="2917689" y="8785033"/>
            <a:ext cx="1213200" cy="471288"/>
          </a:xfrm>
          <a:prstGeom prst="rect">
            <a:avLst/>
          </a:prstGeom>
        </p:spPr>
      </p:pic>
      <p:pic>
        <p:nvPicPr>
          <p:cNvPr id="178" name="Picture 177" descr="A colorful text on a black background&#10;&#10;AI-generated content may be incorrect.">
            <a:extLst>
              <a:ext uri="{FF2B5EF4-FFF2-40B4-BE49-F238E27FC236}">
                <a16:creationId xmlns:a16="http://schemas.microsoft.com/office/drawing/2014/main" id="{5A540122-9219-9CEE-DDA1-74615E546864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568"/>
          <a:stretch>
            <a:fillRect/>
          </a:stretch>
        </p:blipFill>
        <p:spPr>
          <a:xfrm>
            <a:off x="4272376" y="8783132"/>
            <a:ext cx="1213200" cy="473189"/>
          </a:xfrm>
          <a:prstGeom prst="rect">
            <a:avLst/>
          </a:prstGeom>
        </p:spPr>
      </p:pic>
      <p:sp>
        <p:nvSpPr>
          <p:cNvPr id="179" name="TextBox 178">
            <a:extLst>
              <a:ext uri="{FF2B5EF4-FFF2-40B4-BE49-F238E27FC236}">
                <a16:creationId xmlns:a16="http://schemas.microsoft.com/office/drawing/2014/main" id="{3ABE7007-2C13-389A-3C97-3557430E34E9}"/>
              </a:ext>
            </a:extLst>
          </p:cNvPr>
          <p:cNvSpPr txBox="1"/>
          <p:nvPr/>
        </p:nvSpPr>
        <p:spPr>
          <a:xfrm>
            <a:off x="4430977" y="7294429"/>
            <a:ext cx="982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800" dirty="0">
                <a:latin typeface="Arial" panose="020B0604020202020204" pitchFamily="34" charset="0"/>
                <a:cs typeface="Arial" panose="020B0604020202020204" pitchFamily="34" charset="0"/>
              </a:rPr>
              <a:t>Z705G 1.7e-1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08F226D-66B0-86D0-4FA4-5D62D56D2AF6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15" b="3262"/>
          <a:stretch/>
        </p:blipFill>
        <p:spPr>
          <a:xfrm>
            <a:off x="1629000" y="4089199"/>
            <a:ext cx="3240000" cy="3043081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FC4DEC0C-357B-CFC1-1F60-D0DE28633E20}"/>
              </a:ext>
            </a:extLst>
          </p:cNvPr>
          <p:cNvGrpSpPr/>
          <p:nvPr/>
        </p:nvGrpSpPr>
        <p:grpSpPr>
          <a:xfrm>
            <a:off x="5049000" y="4252923"/>
            <a:ext cx="904240" cy="734148"/>
            <a:chOff x="5049000" y="2683705"/>
            <a:chExt cx="904240" cy="734148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378A72A1-4A75-A00F-C9C1-889C5B8C437F}"/>
                </a:ext>
              </a:extLst>
            </p:cNvPr>
            <p:cNvGrpSpPr/>
            <p:nvPr/>
          </p:nvGrpSpPr>
          <p:grpSpPr>
            <a:xfrm>
              <a:off x="5049000" y="3202409"/>
              <a:ext cx="904240" cy="215444"/>
              <a:chOff x="8613096" y="4845278"/>
              <a:chExt cx="904240" cy="215444"/>
            </a:xfrm>
          </p:grpSpPr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A8462062-49E5-E497-5E6D-B36B502936F9}"/>
                  </a:ext>
                </a:extLst>
              </p:cNvPr>
              <p:cNvCxnSpPr/>
              <p:nvPr/>
            </p:nvCxnSpPr>
            <p:spPr>
              <a:xfrm>
                <a:off x="8613096" y="4944967"/>
                <a:ext cx="91440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64AF9908-E16C-61CC-DEA1-22E8D8A1F787}"/>
                  </a:ext>
                </a:extLst>
              </p:cNvPr>
              <p:cNvSpPr txBox="1"/>
              <p:nvPr/>
            </p:nvSpPr>
            <p:spPr>
              <a:xfrm>
                <a:off x="8658816" y="4845278"/>
                <a:ext cx="8585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−QQQ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C6AC1CA4-8F58-7C6B-BEBD-623B839F187A}"/>
                </a:ext>
              </a:extLst>
            </p:cNvPr>
            <p:cNvGrpSpPr/>
            <p:nvPr/>
          </p:nvGrpSpPr>
          <p:grpSpPr>
            <a:xfrm>
              <a:off x="5049000" y="2950873"/>
              <a:ext cx="904240" cy="215444"/>
              <a:chOff x="7754576" y="5385770"/>
              <a:chExt cx="904240" cy="215444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8201828-1EC0-E2C5-0559-073D5A0FAB70}"/>
                  </a:ext>
                </a:extLst>
              </p:cNvPr>
              <p:cNvSpPr txBox="1"/>
              <p:nvPr/>
            </p:nvSpPr>
            <p:spPr>
              <a:xfrm>
                <a:off x="7800296" y="5385770"/>
                <a:ext cx="8585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−FFF</a:t>
                </a:r>
              </a:p>
            </p:txBody>
          </p: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F3813D5E-B6CA-19B5-2F40-C9E886A951E5}"/>
                  </a:ext>
                </a:extLst>
              </p:cNvPr>
              <p:cNvCxnSpPr/>
              <p:nvPr/>
            </p:nvCxnSpPr>
            <p:spPr>
              <a:xfrm>
                <a:off x="7754576" y="5485392"/>
                <a:ext cx="9144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573A6CAB-40E1-0C8C-62EE-D0C7A990C34B}"/>
                </a:ext>
              </a:extLst>
            </p:cNvPr>
            <p:cNvGrpSpPr/>
            <p:nvPr/>
          </p:nvGrpSpPr>
          <p:grpSpPr>
            <a:xfrm>
              <a:off x="5049000" y="2683705"/>
              <a:ext cx="474980" cy="215444"/>
              <a:chOff x="7231458" y="4381344"/>
              <a:chExt cx="474980" cy="215444"/>
            </a:xfrm>
          </p:grpSpPr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2CDD7CE9-E013-D1E5-6220-E060D3C80D07}"/>
                  </a:ext>
                </a:extLst>
              </p:cNvPr>
              <p:cNvCxnSpPr/>
              <p:nvPr/>
            </p:nvCxnSpPr>
            <p:spPr>
              <a:xfrm>
                <a:off x="7231458" y="4484073"/>
                <a:ext cx="91440" cy="0"/>
              </a:xfrm>
              <a:prstGeom prst="line">
                <a:avLst/>
              </a:prstGeom>
              <a:ln w="1905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C0076CD-EC56-549F-7469-631920230312}"/>
                  </a:ext>
                </a:extLst>
              </p:cNvPr>
              <p:cNvSpPr txBox="1"/>
              <p:nvPr/>
            </p:nvSpPr>
            <p:spPr>
              <a:xfrm>
                <a:off x="7277178" y="4381344"/>
                <a:ext cx="4292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MY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</a:t>
                </a:r>
              </a:p>
            </p:txBody>
          </p:sp>
        </p:grp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1E96BC92-D041-05CA-A7EF-7D405641AE83}"/>
              </a:ext>
            </a:extLst>
          </p:cNvPr>
          <p:cNvSpPr txBox="1"/>
          <p:nvPr/>
        </p:nvSpPr>
        <p:spPr>
          <a:xfrm>
            <a:off x="733256" y="415912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SG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2C8A6F1-525D-23F1-FED5-5D046054636D}"/>
              </a:ext>
            </a:extLst>
          </p:cNvPr>
          <p:cNvSpPr txBox="1"/>
          <p:nvPr/>
        </p:nvSpPr>
        <p:spPr>
          <a:xfrm>
            <a:off x="1492674" y="1039730"/>
            <a:ext cx="4780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900" b="1" dirty="0">
                <a:latin typeface="Arial" panose="020B0604020202020204" pitchFamily="34" charset="0"/>
                <a:cs typeface="Arial" panose="020B0604020202020204" pitchFamily="34" charset="0"/>
              </a:rPr>
              <a:t>PRB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1EDD7ED-41DE-18F5-E40C-6D2E1125966C}"/>
              </a:ext>
            </a:extLst>
          </p:cNvPr>
          <p:cNvSpPr txBox="1"/>
          <p:nvPr/>
        </p:nvSpPr>
        <p:spPr>
          <a:xfrm>
            <a:off x="2845203" y="1039730"/>
            <a:ext cx="7549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900" b="1" dirty="0">
                <a:latin typeface="Arial" panose="020B0604020202020204" pitchFamily="34" charset="0"/>
                <a:cs typeface="Arial" panose="020B0604020202020204" pitchFamily="34" charset="0"/>
              </a:rPr>
              <a:t>PRB−FFF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957820C-FE48-EFD1-6666-0B6D3838D724}"/>
              </a:ext>
            </a:extLst>
          </p:cNvPr>
          <p:cNvSpPr txBox="1"/>
          <p:nvPr/>
        </p:nvSpPr>
        <p:spPr>
          <a:xfrm>
            <a:off x="4293320" y="1039730"/>
            <a:ext cx="8589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900" b="1" dirty="0">
                <a:latin typeface="Arial" panose="020B0604020202020204" pitchFamily="34" charset="0"/>
                <a:cs typeface="Arial" panose="020B0604020202020204" pitchFamily="34" charset="0"/>
              </a:rPr>
              <a:t>PRB−QQQ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E8423914-6105-5111-D202-A76F4777F302}"/>
              </a:ext>
            </a:extLst>
          </p:cNvPr>
          <p:cNvGrpSpPr/>
          <p:nvPr/>
        </p:nvGrpSpPr>
        <p:grpSpPr>
          <a:xfrm>
            <a:off x="5226471" y="1226590"/>
            <a:ext cx="597175" cy="489935"/>
            <a:chOff x="2831825" y="3045784"/>
            <a:chExt cx="597175" cy="489935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8AE08702-0EFF-B405-285E-2CDBA5F6C747}"/>
                </a:ext>
              </a:extLst>
            </p:cNvPr>
            <p:cNvGrpSpPr/>
            <p:nvPr/>
          </p:nvGrpSpPr>
          <p:grpSpPr>
            <a:xfrm>
              <a:off x="2831825" y="3045784"/>
              <a:ext cx="597175" cy="215444"/>
              <a:chOff x="2831825" y="3045784"/>
              <a:chExt cx="597175" cy="215444"/>
            </a:xfrm>
          </p:grpSpPr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1B0F4DEC-FB1B-C938-520E-40884CAB63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704" t="7766" r="84255" b="85983"/>
              <a:stretch>
                <a:fillRect/>
              </a:stretch>
            </p:blipFill>
            <p:spPr>
              <a:xfrm>
                <a:off x="2831825" y="3104831"/>
                <a:ext cx="126727" cy="100013"/>
              </a:xfrm>
              <a:prstGeom prst="rect">
                <a:avLst/>
              </a:prstGeom>
            </p:spPr>
          </p:pic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96C48EBB-B8B4-F64F-6F39-10C6F52D30AE}"/>
                  </a:ext>
                </a:extLst>
              </p:cNvPr>
              <p:cNvSpPr txBox="1"/>
              <p:nvPr/>
            </p:nvSpPr>
            <p:spPr>
              <a:xfrm>
                <a:off x="2862262" y="3045784"/>
                <a:ext cx="56673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en-SG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FD17A8E7-DECD-C2C8-5021-68993B5448E9}"/>
                </a:ext>
              </a:extLst>
            </p:cNvPr>
            <p:cNvGrpSpPr/>
            <p:nvPr/>
          </p:nvGrpSpPr>
          <p:grpSpPr>
            <a:xfrm>
              <a:off x="2831825" y="3320275"/>
              <a:ext cx="597175" cy="215444"/>
              <a:chOff x="3429000" y="3045784"/>
              <a:chExt cx="597175" cy="215444"/>
            </a:xfrm>
          </p:grpSpPr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A0C4AB15-8C44-EF99-0706-A37B876306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132" t="43793" r="24826" b="51469"/>
              <a:stretch>
                <a:fillRect/>
              </a:stretch>
            </p:blipFill>
            <p:spPr>
              <a:xfrm>
                <a:off x="3429000" y="3129037"/>
                <a:ext cx="126727" cy="75807"/>
              </a:xfrm>
              <a:prstGeom prst="rect">
                <a:avLst/>
              </a:prstGeom>
            </p:spPr>
          </p:pic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1E5C19F4-EFE5-49CA-CD59-BC4E569D3A87}"/>
                  </a:ext>
                </a:extLst>
              </p:cNvPr>
              <p:cNvSpPr txBox="1"/>
              <p:nvPr/>
            </p:nvSpPr>
            <p:spPr>
              <a:xfrm>
                <a:off x="3459437" y="3045784"/>
                <a:ext cx="56673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5020</a:t>
                </a:r>
                <a:endParaRPr lang="en-SG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E852B274-72C7-04E6-D12B-58536A3E2AFF}"/>
              </a:ext>
            </a:extLst>
          </p:cNvPr>
          <p:cNvSpPr txBox="1"/>
          <p:nvPr/>
        </p:nvSpPr>
        <p:spPr>
          <a:xfrm>
            <a:off x="747760" y="91115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SG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id="{DF3E03DA-03F1-B837-20B7-68FE315710CA}"/>
              </a:ext>
            </a:extLst>
          </p:cNvPr>
          <p:cNvGrpSpPr/>
          <p:nvPr/>
        </p:nvGrpSpPr>
        <p:grpSpPr>
          <a:xfrm>
            <a:off x="2266239" y="1270562"/>
            <a:ext cx="1608086" cy="1392708"/>
            <a:chOff x="583741" y="2196152"/>
            <a:chExt cx="1608086" cy="1392708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C99FF8F6-81CA-E679-89E9-9D71135373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70" t="3675" r="12836" b="5877"/>
            <a:stretch>
              <a:fillRect/>
            </a:stretch>
          </p:blipFill>
          <p:spPr>
            <a:xfrm>
              <a:off x="968991" y="2196152"/>
              <a:ext cx="1080000" cy="1069412"/>
            </a:xfrm>
            <a:prstGeom prst="rect">
              <a:avLst/>
            </a:prstGeom>
          </p:spPr>
        </p:pic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5EF202AB-1346-0061-7229-96F3B7CDA05C}"/>
                </a:ext>
              </a:extLst>
            </p:cNvPr>
            <p:cNvSpPr txBox="1"/>
            <p:nvPr/>
          </p:nvSpPr>
          <p:spPr>
            <a:xfrm>
              <a:off x="773246" y="3358028"/>
              <a:ext cx="14185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900" dirty="0">
                  <a:latin typeface="Arial" panose="020B0604020202020204" pitchFamily="34" charset="0"/>
                  <a:cs typeface="Arial" panose="020B0604020202020204" pitchFamily="34" charset="0"/>
                </a:rPr>
                <a:t>PC1: 90% variance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5FE18727-6A45-2437-F452-18E4DE7C6B41}"/>
                </a:ext>
              </a:extLst>
            </p:cNvPr>
            <p:cNvSpPr txBox="1"/>
            <p:nvPr/>
          </p:nvSpPr>
          <p:spPr>
            <a:xfrm>
              <a:off x="799700" y="3209600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5762486F-5528-6F0A-A49E-42965C4A76EB}"/>
                </a:ext>
              </a:extLst>
            </p:cNvPr>
            <p:cNvSpPr txBox="1"/>
            <p:nvPr/>
          </p:nvSpPr>
          <p:spPr>
            <a:xfrm>
              <a:off x="1027183" y="3209600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EA31DAFF-7B06-C71C-9C0E-B7B4EC2BC357}"/>
                </a:ext>
              </a:extLst>
            </p:cNvPr>
            <p:cNvSpPr txBox="1"/>
            <p:nvPr/>
          </p:nvSpPr>
          <p:spPr>
            <a:xfrm>
              <a:off x="1287628" y="3209600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62D81EA4-931E-AB0A-9D2D-084220EB726A}"/>
                </a:ext>
              </a:extLst>
            </p:cNvPr>
            <p:cNvSpPr txBox="1"/>
            <p:nvPr/>
          </p:nvSpPr>
          <p:spPr>
            <a:xfrm>
              <a:off x="1508990" y="3209600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78FFCA87-5BE2-3428-B4B8-CA089A70C4ED}"/>
                </a:ext>
              </a:extLst>
            </p:cNvPr>
            <p:cNvSpPr txBox="1"/>
            <p:nvPr/>
          </p:nvSpPr>
          <p:spPr>
            <a:xfrm>
              <a:off x="1740163" y="3209600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B44CF4B6-AB79-30A8-FA33-BD0B7B764411}"/>
                </a:ext>
              </a:extLst>
            </p:cNvPr>
            <p:cNvSpPr txBox="1"/>
            <p:nvPr/>
          </p:nvSpPr>
          <p:spPr>
            <a:xfrm rot="16200000">
              <a:off x="139403" y="2665888"/>
              <a:ext cx="11195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900" dirty="0">
                  <a:latin typeface="Arial" panose="020B0604020202020204" pitchFamily="34" charset="0"/>
                  <a:cs typeface="Arial" panose="020B0604020202020204" pitchFamily="34" charset="0"/>
                </a:rPr>
                <a:t>PC2: 5% variance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8076EC17-0DDB-0DEF-C1DF-91E3F4BF6ACA}"/>
                </a:ext>
              </a:extLst>
            </p:cNvPr>
            <p:cNvSpPr txBox="1"/>
            <p:nvPr/>
          </p:nvSpPr>
          <p:spPr>
            <a:xfrm>
              <a:off x="656601" y="2568574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5C931DE4-47AD-2668-9EE2-536ABAA66872}"/>
                </a:ext>
              </a:extLst>
            </p:cNvPr>
            <p:cNvSpPr txBox="1"/>
            <p:nvPr/>
          </p:nvSpPr>
          <p:spPr>
            <a:xfrm>
              <a:off x="656601" y="2308337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AE3E0B89-0211-48E3-57D0-EF7BA33FC5BE}"/>
                </a:ext>
              </a:extLst>
            </p:cNvPr>
            <p:cNvSpPr txBox="1"/>
            <p:nvPr/>
          </p:nvSpPr>
          <p:spPr>
            <a:xfrm>
              <a:off x="656601" y="2830340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B7A2B6B6-2983-D124-FC8B-E83AABF182D7}"/>
                </a:ext>
              </a:extLst>
            </p:cNvPr>
            <p:cNvSpPr txBox="1"/>
            <p:nvPr/>
          </p:nvSpPr>
          <p:spPr>
            <a:xfrm>
              <a:off x="655298" y="3097122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-40</a:t>
              </a:r>
            </a:p>
          </p:txBody>
        </p:sp>
      </p:grpSp>
      <p:grpSp>
        <p:nvGrpSpPr>
          <p:cNvPr id="94" name="Group 93">
            <a:extLst>
              <a:ext uri="{FF2B5EF4-FFF2-40B4-BE49-F238E27FC236}">
                <a16:creationId xmlns:a16="http://schemas.microsoft.com/office/drawing/2014/main" id="{B93BA647-D572-6080-B104-34EE199B35A4}"/>
              </a:ext>
            </a:extLst>
          </p:cNvPr>
          <p:cNvGrpSpPr/>
          <p:nvPr/>
        </p:nvGrpSpPr>
        <p:grpSpPr>
          <a:xfrm>
            <a:off x="3738991" y="1270562"/>
            <a:ext cx="1611143" cy="1410441"/>
            <a:chOff x="3328996" y="2178419"/>
            <a:chExt cx="1611143" cy="1410441"/>
          </a:xfrm>
        </p:grpSpPr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id="{4AD408C5-C5E5-71CF-9445-5CAFFC652D6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69" t="3898" r="14129" b="6102"/>
            <a:stretch>
              <a:fillRect/>
            </a:stretch>
          </p:blipFill>
          <p:spPr>
            <a:xfrm>
              <a:off x="3706945" y="2196152"/>
              <a:ext cx="1080000" cy="1084045"/>
            </a:xfrm>
            <a:prstGeom prst="rect">
              <a:avLst/>
            </a:prstGeom>
          </p:spPr>
        </p:pic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8E2107B0-7CE6-BB15-C4DE-5F5B6750FB3C}"/>
                </a:ext>
              </a:extLst>
            </p:cNvPr>
            <p:cNvSpPr txBox="1"/>
            <p:nvPr/>
          </p:nvSpPr>
          <p:spPr>
            <a:xfrm>
              <a:off x="3657984" y="3226507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02BFA76D-CA75-18AC-3D6D-4EDDAF9CAAF6}"/>
                </a:ext>
              </a:extLst>
            </p:cNvPr>
            <p:cNvSpPr txBox="1"/>
            <p:nvPr/>
          </p:nvSpPr>
          <p:spPr>
            <a:xfrm>
              <a:off x="4032268" y="3226507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18729943-A458-1EE6-FD49-B17AE4E51664}"/>
                </a:ext>
              </a:extLst>
            </p:cNvPr>
            <p:cNvSpPr txBox="1"/>
            <p:nvPr/>
          </p:nvSpPr>
          <p:spPr>
            <a:xfrm>
              <a:off x="4389502" y="3226507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72EEE638-E16F-482A-7C60-D88C5A266170}"/>
                </a:ext>
              </a:extLst>
            </p:cNvPr>
            <p:cNvSpPr txBox="1"/>
            <p:nvPr/>
          </p:nvSpPr>
          <p:spPr>
            <a:xfrm>
              <a:off x="3385677" y="2620277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0633A05A-22B8-0BE3-2F2B-7C02F4B34A8E}"/>
                </a:ext>
              </a:extLst>
            </p:cNvPr>
            <p:cNvSpPr txBox="1"/>
            <p:nvPr/>
          </p:nvSpPr>
          <p:spPr>
            <a:xfrm>
              <a:off x="3382005" y="2433483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EA0F968E-7C9C-4A60-42B0-E4834890269B}"/>
                </a:ext>
              </a:extLst>
            </p:cNvPr>
            <p:cNvSpPr txBox="1"/>
            <p:nvPr/>
          </p:nvSpPr>
          <p:spPr>
            <a:xfrm>
              <a:off x="3385677" y="2808599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97C498BD-4A83-9DF4-161C-6AA77DE066CF}"/>
                </a:ext>
              </a:extLst>
            </p:cNvPr>
            <p:cNvSpPr txBox="1"/>
            <p:nvPr/>
          </p:nvSpPr>
          <p:spPr>
            <a:xfrm>
              <a:off x="3385677" y="2243079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F4918DCA-1EC7-9294-1FA7-730C8EFD9442}"/>
                </a:ext>
              </a:extLst>
            </p:cNvPr>
            <p:cNvSpPr txBox="1"/>
            <p:nvPr/>
          </p:nvSpPr>
          <p:spPr>
            <a:xfrm>
              <a:off x="3389349" y="2997109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BC3DD182-EE34-7ECB-BA4D-7A2505046CAB}"/>
                </a:ext>
              </a:extLst>
            </p:cNvPr>
            <p:cNvSpPr txBox="1"/>
            <p:nvPr/>
          </p:nvSpPr>
          <p:spPr>
            <a:xfrm>
              <a:off x="3521558" y="3358028"/>
              <a:ext cx="14185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900" dirty="0">
                  <a:latin typeface="Arial" panose="020B0604020202020204" pitchFamily="34" charset="0"/>
                  <a:cs typeface="Arial" panose="020B0604020202020204" pitchFamily="34" charset="0"/>
                </a:rPr>
                <a:t>PC1: 89% variance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A227EFB6-0942-86A8-5189-D4EBAAD060B5}"/>
                </a:ext>
              </a:extLst>
            </p:cNvPr>
            <p:cNvSpPr txBox="1"/>
            <p:nvPr/>
          </p:nvSpPr>
          <p:spPr>
            <a:xfrm rot="16200000">
              <a:off x="2884658" y="2622757"/>
              <a:ext cx="11195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900" dirty="0">
                  <a:latin typeface="Arial" panose="020B0604020202020204" pitchFamily="34" charset="0"/>
                  <a:cs typeface="Arial" panose="020B0604020202020204" pitchFamily="34" charset="0"/>
                </a:rPr>
                <a:t>PC2: 5% variance</a:t>
              </a:r>
            </a:p>
          </p:txBody>
        </p:sp>
      </p:grp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BEBBB1BE-BD83-AE62-BB6E-BBFFD717E98C}"/>
              </a:ext>
            </a:extLst>
          </p:cNvPr>
          <p:cNvGrpSpPr/>
          <p:nvPr/>
        </p:nvGrpSpPr>
        <p:grpSpPr>
          <a:xfrm>
            <a:off x="815136" y="1249374"/>
            <a:ext cx="1592056" cy="1420615"/>
            <a:chOff x="4735326" y="2185978"/>
            <a:chExt cx="1592056" cy="1420615"/>
          </a:xfrm>
        </p:grpSpPr>
        <p:pic>
          <p:nvPicPr>
            <p:cNvPr id="107" name="Picture 106">
              <a:extLst>
                <a:ext uri="{FF2B5EF4-FFF2-40B4-BE49-F238E27FC236}">
                  <a16:creationId xmlns:a16="http://schemas.microsoft.com/office/drawing/2014/main" id="{40F73111-B0FA-C6CD-DC7D-F5D177B54141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00" t="3959" r="14026" b="6070"/>
            <a:stretch>
              <a:fillRect/>
            </a:stretch>
          </p:blipFill>
          <p:spPr>
            <a:xfrm>
              <a:off x="5104923" y="2221441"/>
              <a:ext cx="1080000" cy="1080001"/>
            </a:xfrm>
            <a:prstGeom prst="rect">
              <a:avLst/>
            </a:prstGeom>
          </p:spPr>
        </p:pic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CDC6726A-DF20-C6F2-42A1-E76A9DA1ED70}"/>
                </a:ext>
              </a:extLst>
            </p:cNvPr>
            <p:cNvSpPr txBox="1"/>
            <p:nvPr/>
          </p:nvSpPr>
          <p:spPr>
            <a:xfrm>
              <a:off x="5045227" y="3253286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FB5E2FEE-5769-F45B-7203-72C9B6F13F71}"/>
                </a:ext>
              </a:extLst>
            </p:cNvPr>
            <p:cNvSpPr txBox="1"/>
            <p:nvPr/>
          </p:nvSpPr>
          <p:spPr>
            <a:xfrm>
              <a:off x="5419511" y="3253286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BFD53D9C-7303-E38B-6C61-D638CE0F04BD}"/>
                </a:ext>
              </a:extLst>
            </p:cNvPr>
            <p:cNvSpPr txBox="1"/>
            <p:nvPr/>
          </p:nvSpPr>
          <p:spPr>
            <a:xfrm>
              <a:off x="5776745" y="3253286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EF217D04-1C64-F06B-B5E4-4D23D51C011C}"/>
                </a:ext>
              </a:extLst>
            </p:cNvPr>
            <p:cNvSpPr txBox="1"/>
            <p:nvPr/>
          </p:nvSpPr>
          <p:spPr>
            <a:xfrm>
              <a:off x="4788915" y="2591083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52B4346E-0477-7E0E-0F84-59EE92C44BE8}"/>
                </a:ext>
              </a:extLst>
            </p:cNvPr>
            <p:cNvSpPr txBox="1"/>
            <p:nvPr/>
          </p:nvSpPr>
          <p:spPr>
            <a:xfrm>
              <a:off x="4785243" y="2393273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969DF74-5026-8E89-AF1E-1E2975B825AC}"/>
                </a:ext>
              </a:extLst>
            </p:cNvPr>
            <p:cNvSpPr txBox="1"/>
            <p:nvPr/>
          </p:nvSpPr>
          <p:spPr>
            <a:xfrm>
              <a:off x="4788915" y="2790421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CC0657AC-DFCA-8D7D-E1F4-E7D8A18F626B}"/>
                </a:ext>
              </a:extLst>
            </p:cNvPr>
            <p:cNvSpPr txBox="1"/>
            <p:nvPr/>
          </p:nvSpPr>
          <p:spPr>
            <a:xfrm>
              <a:off x="4788915" y="2191853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F3A3A576-FBFE-2945-2107-8F479D7CC9DA}"/>
                </a:ext>
              </a:extLst>
            </p:cNvPr>
            <p:cNvSpPr txBox="1"/>
            <p:nvPr/>
          </p:nvSpPr>
          <p:spPr>
            <a:xfrm>
              <a:off x="4792587" y="2986275"/>
              <a:ext cx="3971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MY" sz="800" dirty="0">
                  <a:latin typeface="Arial" panose="020B0604020202020204" pitchFamily="34" charset="0"/>
                  <a:cs typeface="Arial" panose="020B0604020202020204" pitchFamily="34" charset="0"/>
                </a:rPr>
                <a:t>-20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589B7735-EBD2-3749-03F5-B0802397DB47}"/>
                </a:ext>
              </a:extLst>
            </p:cNvPr>
            <p:cNvSpPr txBox="1"/>
            <p:nvPr/>
          </p:nvSpPr>
          <p:spPr>
            <a:xfrm>
              <a:off x="4908801" y="3375761"/>
              <a:ext cx="14185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900" dirty="0">
                  <a:latin typeface="Arial" panose="020B0604020202020204" pitchFamily="34" charset="0"/>
                  <a:cs typeface="Arial" panose="020B0604020202020204" pitchFamily="34" charset="0"/>
                </a:rPr>
                <a:t>PC1: 90% variance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37A7B11A-2E21-8312-9173-9BB8D4FD10F3}"/>
                </a:ext>
              </a:extLst>
            </p:cNvPr>
            <p:cNvSpPr txBox="1"/>
            <p:nvPr/>
          </p:nvSpPr>
          <p:spPr>
            <a:xfrm rot="16200000">
              <a:off x="4290988" y="2630316"/>
              <a:ext cx="11195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MY" sz="900" dirty="0">
                  <a:latin typeface="Arial" panose="020B0604020202020204" pitchFamily="34" charset="0"/>
                  <a:cs typeface="Arial" panose="020B0604020202020204" pitchFamily="34" charset="0"/>
                </a:rPr>
                <a:t>PC2: 5% varianc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951832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48">
            <a:extLst>
              <a:ext uri="{FF2B5EF4-FFF2-40B4-BE49-F238E27FC236}">
                <a16:creationId xmlns:a16="http://schemas.microsoft.com/office/drawing/2014/main" id="{286E650B-FBE7-5BAF-E551-325A11598721}"/>
              </a:ext>
            </a:extLst>
          </p:cNvPr>
          <p:cNvSpPr txBox="1"/>
          <p:nvPr/>
        </p:nvSpPr>
        <p:spPr>
          <a:xfrm>
            <a:off x="623750" y="881196"/>
            <a:ext cx="5238520" cy="16312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MY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5. Genome wide distribution of PR binding in PRB and AF1 mutants. 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incipal component analysis (PCA) demonstrated tight clustering of biological triplicates and clear separation between Control and R5020-treated samples, indicating strong treatment-dependent effect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enome browser tracks showing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seq enrichment at representative PR target genes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HSD11B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ET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TAT5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Circle plot of PRB peak density across all chromosome regions. PRB-FFF exhibits enriched binding genome wide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top 3 most significant binding motifs identified using MEME software are shown for PRB, PRB-FFF and PRB-QQQ cells. Enriched sequence with no match to a known transcription factor binding motif is indicated as “No motif”.</a:t>
            </a:r>
          </a:p>
        </p:txBody>
      </p:sp>
    </p:spTree>
    <p:extLst>
      <p:ext uri="{BB962C8B-B14F-4D97-AF65-F5344CB8AC3E}">
        <p14:creationId xmlns:p14="http://schemas.microsoft.com/office/powerpoint/2010/main" val="26562332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>
            <a:extLst>
              <a:ext uri="{FF2B5EF4-FFF2-40B4-BE49-F238E27FC236}">
                <a16:creationId xmlns:a16="http://schemas.microsoft.com/office/drawing/2014/main" id="{B48DED76-E61B-7F37-0940-5E17FBEA79EA}"/>
              </a:ext>
            </a:extLst>
          </p:cNvPr>
          <p:cNvSpPr txBox="1"/>
          <p:nvPr/>
        </p:nvSpPr>
        <p:spPr>
          <a:xfrm>
            <a:off x="823242" y="584488"/>
            <a:ext cx="20712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1FD9152-2194-1C2F-BC88-AF8704E7CEAF}"/>
              </a:ext>
            </a:extLst>
          </p:cNvPr>
          <p:cNvSpPr txBox="1"/>
          <p:nvPr/>
        </p:nvSpPr>
        <p:spPr>
          <a:xfrm>
            <a:off x="823242" y="7242664"/>
            <a:ext cx="523852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MY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6. AlphaFold3-predicted structures of AF1, MET-AF1, and AF1-FFF in complex with TBP and SRC-1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F1-FFF exhibits the strongest predicted binding affinity and the most extensive interaction interface, followed by MET-AF1 and wild-type AF1. The arrow indicates the K464F mutation, which contributes to both hydrogen bonding and hydrophobic contacts with SRC-1. Binding affinities were estimated using PRODIGY.</a:t>
            </a:r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27762E2B-A019-3FEB-E93E-DC75A6208728}"/>
              </a:ext>
            </a:extLst>
          </p:cNvPr>
          <p:cNvGrpSpPr/>
          <p:nvPr/>
        </p:nvGrpSpPr>
        <p:grpSpPr>
          <a:xfrm>
            <a:off x="1727643" y="998652"/>
            <a:ext cx="3402714" cy="676198"/>
            <a:chOff x="1701444" y="986813"/>
            <a:chExt cx="3402714" cy="676198"/>
          </a:xfrm>
        </p:grpSpPr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9E2C25DD-9003-3C76-54C9-ADD7552BC1A1}"/>
                </a:ext>
              </a:extLst>
            </p:cNvPr>
            <p:cNvGrpSpPr/>
            <p:nvPr/>
          </p:nvGrpSpPr>
          <p:grpSpPr>
            <a:xfrm>
              <a:off x="2868644" y="991664"/>
              <a:ext cx="867506" cy="442173"/>
              <a:chOff x="2100190" y="1012067"/>
              <a:chExt cx="867506" cy="442173"/>
            </a:xfrm>
          </p:grpSpPr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4D2B88DC-363E-CE91-958A-2B990B35C47B}"/>
                  </a:ext>
                </a:extLst>
              </p:cNvPr>
              <p:cNvGrpSpPr/>
              <p:nvPr/>
            </p:nvGrpSpPr>
            <p:grpSpPr>
              <a:xfrm>
                <a:off x="2100190" y="1012067"/>
                <a:ext cx="867506" cy="215444"/>
                <a:chOff x="2390775" y="517255"/>
                <a:chExt cx="867506" cy="215444"/>
              </a:xfrm>
            </p:grpSpPr>
            <p:sp>
              <p:nvSpPr>
                <p:cNvPr id="34" name="Rectangle 33">
                  <a:extLst>
                    <a:ext uri="{FF2B5EF4-FFF2-40B4-BE49-F238E27FC236}">
                      <a16:creationId xmlns:a16="http://schemas.microsoft.com/office/drawing/2014/main" id="{114D9869-950F-A42F-7E4B-82907C6440AA}"/>
                    </a:ext>
                  </a:extLst>
                </p:cNvPr>
                <p:cNvSpPr/>
                <p:nvPr/>
              </p:nvSpPr>
              <p:spPr>
                <a:xfrm>
                  <a:off x="2390775" y="571500"/>
                  <a:ext cx="108000" cy="108000"/>
                </a:xfrm>
                <a:prstGeom prst="rect">
                  <a:avLst/>
                </a:prstGeom>
                <a:solidFill>
                  <a:srgbClr val="FFFF00"/>
                </a:solidFill>
                <a:ln>
                  <a:solidFill>
                    <a:srgbClr val="FFFF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/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BABBB927-BB8A-CDB3-1D89-D9FC5950E253}"/>
                    </a:ext>
                  </a:extLst>
                </p:cNvPr>
                <p:cNvSpPr txBox="1"/>
                <p:nvPr/>
              </p:nvSpPr>
              <p:spPr>
                <a:xfrm>
                  <a:off x="2517847" y="517255"/>
                  <a:ext cx="7404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BP</a:t>
                  </a:r>
                  <a:endParaRPr lang="en-S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EC7816ED-967F-3E28-825B-109DCC80808B}"/>
                  </a:ext>
                </a:extLst>
              </p:cNvPr>
              <p:cNvGrpSpPr/>
              <p:nvPr/>
            </p:nvGrpSpPr>
            <p:grpSpPr>
              <a:xfrm>
                <a:off x="2100190" y="1238796"/>
                <a:ext cx="867506" cy="215444"/>
                <a:chOff x="2390775" y="743984"/>
                <a:chExt cx="867506" cy="215444"/>
              </a:xfrm>
            </p:grpSpPr>
            <p:sp>
              <p:nvSpPr>
                <p:cNvPr id="37" name="Rectangle 36">
                  <a:extLst>
                    <a:ext uri="{FF2B5EF4-FFF2-40B4-BE49-F238E27FC236}">
                      <a16:creationId xmlns:a16="http://schemas.microsoft.com/office/drawing/2014/main" id="{6EDB91A4-8ED8-AB93-BC69-08189AAA6891}"/>
                    </a:ext>
                  </a:extLst>
                </p:cNvPr>
                <p:cNvSpPr/>
                <p:nvPr/>
              </p:nvSpPr>
              <p:spPr>
                <a:xfrm>
                  <a:off x="2390775" y="788314"/>
                  <a:ext cx="108000" cy="108000"/>
                </a:xfrm>
                <a:prstGeom prst="rect">
                  <a:avLst/>
                </a:prstGeom>
                <a:solidFill>
                  <a:schemeClr val="accent3">
                    <a:lumMod val="60000"/>
                    <a:lumOff val="40000"/>
                  </a:schemeClr>
                </a:solidFill>
                <a:ln>
                  <a:solidFill>
                    <a:schemeClr val="accent3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/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1BDAFA74-C849-7A5C-E39C-15544EF58CD7}"/>
                    </a:ext>
                  </a:extLst>
                </p:cNvPr>
                <p:cNvSpPr txBox="1"/>
                <p:nvPr/>
              </p:nvSpPr>
              <p:spPr>
                <a:xfrm>
                  <a:off x="2517847" y="743984"/>
                  <a:ext cx="7404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RC1</a:t>
                  </a:r>
                  <a:endParaRPr lang="en-S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6B00935F-DE90-838F-FACB-A68EABD32738}"/>
                </a:ext>
              </a:extLst>
            </p:cNvPr>
            <p:cNvGrpSpPr/>
            <p:nvPr/>
          </p:nvGrpSpPr>
          <p:grpSpPr>
            <a:xfrm>
              <a:off x="1701444" y="986813"/>
              <a:ext cx="931064" cy="493262"/>
              <a:chOff x="2100190" y="1511677"/>
              <a:chExt cx="931064" cy="493262"/>
            </a:xfrm>
          </p:grpSpPr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2049884F-7938-0F25-B5DC-1F886BDC99C0}"/>
                  </a:ext>
                </a:extLst>
              </p:cNvPr>
              <p:cNvGrpSpPr/>
              <p:nvPr/>
            </p:nvGrpSpPr>
            <p:grpSpPr>
              <a:xfrm>
                <a:off x="2100190" y="1511677"/>
                <a:ext cx="867506" cy="215444"/>
                <a:chOff x="2390775" y="517255"/>
                <a:chExt cx="867506" cy="215444"/>
              </a:xfrm>
            </p:grpSpPr>
            <p:sp>
              <p:nvSpPr>
                <p:cNvPr id="40" name="Rectangle 39">
                  <a:extLst>
                    <a:ext uri="{FF2B5EF4-FFF2-40B4-BE49-F238E27FC236}">
                      <a16:creationId xmlns:a16="http://schemas.microsoft.com/office/drawing/2014/main" id="{D341EC68-DC11-CE2C-539C-1F54A8863F3E}"/>
                    </a:ext>
                  </a:extLst>
                </p:cNvPr>
                <p:cNvSpPr/>
                <p:nvPr/>
              </p:nvSpPr>
              <p:spPr>
                <a:xfrm>
                  <a:off x="2390775" y="571500"/>
                  <a:ext cx="108000" cy="1080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/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F9085A14-8194-3806-E79C-28B218903297}"/>
                    </a:ext>
                  </a:extLst>
                </p:cNvPr>
                <p:cNvSpPr txBox="1"/>
                <p:nvPr/>
              </p:nvSpPr>
              <p:spPr>
                <a:xfrm>
                  <a:off x="2517847" y="517255"/>
                  <a:ext cx="74043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GR-AF1</a:t>
                  </a:r>
                  <a:endParaRPr lang="en-S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E9299CBB-05AA-67DD-3023-EE1AF07572F6}"/>
                  </a:ext>
                </a:extLst>
              </p:cNvPr>
              <p:cNvGrpSpPr/>
              <p:nvPr/>
            </p:nvGrpSpPr>
            <p:grpSpPr>
              <a:xfrm>
                <a:off x="2100190" y="1789495"/>
                <a:ext cx="931064" cy="215444"/>
                <a:chOff x="2390775" y="743984"/>
                <a:chExt cx="931064" cy="215444"/>
              </a:xfrm>
            </p:grpSpPr>
            <p:sp>
              <p:nvSpPr>
                <p:cNvPr id="43" name="Rectangle 42">
                  <a:extLst>
                    <a:ext uri="{FF2B5EF4-FFF2-40B4-BE49-F238E27FC236}">
                      <a16:creationId xmlns:a16="http://schemas.microsoft.com/office/drawing/2014/main" id="{A7C912E7-D203-F121-4CCF-0C7C17EAA8CA}"/>
                    </a:ext>
                  </a:extLst>
                </p:cNvPr>
                <p:cNvSpPr/>
                <p:nvPr/>
              </p:nvSpPr>
              <p:spPr>
                <a:xfrm>
                  <a:off x="2390775" y="788314"/>
                  <a:ext cx="108000" cy="10800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 dirty="0"/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8BF3A577-7532-620C-6B09-3FE3C6F55273}"/>
                    </a:ext>
                  </a:extLst>
                </p:cNvPr>
                <p:cNvSpPr txBox="1"/>
                <p:nvPr/>
              </p:nvSpPr>
              <p:spPr>
                <a:xfrm>
                  <a:off x="2517847" y="743984"/>
                  <a:ext cx="80399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KR Residue</a:t>
                  </a:r>
                  <a:endParaRPr lang="en-S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FE6E7E66-86B8-2520-665D-59A577E80AFF}"/>
                </a:ext>
              </a:extLst>
            </p:cNvPr>
            <p:cNvGrpSpPr/>
            <p:nvPr/>
          </p:nvGrpSpPr>
          <p:grpSpPr>
            <a:xfrm>
              <a:off x="3736522" y="991709"/>
              <a:ext cx="1367636" cy="671302"/>
              <a:chOff x="3390174" y="1053282"/>
              <a:chExt cx="1367636" cy="671302"/>
            </a:xfrm>
          </p:grpSpPr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05E26328-4543-C8FC-C98A-87BF1DDED75D}"/>
                  </a:ext>
                </a:extLst>
              </p:cNvPr>
              <p:cNvGrpSpPr/>
              <p:nvPr/>
            </p:nvGrpSpPr>
            <p:grpSpPr>
              <a:xfrm>
                <a:off x="3393116" y="1282411"/>
                <a:ext cx="1074090" cy="215444"/>
                <a:chOff x="2390775" y="517255"/>
                <a:chExt cx="1074090" cy="215444"/>
              </a:xfrm>
            </p:grpSpPr>
            <p:sp>
              <p:nvSpPr>
                <p:cNvPr id="46" name="Rectangle 45">
                  <a:extLst>
                    <a:ext uri="{FF2B5EF4-FFF2-40B4-BE49-F238E27FC236}">
                      <a16:creationId xmlns:a16="http://schemas.microsoft.com/office/drawing/2014/main" id="{E01D38C9-BC52-7438-AC13-183A65F3085A}"/>
                    </a:ext>
                  </a:extLst>
                </p:cNvPr>
                <p:cNvSpPr/>
                <p:nvPr/>
              </p:nvSpPr>
              <p:spPr>
                <a:xfrm>
                  <a:off x="2390775" y="571500"/>
                  <a:ext cx="108000" cy="108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/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C14D2331-F14A-5A04-1757-63A118FF25CC}"/>
                    </a:ext>
                  </a:extLst>
                </p:cNvPr>
                <p:cNvSpPr txBox="1"/>
                <p:nvPr/>
              </p:nvSpPr>
              <p:spPr>
                <a:xfrm>
                  <a:off x="2517847" y="517255"/>
                  <a:ext cx="94701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ydrogen bond</a:t>
                  </a:r>
                  <a:endParaRPr lang="en-S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BBC9C54C-F3AA-48D1-2709-F58D5EF6EDA7}"/>
                  </a:ext>
                </a:extLst>
              </p:cNvPr>
              <p:cNvGrpSpPr/>
              <p:nvPr/>
            </p:nvGrpSpPr>
            <p:grpSpPr>
              <a:xfrm>
                <a:off x="3393116" y="1509140"/>
                <a:ext cx="1364694" cy="215444"/>
                <a:chOff x="2390775" y="743984"/>
                <a:chExt cx="1364694" cy="215444"/>
              </a:xfrm>
            </p:grpSpPr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2531557E-59FF-4FC7-9187-ABC3E0F75D19}"/>
                    </a:ext>
                  </a:extLst>
                </p:cNvPr>
                <p:cNvSpPr/>
                <p:nvPr/>
              </p:nvSpPr>
              <p:spPr>
                <a:xfrm>
                  <a:off x="2390775" y="788314"/>
                  <a:ext cx="108000" cy="108000"/>
                </a:xfrm>
                <a:prstGeom prst="rect">
                  <a:avLst/>
                </a:prstGeom>
                <a:solidFill>
                  <a:schemeClr val="accent2">
                    <a:lumMod val="75000"/>
                  </a:schemeClr>
                </a:solidFill>
                <a:ln>
                  <a:solidFill>
                    <a:schemeClr val="accent2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/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5230226C-5D6C-7824-E8E8-9B03CD03DD3F}"/>
                    </a:ext>
                  </a:extLst>
                </p:cNvPr>
                <p:cNvSpPr txBox="1"/>
                <p:nvPr/>
              </p:nvSpPr>
              <p:spPr>
                <a:xfrm>
                  <a:off x="2517847" y="743984"/>
                  <a:ext cx="123762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ydrophobic contact</a:t>
                  </a:r>
                  <a:endParaRPr lang="en-S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A3F37140-1753-C2EF-E6ED-E98E5DE2514E}"/>
                  </a:ext>
                </a:extLst>
              </p:cNvPr>
              <p:cNvGrpSpPr/>
              <p:nvPr/>
            </p:nvGrpSpPr>
            <p:grpSpPr>
              <a:xfrm>
                <a:off x="3390174" y="1053282"/>
                <a:ext cx="1226840" cy="215444"/>
                <a:chOff x="2390775" y="517255"/>
                <a:chExt cx="1226840" cy="215444"/>
              </a:xfrm>
            </p:grpSpPr>
            <p:sp>
              <p:nvSpPr>
                <p:cNvPr id="4" name="Rectangle 3">
                  <a:extLst>
                    <a:ext uri="{FF2B5EF4-FFF2-40B4-BE49-F238E27FC236}">
                      <a16:creationId xmlns:a16="http://schemas.microsoft.com/office/drawing/2014/main" id="{1831514E-624E-3D24-A84D-B47089C15E80}"/>
                    </a:ext>
                  </a:extLst>
                </p:cNvPr>
                <p:cNvSpPr/>
                <p:nvPr/>
              </p:nvSpPr>
              <p:spPr>
                <a:xfrm>
                  <a:off x="2390775" y="571500"/>
                  <a:ext cx="108000" cy="108000"/>
                </a:xfrm>
                <a:prstGeom prst="rect">
                  <a:avLst/>
                </a:prstGeom>
                <a:solidFill>
                  <a:srgbClr val="A3E4FB"/>
                </a:solidFill>
                <a:ln>
                  <a:solidFill>
                    <a:srgbClr val="A3E4FB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SG"/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EA839849-10C0-7C90-AF79-453F4F54F897}"/>
                    </a:ext>
                  </a:extLst>
                </p:cNvPr>
                <p:cNvSpPr txBox="1"/>
                <p:nvPr/>
              </p:nvSpPr>
              <p:spPr>
                <a:xfrm>
                  <a:off x="2517846" y="517255"/>
                  <a:ext cx="109976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teraction interface</a:t>
                  </a:r>
                  <a:endParaRPr lang="en-SG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id="{CBE3295D-DB65-54DC-930B-48D248C0B2F3}"/>
              </a:ext>
            </a:extLst>
          </p:cNvPr>
          <p:cNvGrpSpPr/>
          <p:nvPr/>
        </p:nvGrpSpPr>
        <p:grpSpPr>
          <a:xfrm>
            <a:off x="959607" y="1761754"/>
            <a:ext cx="5125096" cy="5050459"/>
            <a:chOff x="829037" y="1674850"/>
            <a:chExt cx="5125096" cy="5050459"/>
          </a:xfrm>
        </p:grpSpPr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6266A6F3-2124-3AC4-649F-4EC80D242377}"/>
                </a:ext>
              </a:extLst>
            </p:cNvPr>
            <p:cNvGrpSpPr/>
            <p:nvPr/>
          </p:nvGrpSpPr>
          <p:grpSpPr>
            <a:xfrm>
              <a:off x="830130" y="1869072"/>
              <a:ext cx="5124003" cy="4856237"/>
              <a:chOff x="823242" y="2126293"/>
              <a:chExt cx="5124003" cy="4856237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D9D7C40F-F1F6-2AE5-684C-42B3655BB4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2598" t="2109" r="1371" b="2174"/>
              <a:stretch>
                <a:fillRect/>
              </a:stretch>
            </p:blipFill>
            <p:spPr>
              <a:xfrm>
                <a:off x="4327245" y="2130466"/>
                <a:ext cx="1620000" cy="1622760"/>
              </a:xfrm>
              <a:prstGeom prst="rect">
                <a:avLst/>
              </a:prstGeom>
            </p:spPr>
          </p:pic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FE7B716A-23D2-5205-3BD8-D10D68AA10F7}"/>
                  </a:ext>
                </a:extLst>
              </p:cNvPr>
              <p:cNvGrpSpPr/>
              <p:nvPr/>
            </p:nvGrpSpPr>
            <p:grpSpPr>
              <a:xfrm>
                <a:off x="1088976" y="6382366"/>
                <a:ext cx="4768269" cy="600164"/>
                <a:chOff x="1272704" y="5078659"/>
                <a:chExt cx="4768269" cy="600164"/>
              </a:xfrm>
            </p:grpSpPr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188D1543-5B21-2E08-3A7B-D0548A36B56F}"/>
                    </a:ext>
                  </a:extLst>
                </p:cNvPr>
                <p:cNvSpPr txBox="1"/>
                <p:nvPr/>
              </p:nvSpPr>
              <p:spPr>
                <a:xfrm>
                  <a:off x="1272704" y="5078659"/>
                  <a:ext cx="1440000" cy="6001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F1_TBP_SRC</a:t>
                  </a:r>
                </a:p>
                <a:p>
                  <a:r>
                    <a:rPr lang="en-US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pTM</a:t>
                  </a:r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0.18</a:t>
                  </a:r>
                </a:p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ΔG = -8.1 kcal/mol</a:t>
                  </a:r>
                </a:p>
                <a:p>
                  <a:r>
                    <a:rPr lang="en-SG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</a:t>
                  </a:r>
                  <a:r>
                    <a:rPr lang="en-SG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M) = 1.1e-6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922F3FB8-4FB6-B7DB-12E0-3DEBBFB1C680}"/>
                    </a:ext>
                  </a:extLst>
                </p:cNvPr>
                <p:cNvSpPr txBox="1"/>
                <p:nvPr/>
              </p:nvSpPr>
              <p:spPr>
                <a:xfrm>
                  <a:off x="4676573" y="5078659"/>
                  <a:ext cx="1364400" cy="6001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F1-FFF_TBP_SRC1</a:t>
                  </a:r>
                </a:p>
                <a:p>
                  <a:r>
                    <a:rPr lang="en-US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pTM</a:t>
                  </a:r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0.21</a:t>
                  </a:r>
                </a:p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ΔG = -12.6 kcal/mol</a:t>
                  </a:r>
                </a:p>
                <a:p>
                  <a:r>
                    <a:rPr lang="en-SG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</a:t>
                  </a:r>
                  <a:r>
                    <a:rPr lang="en-SG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M) = 5.6e-10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8CFED7CA-5A46-6A08-728D-C2184BC9F173}"/>
                    </a:ext>
                  </a:extLst>
                </p:cNvPr>
                <p:cNvSpPr txBox="1"/>
                <p:nvPr/>
              </p:nvSpPr>
              <p:spPr>
                <a:xfrm>
                  <a:off x="3024764" y="5078659"/>
                  <a:ext cx="1364400" cy="6001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T-AF1_TBP_SRC1</a:t>
                  </a:r>
                </a:p>
                <a:p>
                  <a:r>
                    <a:rPr lang="en-US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pTM</a:t>
                  </a:r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= 0.26</a:t>
                  </a:r>
                </a:p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ΔG = -12.3 kcal/mol</a:t>
                  </a:r>
                </a:p>
                <a:p>
                  <a:r>
                    <a:rPr lang="en-SG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</a:t>
                  </a:r>
                  <a:r>
                    <a:rPr lang="en-SG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M) = 9.2e-10</a:t>
                  </a:r>
                </a:p>
              </p:txBody>
            </p:sp>
          </p:grpSp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51722812-2545-F24E-3D83-97FB12F3BC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2744" t="1621" r="1225" b="2185"/>
              <a:stretch>
                <a:fillRect/>
              </a:stretch>
            </p:blipFill>
            <p:spPr>
              <a:xfrm>
                <a:off x="2707245" y="2130466"/>
                <a:ext cx="1620000" cy="1622760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696DD31D-A882-D337-E102-B39B2ED13A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1522" t="1492" r="1223" b="2555"/>
              <a:stretch>
                <a:fillRect/>
              </a:stretch>
            </p:blipFill>
            <p:spPr>
              <a:xfrm>
                <a:off x="823242" y="2126293"/>
                <a:ext cx="1620000" cy="1602329"/>
              </a:xfrm>
              <a:prstGeom prst="rect">
                <a:avLst/>
              </a:prstGeom>
            </p:spPr>
          </p:pic>
          <p:pic>
            <p:nvPicPr>
              <p:cNvPr id="51" name="Picture 50">
                <a:extLst>
                  <a:ext uri="{FF2B5EF4-FFF2-40B4-BE49-F238E27FC236}">
                    <a16:creationId xmlns:a16="http://schemas.microsoft.com/office/drawing/2014/main" id="{1F8EF49F-4233-B41C-C61E-DADC7E87D9E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t="5569" b="5038"/>
              <a:stretch>
                <a:fillRect/>
              </a:stretch>
            </p:blipFill>
            <p:spPr>
              <a:xfrm>
                <a:off x="981444" y="3987207"/>
                <a:ext cx="1440000" cy="775287"/>
              </a:xfrm>
              <a:prstGeom prst="rect">
                <a:avLst/>
              </a:prstGeom>
            </p:spPr>
          </p:pic>
          <p:pic>
            <p:nvPicPr>
              <p:cNvPr id="55" name="Picture 54">
                <a:extLst>
                  <a:ext uri="{FF2B5EF4-FFF2-40B4-BE49-F238E27FC236}">
                    <a16:creationId xmlns:a16="http://schemas.microsoft.com/office/drawing/2014/main" id="{5FA8F0A1-5F32-13DF-F19E-01089F9F146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417245" y="3931484"/>
                <a:ext cx="1440000" cy="861087"/>
              </a:xfrm>
              <a:prstGeom prst="rect">
                <a:avLst/>
              </a:prstGeom>
            </p:spPr>
          </p:pic>
          <p:pic>
            <p:nvPicPr>
              <p:cNvPr id="59" name="Picture 58">
                <a:extLst>
                  <a:ext uri="{FF2B5EF4-FFF2-40B4-BE49-F238E27FC236}">
                    <a16:creationId xmlns:a16="http://schemas.microsoft.com/office/drawing/2014/main" id="{1DC2F192-EAF8-C63C-B869-B429F4E591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778174" y="3970273"/>
                <a:ext cx="1440000" cy="861445"/>
              </a:xfrm>
              <a:prstGeom prst="rect">
                <a:avLst/>
              </a:prstGeom>
            </p:spPr>
          </p:pic>
          <p:pic>
            <p:nvPicPr>
              <p:cNvPr id="63" name="Picture 62">
                <a:extLst>
                  <a:ext uri="{FF2B5EF4-FFF2-40B4-BE49-F238E27FC236}">
                    <a16:creationId xmlns:a16="http://schemas.microsoft.com/office/drawing/2014/main" id="{E4EC2FA8-3626-B53B-3B02-E5E4712A4A3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981444" y="5209187"/>
                <a:ext cx="1440000" cy="844898"/>
              </a:xfrm>
              <a:prstGeom prst="rect">
                <a:avLst/>
              </a:prstGeom>
            </p:spPr>
          </p:pic>
          <p:pic>
            <p:nvPicPr>
              <p:cNvPr id="65" name="Picture 64">
                <a:extLst>
                  <a:ext uri="{FF2B5EF4-FFF2-40B4-BE49-F238E27FC236}">
                    <a16:creationId xmlns:a16="http://schemas.microsoft.com/office/drawing/2014/main" id="{BAA6EE21-B466-91FE-E676-D93B7B27F9C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417245" y="5186039"/>
                <a:ext cx="1440000" cy="868046"/>
              </a:xfrm>
              <a:prstGeom prst="rect">
                <a:avLst/>
              </a:prstGeom>
            </p:spPr>
          </p:pic>
          <p:pic>
            <p:nvPicPr>
              <p:cNvPr id="67" name="Picture 66">
                <a:extLst>
                  <a:ext uri="{FF2B5EF4-FFF2-40B4-BE49-F238E27FC236}">
                    <a16:creationId xmlns:a16="http://schemas.microsoft.com/office/drawing/2014/main" id="{1F43AF4B-EA1D-BC72-C1D7-EB4EB4F500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778174" y="5209187"/>
                <a:ext cx="1440000" cy="875800"/>
              </a:xfrm>
              <a:prstGeom prst="rect">
                <a:avLst/>
              </a:prstGeom>
            </p:spPr>
          </p:pic>
        </p:grp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F20B5999-A556-3277-D084-1C83D294A0F8}"/>
                </a:ext>
              </a:extLst>
            </p:cNvPr>
            <p:cNvSpPr txBox="1"/>
            <p:nvPr/>
          </p:nvSpPr>
          <p:spPr>
            <a:xfrm>
              <a:off x="829037" y="1674850"/>
              <a:ext cx="8453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. Overview</a:t>
              </a:r>
              <a:endParaRPr lang="en-SG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8E8D52F5-9176-73A2-A099-46FF3DE23BEA}"/>
                </a:ext>
              </a:extLst>
            </p:cNvPr>
            <p:cNvSpPr txBox="1"/>
            <p:nvPr/>
          </p:nvSpPr>
          <p:spPr>
            <a:xfrm>
              <a:off x="830130" y="3450324"/>
              <a:ext cx="13867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B. Hydrogen bonding</a:t>
              </a:r>
              <a:endParaRPr lang="en-SG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A9FAC3E7-762C-43C6-4658-F50AF474390E}"/>
                </a:ext>
              </a:extLst>
            </p:cNvPr>
            <p:cNvSpPr txBox="1"/>
            <p:nvPr/>
          </p:nvSpPr>
          <p:spPr>
            <a:xfrm>
              <a:off x="830129" y="4700066"/>
              <a:ext cx="17057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. Hydrophobic contact</a:t>
              </a:r>
              <a:endParaRPr lang="en-SG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10E7DEB7-CD64-2C7A-BB6C-BC240623217E}"/>
              </a:ext>
            </a:extLst>
          </p:cNvPr>
          <p:cNvCxnSpPr>
            <a:cxnSpLocks/>
          </p:cNvCxnSpPr>
          <p:nvPr/>
        </p:nvCxnSpPr>
        <p:spPr>
          <a:xfrm flipH="1">
            <a:off x="5369717" y="2653045"/>
            <a:ext cx="30178" cy="1393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1B713120-BBA4-11EB-7E82-4E2399F58F79}"/>
              </a:ext>
            </a:extLst>
          </p:cNvPr>
          <p:cNvCxnSpPr>
            <a:cxnSpLocks/>
          </p:cNvCxnSpPr>
          <p:nvPr/>
        </p:nvCxnSpPr>
        <p:spPr>
          <a:xfrm flipH="1">
            <a:off x="5399895" y="3808247"/>
            <a:ext cx="30178" cy="1393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86556E76-4596-6517-BFC9-17BA10834E80}"/>
              </a:ext>
            </a:extLst>
          </p:cNvPr>
          <p:cNvCxnSpPr>
            <a:cxnSpLocks/>
          </p:cNvCxnSpPr>
          <p:nvPr/>
        </p:nvCxnSpPr>
        <p:spPr>
          <a:xfrm flipH="1">
            <a:off x="5385665" y="5091445"/>
            <a:ext cx="30178" cy="1393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603520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943</TotalTime>
  <Words>1284</Words>
  <Application>Microsoft Office PowerPoint</Application>
  <PresentationFormat>A4 Paper (210x297 mm)</PresentationFormat>
  <Paragraphs>220</Paragraphs>
  <Slides>7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-BoldMT</vt:lpstr>
      <vt:lpstr>ArialMT</vt:lpstr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au Pheck Khee</dc:creator>
  <cp:lastModifiedBy>MDPI</cp:lastModifiedBy>
  <cp:revision>110</cp:revision>
  <dcterms:created xsi:type="dcterms:W3CDTF">2025-08-14T04:17:33Z</dcterms:created>
  <dcterms:modified xsi:type="dcterms:W3CDTF">2026-03-23T12:57:58Z</dcterms:modified>
</cp:coreProperties>
</file>